
<file path=[Content_Types].xml><?xml version="1.0" encoding="utf-8"?>
<Types xmlns="http://schemas.openxmlformats.org/package/2006/content-types">
  <Default Extension="bin" ContentType="application/vnd.openxmlformats-officedocument.oleObject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328" r:id="rId3"/>
    <p:sldId id="307" r:id="rId4"/>
    <p:sldId id="310" r:id="rId5"/>
    <p:sldId id="325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5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31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okon-lab1\Desktop\PhD%20-%20Bacterial%20Water%20Treatment\Sequencing\CLCBio%20Analysis\18S%20Analysis\18S%20-%20Alpha%20Diversity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okon-lab1\Desktop\PhD%20-%20Bacterial%20Water%20Treatment\Sequencing\CLCBio%20Analysis\Bacteriovorax%20Analysis\Bacteriovorax%20-%20alpha%20diversity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okon-lab1\Desktop\PhD%20-%20Bacterial%20Water%20Treatment\Sequencing\CLCBio%20Analysis\Bdellovibrio%20Analysis\Bd%20-%20alpha%20diversity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gdrive\Edouard\BACKUP\Articles\BLOs\Wastewater%20trilateral\Kidron\16S%20-%20Core%20Results%20Pco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gdrive\Edouard\BACKUP\Articles\BLOs\Wastewater%20trilateral\Kidron\16S%20-%20Core%20Results%20Pco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 sz="1000"/>
            </a:pPr>
            <a:r>
              <a:rPr lang="en-US" sz="1000" dirty="0"/>
              <a:t>Micro-eukaryotes</a:t>
            </a:r>
          </a:p>
        </c:rich>
      </c:tx>
      <c:layout>
        <c:manualLayout>
          <c:xMode val="edge"/>
          <c:yMode val="edge"/>
          <c:x val="0.35195211828603784"/>
          <c:y val="5.279403377933757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8259683857914225"/>
          <c:y val="0.13342189076551875"/>
          <c:w val="0.70861879544248174"/>
          <c:h val="0.7369706506040392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Kid!$B$4</c:f>
              <c:strCache>
                <c:ptCount val="1"/>
                <c:pt idx="0">
                  <c:v>01/03/2013</c:v>
                </c:pt>
              </c:strCache>
            </c:strRef>
          </c:tx>
          <c:spPr>
            <a:ln w="9525" cap="rnd">
              <a:solidFill>
                <a:schemeClr val="accent1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B$5:$B$34</c:f>
              <c:numCache>
                <c:formatCode>General</c:formatCode>
                <c:ptCount val="30"/>
                <c:pt idx="0">
                  <c:v>1</c:v>
                </c:pt>
                <c:pt idx="1">
                  <c:v>132.58000000000001</c:v>
                </c:pt>
                <c:pt idx="2">
                  <c:v>196.97</c:v>
                </c:pt>
                <c:pt idx="3">
                  <c:v>247.82</c:v>
                </c:pt>
                <c:pt idx="4">
                  <c:v>285.76</c:v>
                </c:pt>
                <c:pt idx="5">
                  <c:v>319.7</c:v>
                </c:pt>
                <c:pt idx="6">
                  <c:v>350.65</c:v>
                </c:pt>
                <c:pt idx="7">
                  <c:v>375.32</c:v>
                </c:pt>
                <c:pt idx="8">
                  <c:v>403.15</c:v>
                </c:pt>
                <c:pt idx="9">
                  <c:v>423.11</c:v>
                </c:pt>
                <c:pt idx="10">
                  <c:v>442.79</c:v>
                </c:pt>
                <c:pt idx="11">
                  <c:v>460.41</c:v>
                </c:pt>
                <c:pt idx="12">
                  <c:v>477.5</c:v>
                </c:pt>
                <c:pt idx="13">
                  <c:v>491.59</c:v>
                </c:pt>
                <c:pt idx="14">
                  <c:v>504.1</c:v>
                </c:pt>
                <c:pt idx="15">
                  <c:v>519.34999999999991</c:v>
                </c:pt>
                <c:pt idx="16">
                  <c:v>531.58000000000004</c:v>
                </c:pt>
                <c:pt idx="17">
                  <c:v>540.71</c:v>
                </c:pt>
                <c:pt idx="18">
                  <c:v>549.93999999999994</c:v>
                </c:pt>
                <c:pt idx="19">
                  <c:v>561.45999999999992</c:v>
                </c:pt>
                <c:pt idx="20">
                  <c:v>570.03</c:v>
                </c:pt>
                <c:pt idx="21">
                  <c:v>578.79999999999995</c:v>
                </c:pt>
                <c:pt idx="22">
                  <c:v>585.3599999999999</c:v>
                </c:pt>
                <c:pt idx="23">
                  <c:v>593.85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FB9-474D-98FB-FB7E44384FD7}"/>
            </c:ext>
          </c:extLst>
        </c:ser>
        <c:ser>
          <c:idx val="1"/>
          <c:order val="1"/>
          <c:tx>
            <c:strRef>
              <c:f>Kid!$C$4</c:f>
              <c:strCache>
                <c:ptCount val="1"/>
                <c:pt idx="0">
                  <c:v>01/03/2013</c:v>
                </c:pt>
              </c:strCache>
            </c:strRef>
          </c:tx>
          <c:spPr>
            <a:ln w="9525" cap="rnd">
              <a:solidFill>
                <a:schemeClr val="accent2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C$5:$C$34</c:f>
              <c:numCache>
                <c:formatCode>General</c:formatCode>
                <c:ptCount val="30"/>
                <c:pt idx="0">
                  <c:v>1</c:v>
                </c:pt>
                <c:pt idx="1">
                  <c:v>134.81</c:v>
                </c:pt>
                <c:pt idx="2">
                  <c:v>198.8</c:v>
                </c:pt>
                <c:pt idx="3">
                  <c:v>248.91</c:v>
                </c:pt>
                <c:pt idx="4">
                  <c:v>289.54000000000002</c:v>
                </c:pt>
                <c:pt idx="5">
                  <c:v>324.44</c:v>
                </c:pt>
                <c:pt idx="6">
                  <c:v>353.25</c:v>
                </c:pt>
                <c:pt idx="7">
                  <c:v>381.35</c:v>
                </c:pt>
                <c:pt idx="8">
                  <c:v>403.38</c:v>
                </c:pt>
                <c:pt idx="9">
                  <c:v>424.2</c:v>
                </c:pt>
                <c:pt idx="10">
                  <c:v>444.59</c:v>
                </c:pt>
                <c:pt idx="11">
                  <c:v>462.13</c:v>
                </c:pt>
                <c:pt idx="12">
                  <c:v>477.73</c:v>
                </c:pt>
                <c:pt idx="13">
                  <c:v>493.42</c:v>
                </c:pt>
                <c:pt idx="14">
                  <c:v>507.61</c:v>
                </c:pt>
                <c:pt idx="15">
                  <c:v>519.55999999999983</c:v>
                </c:pt>
                <c:pt idx="16">
                  <c:v>530.1</c:v>
                </c:pt>
                <c:pt idx="17">
                  <c:v>539.66999999999996</c:v>
                </c:pt>
                <c:pt idx="18">
                  <c:v>550.95999999999992</c:v>
                </c:pt>
                <c:pt idx="19">
                  <c:v>560.61</c:v>
                </c:pt>
                <c:pt idx="20">
                  <c:v>572.2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FB9-474D-98FB-FB7E44384FD7}"/>
            </c:ext>
          </c:extLst>
        </c:ser>
        <c:ser>
          <c:idx val="2"/>
          <c:order val="2"/>
          <c:tx>
            <c:strRef>
              <c:f>Kid!$D$4</c:f>
              <c:strCache>
                <c:ptCount val="1"/>
                <c:pt idx="0">
                  <c:v>01/05/2013</c:v>
                </c:pt>
              </c:strCache>
            </c:strRef>
          </c:tx>
          <c:spPr>
            <a:ln w="9525" cap="rnd">
              <a:solidFill>
                <a:schemeClr val="accent3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D$5:$D$34</c:f>
              <c:numCache>
                <c:formatCode>General</c:formatCode>
                <c:ptCount val="30"/>
                <c:pt idx="0">
                  <c:v>1</c:v>
                </c:pt>
                <c:pt idx="1">
                  <c:v>191.11</c:v>
                </c:pt>
                <c:pt idx="2">
                  <c:v>283.42999999999989</c:v>
                </c:pt>
                <c:pt idx="3">
                  <c:v>352.96</c:v>
                </c:pt>
                <c:pt idx="4">
                  <c:v>409.9</c:v>
                </c:pt>
                <c:pt idx="5">
                  <c:v>457.19</c:v>
                </c:pt>
                <c:pt idx="6">
                  <c:v>502.66</c:v>
                </c:pt>
                <c:pt idx="7">
                  <c:v>539.28</c:v>
                </c:pt>
                <c:pt idx="8">
                  <c:v>573.84999999999991</c:v>
                </c:pt>
                <c:pt idx="9">
                  <c:v>604.64</c:v>
                </c:pt>
                <c:pt idx="10">
                  <c:v>631.21</c:v>
                </c:pt>
                <c:pt idx="11">
                  <c:v>655.59</c:v>
                </c:pt>
                <c:pt idx="12">
                  <c:v>679.77</c:v>
                </c:pt>
                <c:pt idx="13">
                  <c:v>697.95999999999992</c:v>
                </c:pt>
                <c:pt idx="14">
                  <c:v>716.89</c:v>
                </c:pt>
                <c:pt idx="15">
                  <c:v>738.22</c:v>
                </c:pt>
                <c:pt idx="16">
                  <c:v>752.41</c:v>
                </c:pt>
                <c:pt idx="17">
                  <c:v>768.44999999999993</c:v>
                </c:pt>
                <c:pt idx="18">
                  <c:v>781.13</c:v>
                </c:pt>
                <c:pt idx="19">
                  <c:v>794.83999999999992</c:v>
                </c:pt>
                <c:pt idx="20">
                  <c:v>806.15</c:v>
                </c:pt>
                <c:pt idx="21">
                  <c:v>820.22</c:v>
                </c:pt>
                <c:pt idx="22">
                  <c:v>827.93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FB9-474D-98FB-FB7E44384FD7}"/>
            </c:ext>
          </c:extLst>
        </c:ser>
        <c:ser>
          <c:idx val="3"/>
          <c:order val="3"/>
          <c:tx>
            <c:strRef>
              <c:f>Kid!$E$4</c:f>
              <c:strCache>
                <c:ptCount val="1"/>
                <c:pt idx="0">
                  <c:v>01/05/2013</c:v>
                </c:pt>
              </c:strCache>
            </c:strRef>
          </c:tx>
          <c:spPr>
            <a:ln w="9525" cap="rnd">
              <a:solidFill>
                <a:schemeClr val="accent4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E$5:$E$34</c:f>
              <c:numCache>
                <c:formatCode>General</c:formatCode>
                <c:ptCount val="30"/>
                <c:pt idx="0">
                  <c:v>1</c:v>
                </c:pt>
                <c:pt idx="1">
                  <c:v>175.73</c:v>
                </c:pt>
                <c:pt idx="2">
                  <c:v>253.62</c:v>
                </c:pt>
                <c:pt idx="3">
                  <c:v>313.05</c:v>
                </c:pt>
                <c:pt idx="4">
                  <c:v>359.49</c:v>
                </c:pt>
                <c:pt idx="5">
                  <c:v>397.98</c:v>
                </c:pt>
                <c:pt idx="6">
                  <c:v>433.97</c:v>
                </c:pt>
                <c:pt idx="7">
                  <c:v>465.64</c:v>
                </c:pt>
                <c:pt idx="8">
                  <c:v>492.06</c:v>
                </c:pt>
                <c:pt idx="9">
                  <c:v>516.08000000000004</c:v>
                </c:pt>
                <c:pt idx="10">
                  <c:v>538.71</c:v>
                </c:pt>
                <c:pt idx="11">
                  <c:v>558.3599999999999</c:v>
                </c:pt>
                <c:pt idx="12">
                  <c:v>576.98</c:v>
                </c:pt>
                <c:pt idx="13">
                  <c:v>592.69000000000005</c:v>
                </c:pt>
                <c:pt idx="14">
                  <c:v>607.6</c:v>
                </c:pt>
                <c:pt idx="15">
                  <c:v>623.66</c:v>
                </c:pt>
                <c:pt idx="16">
                  <c:v>635.54</c:v>
                </c:pt>
                <c:pt idx="17">
                  <c:v>646.61</c:v>
                </c:pt>
                <c:pt idx="18">
                  <c:v>658</c:v>
                </c:pt>
                <c:pt idx="19">
                  <c:v>668.07</c:v>
                </c:pt>
                <c:pt idx="20">
                  <c:v>677.26</c:v>
                </c:pt>
                <c:pt idx="21">
                  <c:v>687.02</c:v>
                </c:pt>
                <c:pt idx="22">
                  <c:v>696.37</c:v>
                </c:pt>
                <c:pt idx="23">
                  <c:v>703.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FB9-474D-98FB-FB7E44384FD7}"/>
            </c:ext>
          </c:extLst>
        </c:ser>
        <c:ser>
          <c:idx val="4"/>
          <c:order val="4"/>
          <c:tx>
            <c:strRef>
              <c:f>Kid!$F$4</c:f>
              <c:strCache>
                <c:ptCount val="1"/>
                <c:pt idx="0">
                  <c:v>01/06/2013</c:v>
                </c:pt>
              </c:strCache>
            </c:strRef>
          </c:tx>
          <c:spPr>
            <a:ln w="9525" cap="rnd">
              <a:solidFill>
                <a:schemeClr val="accent5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F$5:$F$34</c:f>
              <c:numCache>
                <c:formatCode>General</c:formatCode>
                <c:ptCount val="30"/>
                <c:pt idx="0">
                  <c:v>1</c:v>
                </c:pt>
                <c:pt idx="1">
                  <c:v>125.22</c:v>
                </c:pt>
                <c:pt idx="2">
                  <c:v>186.51</c:v>
                </c:pt>
                <c:pt idx="3">
                  <c:v>232.96</c:v>
                </c:pt>
                <c:pt idx="4">
                  <c:v>272.81</c:v>
                </c:pt>
                <c:pt idx="5">
                  <c:v>304.61</c:v>
                </c:pt>
                <c:pt idx="6">
                  <c:v>334.62</c:v>
                </c:pt>
                <c:pt idx="7">
                  <c:v>360.39</c:v>
                </c:pt>
                <c:pt idx="8">
                  <c:v>384.95</c:v>
                </c:pt>
                <c:pt idx="9">
                  <c:v>405.86</c:v>
                </c:pt>
                <c:pt idx="10">
                  <c:v>423.8</c:v>
                </c:pt>
                <c:pt idx="11">
                  <c:v>440.1</c:v>
                </c:pt>
                <c:pt idx="12">
                  <c:v>455.53</c:v>
                </c:pt>
                <c:pt idx="13">
                  <c:v>472.34</c:v>
                </c:pt>
                <c:pt idx="14">
                  <c:v>483.92</c:v>
                </c:pt>
                <c:pt idx="15">
                  <c:v>497.13</c:v>
                </c:pt>
                <c:pt idx="16">
                  <c:v>509.41</c:v>
                </c:pt>
                <c:pt idx="17">
                  <c:v>519.45999999999992</c:v>
                </c:pt>
                <c:pt idx="18">
                  <c:v>526.13</c:v>
                </c:pt>
                <c:pt idx="19">
                  <c:v>538.12</c:v>
                </c:pt>
                <c:pt idx="20">
                  <c:v>547.28</c:v>
                </c:pt>
                <c:pt idx="21">
                  <c:v>551.549999999999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FB9-474D-98FB-FB7E44384FD7}"/>
            </c:ext>
          </c:extLst>
        </c:ser>
        <c:ser>
          <c:idx val="5"/>
          <c:order val="5"/>
          <c:tx>
            <c:strRef>
              <c:f>Kid!$G$4</c:f>
              <c:strCache>
                <c:ptCount val="1"/>
                <c:pt idx="0">
                  <c:v>01/06/2013</c:v>
                </c:pt>
              </c:strCache>
            </c:strRef>
          </c:tx>
          <c:spPr>
            <a:ln w="9525" cap="rnd">
              <a:solidFill>
                <a:schemeClr val="accent6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G$5:$G$34</c:f>
              <c:numCache>
                <c:formatCode>General</c:formatCode>
                <c:ptCount val="30"/>
                <c:pt idx="0">
                  <c:v>1</c:v>
                </c:pt>
                <c:pt idx="1">
                  <c:v>147.15</c:v>
                </c:pt>
                <c:pt idx="2">
                  <c:v>220.25</c:v>
                </c:pt>
                <c:pt idx="3">
                  <c:v>273.63</c:v>
                </c:pt>
                <c:pt idx="4">
                  <c:v>321.08999999999992</c:v>
                </c:pt>
                <c:pt idx="5">
                  <c:v>358.83</c:v>
                </c:pt>
                <c:pt idx="6">
                  <c:v>395.58</c:v>
                </c:pt>
                <c:pt idx="7">
                  <c:v>428.33</c:v>
                </c:pt>
                <c:pt idx="8">
                  <c:v>452.42</c:v>
                </c:pt>
                <c:pt idx="9">
                  <c:v>479.81</c:v>
                </c:pt>
                <c:pt idx="10">
                  <c:v>501.52</c:v>
                </c:pt>
                <c:pt idx="11">
                  <c:v>523.42999999999984</c:v>
                </c:pt>
                <c:pt idx="12">
                  <c:v>541.55999999999983</c:v>
                </c:pt>
                <c:pt idx="13">
                  <c:v>558.34999999999991</c:v>
                </c:pt>
                <c:pt idx="14">
                  <c:v>575.22</c:v>
                </c:pt>
                <c:pt idx="15">
                  <c:v>588.76</c:v>
                </c:pt>
                <c:pt idx="16">
                  <c:v>602.5</c:v>
                </c:pt>
                <c:pt idx="17">
                  <c:v>614.66</c:v>
                </c:pt>
                <c:pt idx="18">
                  <c:v>629.13</c:v>
                </c:pt>
                <c:pt idx="19">
                  <c:v>638.54999999999984</c:v>
                </c:pt>
                <c:pt idx="20">
                  <c:v>649.79</c:v>
                </c:pt>
                <c:pt idx="21">
                  <c:v>659.49</c:v>
                </c:pt>
                <c:pt idx="22">
                  <c:v>669.2</c:v>
                </c:pt>
                <c:pt idx="23">
                  <c:v>677.52</c:v>
                </c:pt>
                <c:pt idx="24">
                  <c:v>686.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FB9-474D-98FB-FB7E44384FD7}"/>
            </c:ext>
          </c:extLst>
        </c:ser>
        <c:ser>
          <c:idx val="6"/>
          <c:order val="6"/>
          <c:tx>
            <c:strRef>
              <c:f>Kid!$H$4</c:f>
              <c:strCache>
                <c:ptCount val="1"/>
                <c:pt idx="0">
                  <c:v>01/07/2013</c:v>
                </c:pt>
              </c:strCache>
            </c:strRef>
          </c:tx>
          <c:spPr>
            <a:ln w="9525" cap="rnd">
              <a:solidFill>
                <a:schemeClr val="accent1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H$5:$H$34</c:f>
              <c:numCache>
                <c:formatCode>General</c:formatCode>
                <c:ptCount val="30"/>
                <c:pt idx="0">
                  <c:v>1</c:v>
                </c:pt>
                <c:pt idx="1">
                  <c:v>170.42</c:v>
                </c:pt>
                <c:pt idx="2">
                  <c:v>247.15</c:v>
                </c:pt>
                <c:pt idx="3">
                  <c:v>298.70999999999992</c:v>
                </c:pt>
                <c:pt idx="4">
                  <c:v>342.86</c:v>
                </c:pt>
                <c:pt idx="5">
                  <c:v>376.7</c:v>
                </c:pt>
                <c:pt idx="6">
                  <c:v>408.31</c:v>
                </c:pt>
                <c:pt idx="7">
                  <c:v>435.85</c:v>
                </c:pt>
                <c:pt idx="8">
                  <c:v>458.54</c:v>
                </c:pt>
                <c:pt idx="9">
                  <c:v>478.84</c:v>
                </c:pt>
                <c:pt idx="10">
                  <c:v>501.34</c:v>
                </c:pt>
                <c:pt idx="11">
                  <c:v>515.29999999999995</c:v>
                </c:pt>
                <c:pt idx="12">
                  <c:v>531.26</c:v>
                </c:pt>
                <c:pt idx="13">
                  <c:v>544.65</c:v>
                </c:pt>
                <c:pt idx="14">
                  <c:v>557.76</c:v>
                </c:pt>
                <c:pt idx="15">
                  <c:v>570.92999999999984</c:v>
                </c:pt>
                <c:pt idx="16">
                  <c:v>581.69000000000005</c:v>
                </c:pt>
                <c:pt idx="17">
                  <c:v>592.82999999999993</c:v>
                </c:pt>
                <c:pt idx="18">
                  <c:v>603.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5FB9-474D-98FB-FB7E44384FD7}"/>
            </c:ext>
          </c:extLst>
        </c:ser>
        <c:ser>
          <c:idx val="7"/>
          <c:order val="7"/>
          <c:tx>
            <c:strRef>
              <c:f>Kid!$I$4</c:f>
              <c:strCache>
                <c:ptCount val="1"/>
                <c:pt idx="0">
                  <c:v>01/07/2013</c:v>
                </c:pt>
              </c:strCache>
            </c:strRef>
          </c:tx>
          <c:spPr>
            <a:ln w="9525" cap="rnd">
              <a:solidFill>
                <a:schemeClr val="accent2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I$5:$I$34</c:f>
              <c:numCache>
                <c:formatCode>General</c:formatCode>
                <c:ptCount val="30"/>
                <c:pt idx="0">
                  <c:v>1</c:v>
                </c:pt>
                <c:pt idx="1">
                  <c:v>202.62</c:v>
                </c:pt>
                <c:pt idx="2">
                  <c:v>287.60000000000002</c:v>
                </c:pt>
                <c:pt idx="3">
                  <c:v>346.45</c:v>
                </c:pt>
                <c:pt idx="4">
                  <c:v>393.3</c:v>
                </c:pt>
                <c:pt idx="5">
                  <c:v>433.22</c:v>
                </c:pt>
                <c:pt idx="6">
                  <c:v>465.92999999999989</c:v>
                </c:pt>
                <c:pt idx="7">
                  <c:v>494.2</c:v>
                </c:pt>
                <c:pt idx="8">
                  <c:v>518.47</c:v>
                </c:pt>
                <c:pt idx="9">
                  <c:v>542.26</c:v>
                </c:pt>
                <c:pt idx="10">
                  <c:v>564.42999999999984</c:v>
                </c:pt>
                <c:pt idx="11">
                  <c:v>579.05999999999983</c:v>
                </c:pt>
                <c:pt idx="12">
                  <c:v>595.4</c:v>
                </c:pt>
                <c:pt idx="13">
                  <c:v>610.38</c:v>
                </c:pt>
                <c:pt idx="14">
                  <c:v>624.15</c:v>
                </c:pt>
                <c:pt idx="15">
                  <c:v>637.80999999999983</c:v>
                </c:pt>
                <c:pt idx="16">
                  <c:v>648.24</c:v>
                </c:pt>
                <c:pt idx="17">
                  <c:v>659.09</c:v>
                </c:pt>
                <c:pt idx="18">
                  <c:v>668.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5FB9-474D-98FB-FB7E44384FD7}"/>
            </c:ext>
          </c:extLst>
        </c:ser>
        <c:ser>
          <c:idx val="8"/>
          <c:order val="8"/>
          <c:tx>
            <c:strRef>
              <c:f>Kid!$J$4</c:f>
              <c:strCache>
                <c:ptCount val="1"/>
                <c:pt idx="0">
                  <c:v>01/08/2013</c:v>
                </c:pt>
              </c:strCache>
            </c:strRef>
          </c:tx>
          <c:spPr>
            <a:ln w="9525" cap="rnd">
              <a:solidFill>
                <a:schemeClr val="accent3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J$5:$J$34</c:f>
              <c:numCache>
                <c:formatCode>General</c:formatCode>
                <c:ptCount val="30"/>
                <c:pt idx="0">
                  <c:v>1</c:v>
                </c:pt>
                <c:pt idx="1">
                  <c:v>168.97</c:v>
                </c:pt>
                <c:pt idx="2">
                  <c:v>245.67</c:v>
                </c:pt>
                <c:pt idx="3">
                  <c:v>299.73</c:v>
                </c:pt>
                <c:pt idx="4">
                  <c:v>345.09</c:v>
                </c:pt>
                <c:pt idx="5">
                  <c:v>380.46</c:v>
                </c:pt>
                <c:pt idx="6">
                  <c:v>409.85</c:v>
                </c:pt>
                <c:pt idx="7">
                  <c:v>437.32</c:v>
                </c:pt>
                <c:pt idx="8">
                  <c:v>459.72</c:v>
                </c:pt>
                <c:pt idx="9">
                  <c:v>480.28</c:v>
                </c:pt>
                <c:pt idx="10">
                  <c:v>500.13</c:v>
                </c:pt>
                <c:pt idx="11">
                  <c:v>516.08000000000004</c:v>
                </c:pt>
                <c:pt idx="12">
                  <c:v>531.91999999999996</c:v>
                </c:pt>
                <c:pt idx="13">
                  <c:v>544.65</c:v>
                </c:pt>
                <c:pt idx="14">
                  <c:v>556.16999999999996</c:v>
                </c:pt>
                <c:pt idx="15">
                  <c:v>565.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5FB9-474D-98FB-FB7E44384FD7}"/>
            </c:ext>
          </c:extLst>
        </c:ser>
        <c:ser>
          <c:idx val="9"/>
          <c:order val="9"/>
          <c:tx>
            <c:strRef>
              <c:f>Kid!$K$4</c:f>
              <c:strCache>
                <c:ptCount val="1"/>
                <c:pt idx="0">
                  <c:v>01/08/2013</c:v>
                </c:pt>
              </c:strCache>
            </c:strRef>
          </c:tx>
          <c:spPr>
            <a:ln w="9525" cap="rnd">
              <a:solidFill>
                <a:schemeClr val="accent4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K$5:$K$34</c:f>
              <c:numCache>
                <c:formatCode>General</c:formatCode>
                <c:ptCount val="30"/>
                <c:pt idx="0">
                  <c:v>1</c:v>
                </c:pt>
                <c:pt idx="1">
                  <c:v>201.34</c:v>
                </c:pt>
                <c:pt idx="2">
                  <c:v>286.5</c:v>
                </c:pt>
                <c:pt idx="3">
                  <c:v>347.94</c:v>
                </c:pt>
                <c:pt idx="4">
                  <c:v>393.83</c:v>
                </c:pt>
                <c:pt idx="5">
                  <c:v>436.85</c:v>
                </c:pt>
                <c:pt idx="6">
                  <c:v>470.28</c:v>
                </c:pt>
                <c:pt idx="7">
                  <c:v>501</c:v>
                </c:pt>
                <c:pt idx="8">
                  <c:v>526.30999999999983</c:v>
                </c:pt>
                <c:pt idx="9">
                  <c:v>550.8599999999999</c:v>
                </c:pt>
                <c:pt idx="10">
                  <c:v>571.57000000000005</c:v>
                </c:pt>
                <c:pt idx="11">
                  <c:v>593</c:v>
                </c:pt>
                <c:pt idx="12">
                  <c:v>605.72</c:v>
                </c:pt>
                <c:pt idx="13">
                  <c:v>623.61</c:v>
                </c:pt>
                <c:pt idx="14">
                  <c:v>641.53</c:v>
                </c:pt>
                <c:pt idx="15">
                  <c:v>653.45999999999992</c:v>
                </c:pt>
                <c:pt idx="16">
                  <c:v>665.04</c:v>
                </c:pt>
                <c:pt idx="17">
                  <c:v>678.56</c:v>
                </c:pt>
                <c:pt idx="18">
                  <c:v>688.02</c:v>
                </c:pt>
                <c:pt idx="19">
                  <c:v>698.05</c:v>
                </c:pt>
                <c:pt idx="20">
                  <c:v>705.66</c:v>
                </c:pt>
                <c:pt idx="21">
                  <c:v>714.829999999999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5FB9-474D-98FB-FB7E44384FD7}"/>
            </c:ext>
          </c:extLst>
        </c:ser>
        <c:ser>
          <c:idx val="10"/>
          <c:order val="10"/>
          <c:tx>
            <c:strRef>
              <c:f>Kid!$L$4</c:f>
              <c:strCache>
                <c:ptCount val="1"/>
                <c:pt idx="0">
                  <c:v>08/08/2013</c:v>
                </c:pt>
              </c:strCache>
            </c:strRef>
          </c:tx>
          <c:spPr>
            <a:ln w="9525" cap="rnd">
              <a:solidFill>
                <a:schemeClr val="accent5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L$5:$L$34</c:f>
              <c:numCache>
                <c:formatCode>General</c:formatCode>
                <c:ptCount val="30"/>
                <c:pt idx="0">
                  <c:v>1</c:v>
                </c:pt>
                <c:pt idx="1">
                  <c:v>138.88999999999999</c:v>
                </c:pt>
                <c:pt idx="2">
                  <c:v>212.03</c:v>
                </c:pt>
                <c:pt idx="3">
                  <c:v>270.73</c:v>
                </c:pt>
                <c:pt idx="4">
                  <c:v>315.8</c:v>
                </c:pt>
                <c:pt idx="5">
                  <c:v>357.56</c:v>
                </c:pt>
                <c:pt idx="6">
                  <c:v>393.81</c:v>
                </c:pt>
                <c:pt idx="7">
                  <c:v>423.6</c:v>
                </c:pt>
                <c:pt idx="8">
                  <c:v>451.89</c:v>
                </c:pt>
                <c:pt idx="9">
                  <c:v>479.64</c:v>
                </c:pt>
                <c:pt idx="10">
                  <c:v>501.62</c:v>
                </c:pt>
                <c:pt idx="11">
                  <c:v>519.95999999999992</c:v>
                </c:pt>
                <c:pt idx="12">
                  <c:v>538.48</c:v>
                </c:pt>
                <c:pt idx="13">
                  <c:v>556.9</c:v>
                </c:pt>
                <c:pt idx="14">
                  <c:v>573.57000000000005</c:v>
                </c:pt>
                <c:pt idx="15">
                  <c:v>585.97</c:v>
                </c:pt>
                <c:pt idx="16">
                  <c:v>601.29999999999995</c:v>
                </c:pt>
                <c:pt idx="17">
                  <c:v>614.70000000000005</c:v>
                </c:pt>
                <c:pt idx="18">
                  <c:v>627.04</c:v>
                </c:pt>
                <c:pt idx="19">
                  <c:v>637.43999999999994</c:v>
                </c:pt>
                <c:pt idx="20">
                  <c:v>646.76</c:v>
                </c:pt>
                <c:pt idx="21">
                  <c:v>657.05</c:v>
                </c:pt>
                <c:pt idx="22">
                  <c:v>664.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5FB9-474D-98FB-FB7E44384FD7}"/>
            </c:ext>
          </c:extLst>
        </c:ser>
        <c:ser>
          <c:idx val="11"/>
          <c:order val="11"/>
          <c:tx>
            <c:strRef>
              <c:f>Kid!$M$4</c:f>
              <c:strCache>
                <c:ptCount val="1"/>
                <c:pt idx="0">
                  <c:v>08/08/2013</c:v>
                </c:pt>
              </c:strCache>
            </c:strRef>
          </c:tx>
          <c:spPr>
            <a:ln w="9525" cap="rnd">
              <a:solidFill>
                <a:schemeClr val="accent6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M$5:$M$34</c:f>
              <c:numCache>
                <c:formatCode>General</c:formatCode>
                <c:ptCount val="30"/>
                <c:pt idx="0">
                  <c:v>1</c:v>
                </c:pt>
                <c:pt idx="1">
                  <c:v>156.07</c:v>
                </c:pt>
                <c:pt idx="2">
                  <c:v>229.23</c:v>
                </c:pt>
                <c:pt idx="3">
                  <c:v>282.67</c:v>
                </c:pt>
                <c:pt idx="4">
                  <c:v>324.89999999999992</c:v>
                </c:pt>
                <c:pt idx="5">
                  <c:v>362.77</c:v>
                </c:pt>
                <c:pt idx="6">
                  <c:v>392.15</c:v>
                </c:pt>
                <c:pt idx="7">
                  <c:v>421.11</c:v>
                </c:pt>
                <c:pt idx="8">
                  <c:v>441.87</c:v>
                </c:pt>
                <c:pt idx="9">
                  <c:v>462.27</c:v>
                </c:pt>
                <c:pt idx="10">
                  <c:v>485.04</c:v>
                </c:pt>
                <c:pt idx="11">
                  <c:v>500.64</c:v>
                </c:pt>
                <c:pt idx="12">
                  <c:v>516.17999999999995</c:v>
                </c:pt>
                <c:pt idx="13">
                  <c:v>531.37</c:v>
                </c:pt>
                <c:pt idx="14">
                  <c:v>545.17999999999995</c:v>
                </c:pt>
                <c:pt idx="15">
                  <c:v>554.93999999999994</c:v>
                </c:pt>
                <c:pt idx="16">
                  <c:v>568.74</c:v>
                </c:pt>
                <c:pt idx="17">
                  <c:v>579.41</c:v>
                </c:pt>
                <c:pt idx="18">
                  <c:v>589.3599999999999</c:v>
                </c:pt>
                <c:pt idx="19">
                  <c:v>596.53</c:v>
                </c:pt>
                <c:pt idx="20">
                  <c:v>605.82999999999993</c:v>
                </c:pt>
                <c:pt idx="21">
                  <c:v>613.69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5FB9-474D-98FB-FB7E44384FD7}"/>
            </c:ext>
          </c:extLst>
        </c:ser>
        <c:ser>
          <c:idx val="12"/>
          <c:order val="12"/>
          <c:tx>
            <c:strRef>
              <c:f>Kid!$N$4</c:f>
              <c:strCache>
                <c:ptCount val="1"/>
                <c:pt idx="0">
                  <c:v>15/08/2013</c:v>
                </c:pt>
              </c:strCache>
            </c:strRef>
          </c:tx>
          <c:spPr>
            <a:ln w="952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N$5:$N$34</c:f>
              <c:numCache>
                <c:formatCode>General</c:formatCode>
                <c:ptCount val="30"/>
                <c:pt idx="0">
                  <c:v>1</c:v>
                </c:pt>
                <c:pt idx="1">
                  <c:v>148.41</c:v>
                </c:pt>
                <c:pt idx="2">
                  <c:v>219.95</c:v>
                </c:pt>
                <c:pt idx="3">
                  <c:v>274.31</c:v>
                </c:pt>
                <c:pt idx="4">
                  <c:v>316.70999999999992</c:v>
                </c:pt>
                <c:pt idx="5">
                  <c:v>358.21</c:v>
                </c:pt>
                <c:pt idx="6">
                  <c:v>387.31</c:v>
                </c:pt>
                <c:pt idx="7">
                  <c:v>416.98</c:v>
                </c:pt>
                <c:pt idx="8">
                  <c:v>441.61</c:v>
                </c:pt>
                <c:pt idx="9">
                  <c:v>463.29</c:v>
                </c:pt>
                <c:pt idx="10">
                  <c:v>483.07</c:v>
                </c:pt>
                <c:pt idx="11">
                  <c:v>501.76</c:v>
                </c:pt>
                <c:pt idx="12">
                  <c:v>515.98</c:v>
                </c:pt>
                <c:pt idx="13">
                  <c:v>533.30999999999983</c:v>
                </c:pt>
                <c:pt idx="14">
                  <c:v>543.70000000000005</c:v>
                </c:pt>
                <c:pt idx="15">
                  <c:v>557.27</c:v>
                </c:pt>
                <c:pt idx="16">
                  <c:v>569.51</c:v>
                </c:pt>
                <c:pt idx="17">
                  <c:v>578.88</c:v>
                </c:pt>
                <c:pt idx="18">
                  <c:v>589.059999999999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5FB9-474D-98FB-FB7E44384FD7}"/>
            </c:ext>
          </c:extLst>
        </c:ser>
        <c:ser>
          <c:idx val="13"/>
          <c:order val="13"/>
          <c:tx>
            <c:strRef>
              <c:f>Kid!$O$4</c:f>
              <c:strCache>
                <c:ptCount val="1"/>
                <c:pt idx="0">
                  <c:v>15/08/2013</c:v>
                </c:pt>
              </c:strCache>
            </c:strRef>
          </c:tx>
          <c:spPr>
            <a:ln w="952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O$5:$O$34</c:f>
              <c:numCache>
                <c:formatCode>General</c:formatCode>
                <c:ptCount val="30"/>
                <c:pt idx="0">
                  <c:v>1</c:v>
                </c:pt>
                <c:pt idx="1">
                  <c:v>179.03</c:v>
                </c:pt>
                <c:pt idx="2">
                  <c:v>263.08</c:v>
                </c:pt>
                <c:pt idx="3">
                  <c:v>324.37</c:v>
                </c:pt>
                <c:pt idx="4">
                  <c:v>373.5</c:v>
                </c:pt>
                <c:pt idx="5">
                  <c:v>414.92</c:v>
                </c:pt>
                <c:pt idx="6">
                  <c:v>449.67</c:v>
                </c:pt>
                <c:pt idx="7">
                  <c:v>483.03</c:v>
                </c:pt>
                <c:pt idx="8">
                  <c:v>509.1</c:v>
                </c:pt>
                <c:pt idx="9">
                  <c:v>531.09</c:v>
                </c:pt>
                <c:pt idx="10">
                  <c:v>553.70000000000005</c:v>
                </c:pt>
                <c:pt idx="11">
                  <c:v>572.73</c:v>
                </c:pt>
                <c:pt idx="12">
                  <c:v>592.29999999999995</c:v>
                </c:pt>
                <c:pt idx="13">
                  <c:v>605.19000000000005</c:v>
                </c:pt>
                <c:pt idx="14">
                  <c:v>622.5</c:v>
                </c:pt>
                <c:pt idx="15">
                  <c:v>633.32999999999993</c:v>
                </c:pt>
                <c:pt idx="16">
                  <c:v>644.24</c:v>
                </c:pt>
                <c:pt idx="17">
                  <c:v>655.7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5FB9-474D-98FB-FB7E44384FD7}"/>
            </c:ext>
          </c:extLst>
        </c:ser>
        <c:ser>
          <c:idx val="14"/>
          <c:order val="14"/>
          <c:tx>
            <c:strRef>
              <c:f>Kid!$P$4</c:f>
              <c:strCache>
                <c:ptCount val="1"/>
                <c:pt idx="0">
                  <c:v>01/09/2013</c:v>
                </c:pt>
              </c:strCache>
            </c:strRef>
          </c:tx>
          <c:spPr>
            <a:ln w="952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P$5:$P$34</c:f>
              <c:numCache>
                <c:formatCode>General</c:formatCode>
                <c:ptCount val="30"/>
                <c:pt idx="0">
                  <c:v>1</c:v>
                </c:pt>
                <c:pt idx="1">
                  <c:v>120.76</c:v>
                </c:pt>
                <c:pt idx="2">
                  <c:v>186.27</c:v>
                </c:pt>
                <c:pt idx="3">
                  <c:v>235.11</c:v>
                </c:pt>
                <c:pt idx="4">
                  <c:v>275.02999999999992</c:v>
                </c:pt>
                <c:pt idx="5">
                  <c:v>309.24</c:v>
                </c:pt>
                <c:pt idx="6">
                  <c:v>338.72</c:v>
                </c:pt>
                <c:pt idx="7">
                  <c:v>364.65</c:v>
                </c:pt>
                <c:pt idx="8">
                  <c:v>390.29</c:v>
                </c:pt>
                <c:pt idx="9">
                  <c:v>410.87</c:v>
                </c:pt>
                <c:pt idx="10">
                  <c:v>429.73</c:v>
                </c:pt>
                <c:pt idx="11">
                  <c:v>446.67</c:v>
                </c:pt>
                <c:pt idx="12">
                  <c:v>460.01</c:v>
                </c:pt>
                <c:pt idx="13">
                  <c:v>473.78</c:v>
                </c:pt>
                <c:pt idx="14">
                  <c:v>485.48</c:v>
                </c:pt>
                <c:pt idx="15">
                  <c:v>500.41</c:v>
                </c:pt>
                <c:pt idx="16">
                  <c:v>509.59</c:v>
                </c:pt>
                <c:pt idx="17">
                  <c:v>518.75</c:v>
                </c:pt>
                <c:pt idx="18">
                  <c:v>528.85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5FB9-474D-98FB-FB7E44384FD7}"/>
            </c:ext>
          </c:extLst>
        </c:ser>
        <c:ser>
          <c:idx val="15"/>
          <c:order val="15"/>
          <c:tx>
            <c:strRef>
              <c:f>Kid!$Q$4</c:f>
              <c:strCache>
                <c:ptCount val="1"/>
                <c:pt idx="0">
                  <c:v>01/09/2013</c:v>
                </c:pt>
              </c:strCache>
            </c:strRef>
          </c:tx>
          <c:spPr>
            <a:ln w="952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Q$5:$Q$34</c:f>
              <c:numCache>
                <c:formatCode>General</c:formatCode>
                <c:ptCount val="30"/>
                <c:pt idx="0">
                  <c:v>1</c:v>
                </c:pt>
                <c:pt idx="1">
                  <c:v>183.13</c:v>
                </c:pt>
                <c:pt idx="2">
                  <c:v>265.58999999999992</c:v>
                </c:pt>
                <c:pt idx="3">
                  <c:v>324</c:v>
                </c:pt>
                <c:pt idx="4">
                  <c:v>370.88</c:v>
                </c:pt>
                <c:pt idx="5">
                  <c:v>410.11</c:v>
                </c:pt>
                <c:pt idx="6">
                  <c:v>445.74</c:v>
                </c:pt>
                <c:pt idx="7">
                  <c:v>475.16</c:v>
                </c:pt>
                <c:pt idx="8">
                  <c:v>500.41</c:v>
                </c:pt>
                <c:pt idx="9">
                  <c:v>525.01</c:v>
                </c:pt>
                <c:pt idx="10">
                  <c:v>545.93999999999994</c:v>
                </c:pt>
                <c:pt idx="11">
                  <c:v>564.30999999999983</c:v>
                </c:pt>
                <c:pt idx="12">
                  <c:v>582.1</c:v>
                </c:pt>
                <c:pt idx="13">
                  <c:v>600.63</c:v>
                </c:pt>
                <c:pt idx="14">
                  <c:v>611.97</c:v>
                </c:pt>
                <c:pt idx="15">
                  <c:v>625.32999999999993</c:v>
                </c:pt>
                <c:pt idx="16">
                  <c:v>638.57000000000005</c:v>
                </c:pt>
                <c:pt idx="17">
                  <c:v>648.84999999999991</c:v>
                </c:pt>
                <c:pt idx="18">
                  <c:v>660.81999999999994</c:v>
                </c:pt>
                <c:pt idx="19">
                  <c:v>671.95999999999992</c:v>
                </c:pt>
                <c:pt idx="20">
                  <c:v>679.31999999999994</c:v>
                </c:pt>
                <c:pt idx="21">
                  <c:v>689.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5FB9-474D-98FB-FB7E44384FD7}"/>
            </c:ext>
          </c:extLst>
        </c:ser>
        <c:ser>
          <c:idx val="16"/>
          <c:order val="16"/>
          <c:tx>
            <c:strRef>
              <c:f>Kid!$R$4</c:f>
              <c:strCache>
                <c:ptCount val="1"/>
                <c:pt idx="0">
                  <c:v>01/10/2013</c:v>
                </c:pt>
              </c:strCache>
            </c:strRef>
          </c:tx>
          <c:spPr>
            <a:ln w="952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R$5:$R$34</c:f>
              <c:numCache>
                <c:formatCode>General</c:formatCode>
                <c:ptCount val="30"/>
                <c:pt idx="0">
                  <c:v>1</c:v>
                </c:pt>
                <c:pt idx="1">
                  <c:v>186.08</c:v>
                </c:pt>
                <c:pt idx="2">
                  <c:v>268.24</c:v>
                </c:pt>
                <c:pt idx="3">
                  <c:v>323.82</c:v>
                </c:pt>
                <c:pt idx="4">
                  <c:v>367.18</c:v>
                </c:pt>
                <c:pt idx="5">
                  <c:v>400.73</c:v>
                </c:pt>
                <c:pt idx="6">
                  <c:v>426.71</c:v>
                </c:pt>
                <c:pt idx="7">
                  <c:v>449.61</c:v>
                </c:pt>
                <c:pt idx="8">
                  <c:v>466.92</c:v>
                </c:pt>
                <c:pt idx="9">
                  <c:v>481.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5FB9-474D-98FB-FB7E44384FD7}"/>
            </c:ext>
          </c:extLst>
        </c:ser>
        <c:ser>
          <c:idx val="17"/>
          <c:order val="17"/>
          <c:tx>
            <c:strRef>
              <c:f>Kid!$S$4</c:f>
              <c:strCache>
                <c:ptCount val="1"/>
                <c:pt idx="0">
                  <c:v>01/10/2013</c:v>
                </c:pt>
              </c:strCache>
            </c:strRef>
          </c:tx>
          <c:spPr>
            <a:ln w="952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S$5:$S$34</c:f>
              <c:numCache>
                <c:formatCode>General</c:formatCode>
                <c:ptCount val="30"/>
                <c:pt idx="0">
                  <c:v>1</c:v>
                </c:pt>
                <c:pt idx="1">
                  <c:v>221.51</c:v>
                </c:pt>
                <c:pt idx="2">
                  <c:v>316.38</c:v>
                </c:pt>
                <c:pt idx="3">
                  <c:v>381.75</c:v>
                </c:pt>
                <c:pt idx="4">
                  <c:v>436.04</c:v>
                </c:pt>
                <c:pt idx="5">
                  <c:v>476.46</c:v>
                </c:pt>
                <c:pt idx="6">
                  <c:v>516.19000000000005</c:v>
                </c:pt>
                <c:pt idx="7">
                  <c:v>549.17999999999995</c:v>
                </c:pt>
                <c:pt idx="8">
                  <c:v>577.34999999999991</c:v>
                </c:pt>
                <c:pt idx="9">
                  <c:v>604.23</c:v>
                </c:pt>
                <c:pt idx="10">
                  <c:v>628.94999999999993</c:v>
                </c:pt>
                <c:pt idx="11">
                  <c:v>650.25</c:v>
                </c:pt>
                <c:pt idx="12">
                  <c:v>667.84999999999991</c:v>
                </c:pt>
                <c:pt idx="13">
                  <c:v>687.41</c:v>
                </c:pt>
                <c:pt idx="14">
                  <c:v>702.9</c:v>
                </c:pt>
                <c:pt idx="15">
                  <c:v>720.49</c:v>
                </c:pt>
                <c:pt idx="16">
                  <c:v>731.1</c:v>
                </c:pt>
                <c:pt idx="17">
                  <c:v>745.75</c:v>
                </c:pt>
                <c:pt idx="18">
                  <c:v>757.41</c:v>
                </c:pt>
                <c:pt idx="19">
                  <c:v>767.33999999999992</c:v>
                </c:pt>
                <c:pt idx="20">
                  <c:v>777.25</c:v>
                </c:pt>
                <c:pt idx="21">
                  <c:v>787.49</c:v>
                </c:pt>
                <c:pt idx="22">
                  <c:v>798.45999999999992</c:v>
                </c:pt>
                <c:pt idx="23">
                  <c:v>806.1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5FB9-474D-98FB-FB7E44384FD7}"/>
            </c:ext>
          </c:extLst>
        </c:ser>
        <c:ser>
          <c:idx val="18"/>
          <c:order val="18"/>
          <c:tx>
            <c:strRef>
              <c:f>Kid!$T$4</c:f>
              <c:strCache>
                <c:ptCount val="1"/>
                <c:pt idx="0">
                  <c:v>01/11/2013</c:v>
                </c:pt>
              </c:strCache>
            </c:strRef>
          </c:tx>
          <c:spPr>
            <a:ln w="9525" cap="rnd">
              <a:solidFill>
                <a:schemeClr val="accent1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T$5:$T$34</c:f>
              <c:numCache>
                <c:formatCode>General</c:formatCode>
                <c:ptCount val="30"/>
                <c:pt idx="0">
                  <c:v>1</c:v>
                </c:pt>
                <c:pt idx="1">
                  <c:v>190.36</c:v>
                </c:pt>
                <c:pt idx="2">
                  <c:v>271.35000000000002</c:v>
                </c:pt>
                <c:pt idx="3">
                  <c:v>331.54</c:v>
                </c:pt>
                <c:pt idx="4">
                  <c:v>379.66</c:v>
                </c:pt>
                <c:pt idx="5">
                  <c:v>419.33</c:v>
                </c:pt>
                <c:pt idx="6">
                  <c:v>454.61</c:v>
                </c:pt>
                <c:pt idx="7">
                  <c:v>483.89</c:v>
                </c:pt>
                <c:pt idx="8">
                  <c:v>513.05999999999983</c:v>
                </c:pt>
                <c:pt idx="9">
                  <c:v>536.8599999999999</c:v>
                </c:pt>
                <c:pt idx="10">
                  <c:v>557.52</c:v>
                </c:pt>
                <c:pt idx="11">
                  <c:v>577.23</c:v>
                </c:pt>
                <c:pt idx="12">
                  <c:v>595.57000000000005</c:v>
                </c:pt>
                <c:pt idx="13">
                  <c:v>613.63</c:v>
                </c:pt>
                <c:pt idx="14">
                  <c:v>627.64</c:v>
                </c:pt>
                <c:pt idx="15">
                  <c:v>641.71</c:v>
                </c:pt>
                <c:pt idx="16">
                  <c:v>655.04999999999984</c:v>
                </c:pt>
                <c:pt idx="17">
                  <c:v>666</c:v>
                </c:pt>
                <c:pt idx="18">
                  <c:v>675.44999999999993</c:v>
                </c:pt>
                <c:pt idx="19">
                  <c:v>688.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2-5FB9-474D-98FB-FB7E44384FD7}"/>
            </c:ext>
          </c:extLst>
        </c:ser>
        <c:ser>
          <c:idx val="19"/>
          <c:order val="19"/>
          <c:tx>
            <c:strRef>
              <c:f>Kid!$U$4</c:f>
              <c:strCache>
                <c:ptCount val="1"/>
                <c:pt idx="0">
                  <c:v>01/11/2013</c:v>
                </c:pt>
              </c:strCache>
            </c:strRef>
          </c:tx>
          <c:spPr>
            <a:ln w="9525" cap="rnd">
              <a:solidFill>
                <a:schemeClr val="accent2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U$5:$U$34</c:f>
              <c:numCache>
                <c:formatCode>General</c:formatCode>
                <c:ptCount val="30"/>
                <c:pt idx="0">
                  <c:v>1</c:v>
                </c:pt>
                <c:pt idx="1">
                  <c:v>211.04</c:v>
                </c:pt>
                <c:pt idx="2">
                  <c:v>305.66000000000008</c:v>
                </c:pt>
                <c:pt idx="3">
                  <c:v>374.33</c:v>
                </c:pt>
                <c:pt idx="4">
                  <c:v>431.65</c:v>
                </c:pt>
                <c:pt idx="5">
                  <c:v>475.54</c:v>
                </c:pt>
                <c:pt idx="6">
                  <c:v>513.29</c:v>
                </c:pt>
                <c:pt idx="7">
                  <c:v>551.25</c:v>
                </c:pt>
                <c:pt idx="8">
                  <c:v>578.13</c:v>
                </c:pt>
                <c:pt idx="9">
                  <c:v>607.77</c:v>
                </c:pt>
                <c:pt idx="10">
                  <c:v>631.89</c:v>
                </c:pt>
                <c:pt idx="11">
                  <c:v>654.93999999999994</c:v>
                </c:pt>
                <c:pt idx="12">
                  <c:v>673.23</c:v>
                </c:pt>
                <c:pt idx="13">
                  <c:v>691.94999999999993</c:v>
                </c:pt>
                <c:pt idx="14">
                  <c:v>708.33999999999992</c:v>
                </c:pt>
                <c:pt idx="15">
                  <c:v>725.08</c:v>
                </c:pt>
                <c:pt idx="16">
                  <c:v>738.94999999999993</c:v>
                </c:pt>
                <c:pt idx="17">
                  <c:v>751.31</c:v>
                </c:pt>
                <c:pt idx="18">
                  <c:v>764.03</c:v>
                </c:pt>
                <c:pt idx="19">
                  <c:v>774.81999999999994</c:v>
                </c:pt>
                <c:pt idx="20">
                  <c:v>784.98</c:v>
                </c:pt>
                <c:pt idx="21">
                  <c:v>793.09</c:v>
                </c:pt>
                <c:pt idx="22">
                  <c:v>802.37</c:v>
                </c:pt>
                <c:pt idx="23">
                  <c:v>811.89</c:v>
                </c:pt>
                <c:pt idx="24">
                  <c:v>818.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3-5FB9-474D-98FB-FB7E44384FD7}"/>
            </c:ext>
          </c:extLst>
        </c:ser>
        <c:ser>
          <c:idx val="20"/>
          <c:order val="20"/>
          <c:tx>
            <c:strRef>
              <c:f>Kid!$V$4</c:f>
              <c:strCache>
                <c:ptCount val="1"/>
                <c:pt idx="0">
                  <c:v>01/12/2013</c:v>
                </c:pt>
              </c:strCache>
            </c:strRef>
          </c:tx>
          <c:spPr>
            <a:ln w="9525" cap="rnd">
              <a:solidFill>
                <a:schemeClr val="accent3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V$5:$V$34</c:f>
              <c:numCache>
                <c:formatCode>General</c:formatCode>
                <c:ptCount val="30"/>
                <c:pt idx="0">
                  <c:v>1</c:v>
                </c:pt>
                <c:pt idx="1">
                  <c:v>182.88</c:v>
                </c:pt>
                <c:pt idx="2">
                  <c:v>258.05</c:v>
                </c:pt>
                <c:pt idx="3">
                  <c:v>313.92999999999989</c:v>
                </c:pt>
                <c:pt idx="4">
                  <c:v>356.98</c:v>
                </c:pt>
                <c:pt idx="5">
                  <c:v>394.59</c:v>
                </c:pt>
                <c:pt idx="6">
                  <c:v>425.39</c:v>
                </c:pt>
                <c:pt idx="7">
                  <c:v>457.91</c:v>
                </c:pt>
                <c:pt idx="8">
                  <c:v>479.06</c:v>
                </c:pt>
                <c:pt idx="9">
                  <c:v>497.71</c:v>
                </c:pt>
                <c:pt idx="10">
                  <c:v>518.81999999999994</c:v>
                </c:pt>
                <c:pt idx="11">
                  <c:v>535.53</c:v>
                </c:pt>
                <c:pt idx="12">
                  <c:v>551.45999999999992</c:v>
                </c:pt>
                <c:pt idx="13">
                  <c:v>564.59</c:v>
                </c:pt>
                <c:pt idx="14">
                  <c:v>578.04</c:v>
                </c:pt>
                <c:pt idx="15">
                  <c:v>588.47</c:v>
                </c:pt>
                <c:pt idx="16">
                  <c:v>599.32999999999993</c:v>
                </c:pt>
                <c:pt idx="17">
                  <c:v>606.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4-5FB9-474D-98FB-FB7E44384FD7}"/>
            </c:ext>
          </c:extLst>
        </c:ser>
        <c:ser>
          <c:idx val="21"/>
          <c:order val="21"/>
          <c:tx>
            <c:strRef>
              <c:f>Kid!$W$4</c:f>
              <c:strCache>
                <c:ptCount val="1"/>
                <c:pt idx="0">
                  <c:v>01/12/2013</c:v>
                </c:pt>
              </c:strCache>
            </c:strRef>
          </c:tx>
          <c:spPr>
            <a:ln w="9525" cap="rnd">
              <a:solidFill>
                <a:schemeClr val="accent4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W$5:$W$34</c:f>
              <c:numCache>
                <c:formatCode>General</c:formatCode>
                <c:ptCount val="30"/>
                <c:pt idx="0">
                  <c:v>1</c:v>
                </c:pt>
                <c:pt idx="1">
                  <c:v>205.9</c:v>
                </c:pt>
                <c:pt idx="2">
                  <c:v>292.42999999999989</c:v>
                </c:pt>
                <c:pt idx="3">
                  <c:v>356.2</c:v>
                </c:pt>
                <c:pt idx="4">
                  <c:v>409.85</c:v>
                </c:pt>
                <c:pt idx="5">
                  <c:v>451.28</c:v>
                </c:pt>
                <c:pt idx="6">
                  <c:v>484.5</c:v>
                </c:pt>
                <c:pt idx="7">
                  <c:v>517.91999999999996</c:v>
                </c:pt>
                <c:pt idx="8">
                  <c:v>545.47</c:v>
                </c:pt>
                <c:pt idx="9">
                  <c:v>568.71</c:v>
                </c:pt>
                <c:pt idx="10">
                  <c:v>589.62</c:v>
                </c:pt>
                <c:pt idx="11">
                  <c:v>608.74</c:v>
                </c:pt>
                <c:pt idx="12">
                  <c:v>625.97</c:v>
                </c:pt>
                <c:pt idx="13">
                  <c:v>640.71</c:v>
                </c:pt>
                <c:pt idx="14">
                  <c:v>656.41</c:v>
                </c:pt>
                <c:pt idx="15">
                  <c:v>669.48</c:v>
                </c:pt>
                <c:pt idx="16">
                  <c:v>682.03</c:v>
                </c:pt>
                <c:pt idx="17">
                  <c:v>693.3</c:v>
                </c:pt>
                <c:pt idx="18">
                  <c:v>703.52</c:v>
                </c:pt>
                <c:pt idx="19">
                  <c:v>712.09</c:v>
                </c:pt>
                <c:pt idx="20">
                  <c:v>719.4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5-5FB9-474D-98FB-FB7E44384FD7}"/>
            </c:ext>
          </c:extLst>
        </c:ser>
        <c:ser>
          <c:idx val="22"/>
          <c:order val="22"/>
          <c:tx>
            <c:strRef>
              <c:f>Kid!$X$4</c:f>
              <c:strCache>
                <c:ptCount val="1"/>
                <c:pt idx="0">
                  <c:v>01/01/2014</c:v>
                </c:pt>
              </c:strCache>
            </c:strRef>
          </c:tx>
          <c:spPr>
            <a:ln w="9525" cap="rnd">
              <a:solidFill>
                <a:schemeClr val="accent5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X$5:$X$34</c:f>
              <c:numCache>
                <c:formatCode>General</c:formatCode>
                <c:ptCount val="30"/>
                <c:pt idx="0">
                  <c:v>1</c:v>
                </c:pt>
                <c:pt idx="1">
                  <c:v>148.91999999999999</c:v>
                </c:pt>
                <c:pt idx="2">
                  <c:v>223.03</c:v>
                </c:pt>
                <c:pt idx="3">
                  <c:v>275.60000000000002</c:v>
                </c:pt>
                <c:pt idx="4">
                  <c:v>320.08</c:v>
                </c:pt>
                <c:pt idx="5">
                  <c:v>357</c:v>
                </c:pt>
                <c:pt idx="6">
                  <c:v>391.79</c:v>
                </c:pt>
                <c:pt idx="7">
                  <c:v>420.41</c:v>
                </c:pt>
                <c:pt idx="8">
                  <c:v>443.39</c:v>
                </c:pt>
                <c:pt idx="9">
                  <c:v>469.11</c:v>
                </c:pt>
                <c:pt idx="10">
                  <c:v>488.69</c:v>
                </c:pt>
                <c:pt idx="11">
                  <c:v>508.06</c:v>
                </c:pt>
                <c:pt idx="12">
                  <c:v>525.15</c:v>
                </c:pt>
                <c:pt idx="13">
                  <c:v>541.09</c:v>
                </c:pt>
                <c:pt idx="14">
                  <c:v>555.80999999999983</c:v>
                </c:pt>
                <c:pt idx="15">
                  <c:v>569.05999999999983</c:v>
                </c:pt>
                <c:pt idx="16">
                  <c:v>579.73</c:v>
                </c:pt>
                <c:pt idx="17">
                  <c:v>591.31999999999994</c:v>
                </c:pt>
                <c:pt idx="18">
                  <c:v>601.89</c:v>
                </c:pt>
                <c:pt idx="19">
                  <c:v>610.809999999999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6-5FB9-474D-98FB-FB7E44384FD7}"/>
            </c:ext>
          </c:extLst>
        </c:ser>
        <c:ser>
          <c:idx val="23"/>
          <c:order val="23"/>
          <c:tx>
            <c:strRef>
              <c:f>Kid!$Y$4</c:f>
              <c:strCache>
                <c:ptCount val="1"/>
                <c:pt idx="0">
                  <c:v>01/01/2014</c:v>
                </c:pt>
              </c:strCache>
            </c:strRef>
          </c:tx>
          <c:spPr>
            <a:ln w="9525" cap="rnd">
              <a:solidFill>
                <a:schemeClr val="accent6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Y$5:$Y$34</c:f>
              <c:numCache>
                <c:formatCode>General</c:formatCode>
                <c:ptCount val="30"/>
                <c:pt idx="0">
                  <c:v>1</c:v>
                </c:pt>
                <c:pt idx="1">
                  <c:v>178.41</c:v>
                </c:pt>
                <c:pt idx="2">
                  <c:v>256.49</c:v>
                </c:pt>
                <c:pt idx="3">
                  <c:v>314.06</c:v>
                </c:pt>
                <c:pt idx="4">
                  <c:v>365.76</c:v>
                </c:pt>
                <c:pt idx="5">
                  <c:v>405.12</c:v>
                </c:pt>
                <c:pt idx="6">
                  <c:v>440.28</c:v>
                </c:pt>
                <c:pt idx="7">
                  <c:v>469.99</c:v>
                </c:pt>
                <c:pt idx="8">
                  <c:v>496.25</c:v>
                </c:pt>
                <c:pt idx="9">
                  <c:v>523.01</c:v>
                </c:pt>
                <c:pt idx="10">
                  <c:v>545.08000000000004</c:v>
                </c:pt>
                <c:pt idx="11">
                  <c:v>564.32999999999993</c:v>
                </c:pt>
                <c:pt idx="12">
                  <c:v>586.25</c:v>
                </c:pt>
                <c:pt idx="13">
                  <c:v>598.89</c:v>
                </c:pt>
                <c:pt idx="14">
                  <c:v>614.70000000000005</c:v>
                </c:pt>
                <c:pt idx="15">
                  <c:v>629.27</c:v>
                </c:pt>
                <c:pt idx="16">
                  <c:v>640.81999999999994</c:v>
                </c:pt>
                <c:pt idx="17">
                  <c:v>655.82999999999993</c:v>
                </c:pt>
                <c:pt idx="18">
                  <c:v>667.79</c:v>
                </c:pt>
                <c:pt idx="19">
                  <c:v>676.3</c:v>
                </c:pt>
                <c:pt idx="20">
                  <c:v>686.8</c:v>
                </c:pt>
                <c:pt idx="21">
                  <c:v>693.3599999999999</c:v>
                </c:pt>
                <c:pt idx="22">
                  <c:v>704.449999999999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7-5FB9-474D-98FB-FB7E44384FD7}"/>
            </c:ext>
          </c:extLst>
        </c:ser>
        <c:ser>
          <c:idx val="24"/>
          <c:order val="24"/>
          <c:tx>
            <c:strRef>
              <c:f>Kid!$Z$4</c:f>
              <c:strCache>
                <c:ptCount val="1"/>
                <c:pt idx="0">
                  <c:v>01/02/2014</c:v>
                </c:pt>
              </c:strCache>
            </c:strRef>
          </c:tx>
          <c:spPr>
            <a:ln w="952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Z$5:$Z$34</c:f>
              <c:numCache>
                <c:formatCode>General</c:formatCode>
                <c:ptCount val="30"/>
                <c:pt idx="0">
                  <c:v>1</c:v>
                </c:pt>
                <c:pt idx="1">
                  <c:v>163.34</c:v>
                </c:pt>
                <c:pt idx="2">
                  <c:v>241.77</c:v>
                </c:pt>
                <c:pt idx="3">
                  <c:v>302.24</c:v>
                </c:pt>
                <c:pt idx="4">
                  <c:v>351.02</c:v>
                </c:pt>
                <c:pt idx="5">
                  <c:v>392.44</c:v>
                </c:pt>
                <c:pt idx="6">
                  <c:v>427.33</c:v>
                </c:pt>
                <c:pt idx="7">
                  <c:v>456.27</c:v>
                </c:pt>
                <c:pt idx="8">
                  <c:v>487.35</c:v>
                </c:pt>
                <c:pt idx="9">
                  <c:v>512.1</c:v>
                </c:pt>
                <c:pt idx="10">
                  <c:v>531.74</c:v>
                </c:pt>
                <c:pt idx="11">
                  <c:v>553.80999999999983</c:v>
                </c:pt>
                <c:pt idx="12">
                  <c:v>573.31999999999994</c:v>
                </c:pt>
                <c:pt idx="13">
                  <c:v>586.87</c:v>
                </c:pt>
                <c:pt idx="14">
                  <c:v>604</c:v>
                </c:pt>
                <c:pt idx="15">
                  <c:v>619.27</c:v>
                </c:pt>
                <c:pt idx="16">
                  <c:v>630.87</c:v>
                </c:pt>
                <c:pt idx="17">
                  <c:v>641.89</c:v>
                </c:pt>
                <c:pt idx="18">
                  <c:v>653.79</c:v>
                </c:pt>
                <c:pt idx="19">
                  <c:v>663.34999999999991</c:v>
                </c:pt>
                <c:pt idx="20">
                  <c:v>673.43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8-5FB9-474D-98FB-FB7E44384FD7}"/>
            </c:ext>
          </c:extLst>
        </c:ser>
        <c:ser>
          <c:idx val="25"/>
          <c:order val="25"/>
          <c:tx>
            <c:strRef>
              <c:f>Kid!$AA$4</c:f>
              <c:strCache>
                <c:ptCount val="1"/>
                <c:pt idx="0">
                  <c:v>01/02/2014</c:v>
                </c:pt>
              </c:strCache>
            </c:strRef>
          </c:tx>
          <c:spPr>
            <a:ln w="952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A$5:$AA$34</c:f>
              <c:numCache>
                <c:formatCode>General</c:formatCode>
                <c:ptCount val="30"/>
                <c:pt idx="0">
                  <c:v>1</c:v>
                </c:pt>
                <c:pt idx="1">
                  <c:v>195.93</c:v>
                </c:pt>
                <c:pt idx="2">
                  <c:v>282.14</c:v>
                </c:pt>
                <c:pt idx="3">
                  <c:v>348.19</c:v>
                </c:pt>
                <c:pt idx="4">
                  <c:v>399.77</c:v>
                </c:pt>
                <c:pt idx="5">
                  <c:v>442.51</c:v>
                </c:pt>
                <c:pt idx="6">
                  <c:v>481.12</c:v>
                </c:pt>
                <c:pt idx="7">
                  <c:v>514.31999999999994</c:v>
                </c:pt>
                <c:pt idx="8">
                  <c:v>545.13</c:v>
                </c:pt>
                <c:pt idx="9">
                  <c:v>569.75</c:v>
                </c:pt>
                <c:pt idx="10">
                  <c:v>597.49</c:v>
                </c:pt>
                <c:pt idx="11">
                  <c:v>613.98</c:v>
                </c:pt>
                <c:pt idx="12">
                  <c:v>636.13</c:v>
                </c:pt>
                <c:pt idx="13">
                  <c:v>655.41</c:v>
                </c:pt>
                <c:pt idx="14">
                  <c:v>674.71</c:v>
                </c:pt>
                <c:pt idx="15">
                  <c:v>689.26</c:v>
                </c:pt>
                <c:pt idx="16">
                  <c:v>706.65</c:v>
                </c:pt>
                <c:pt idx="17">
                  <c:v>718.04</c:v>
                </c:pt>
                <c:pt idx="18">
                  <c:v>731.82999999999993</c:v>
                </c:pt>
                <c:pt idx="19">
                  <c:v>744.5</c:v>
                </c:pt>
                <c:pt idx="20">
                  <c:v>755.02</c:v>
                </c:pt>
                <c:pt idx="21">
                  <c:v>766.33999999999992</c:v>
                </c:pt>
                <c:pt idx="22">
                  <c:v>775.45999999999992</c:v>
                </c:pt>
                <c:pt idx="23">
                  <c:v>784.38</c:v>
                </c:pt>
                <c:pt idx="24">
                  <c:v>791.31</c:v>
                </c:pt>
                <c:pt idx="25">
                  <c:v>802.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9-5FB9-474D-98FB-FB7E44384FD7}"/>
            </c:ext>
          </c:extLst>
        </c:ser>
        <c:ser>
          <c:idx val="26"/>
          <c:order val="26"/>
          <c:tx>
            <c:strRef>
              <c:f>Kid!$AB$4</c:f>
              <c:strCache>
                <c:ptCount val="1"/>
                <c:pt idx="0">
                  <c:v>08/02/2014</c:v>
                </c:pt>
              </c:strCache>
            </c:strRef>
          </c:tx>
          <c:spPr>
            <a:ln w="952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B$5:$AB$34</c:f>
              <c:numCache>
                <c:formatCode>General</c:formatCode>
                <c:ptCount val="30"/>
                <c:pt idx="0">
                  <c:v>1</c:v>
                </c:pt>
                <c:pt idx="1">
                  <c:v>170.82</c:v>
                </c:pt>
                <c:pt idx="2">
                  <c:v>250.23</c:v>
                </c:pt>
                <c:pt idx="3">
                  <c:v>307.13</c:v>
                </c:pt>
                <c:pt idx="4">
                  <c:v>352.8</c:v>
                </c:pt>
                <c:pt idx="5">
                  <c:v>392.13</c:v>
                </c:pt>
                <c:pt idx="6">
                  <c:v>424.3</c:v>
                </c:pt>
                <c:pt idx="7">
                  <c:v>454.25</c:v>
                </c:pt>
                <c:pt idx="8">
                  <c:v>477.66</c:v>
                </c:pt>
                <c:pt idx="9">
                  <c:v>504.03</c:v>
                </c:pt>
                <c:pt idx="10">
                  <c:v>525.13</c:v>
                </c:pt>
                <c:pt idx="11">
                  <c:v>543.34999999999991</c:v>
                </c:pt>
                <c:pt idx="12">
                  <c:v>560.75</c:v>
                </c:pt>
                <c:pt idx="13">
                  <c:v>575.87</c:v>
                </c:pt>
                <c:pt idx="14">
                  <c:v>590.14</c:v>
                </c:pt>
                <c:pt idx="15">
                  <c:v>604.52</c:v>
                </c:pt>
                <c:pt idx="16">
                  <c:v>614.26</c:v>
                </c:pt>
                <c:pt idx="17">
                  <c:v>626.04</c:v>
                </c:pt>
                <c:pt idx="18">
                  <c:v>636.89</c:v>
                </c:pt>
                <c:pt idx="19">
                  <c:v>644.93999999999994</c:v>
                </c:pt>
                <c:pt idx="20">
                  <c:v>654.2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A-5FB9-474D-98FB-FB7E44384FD7}"/>
            </c:ext>
          </c:extLst>
        </c:ser>
        <c:ser>
          <c:idx val="28"/>
          <c:order val="27"/>
          <c:tx>
            <c:strRef>
              <c:f>Kid!$AC$4</c:f>
              <c:strCache>
                <c:ptCount val="1"/>
                <c:pt idx="0">
                  <c:v>15/02/2014</c:v>
                </c:pt>
              </c:strCache>
            </c:strRef>
          </c:tx>
          <c:spPr>
            <a:ln w="952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C$5:$AC$34</c:f>
              <c:numCache>
                <c:formatCode>General</c:formatCode>
                <c:ptCount val="30"/>
                <c:pt idx="0">
                  <c:v>1</c:v>
                </c:pt>
                <c:pt idx="1">
                  <c:v>155.72</c:v>
                </c:pt>
                <c:pt idx="2">
                  <c:v>231.71</c:v>
                </c:pt>
                <c:pt idx="3">
                  <c:v>286.2</c:v>
                </c:pt>
                <c:pt idx="4">
                  <c:v>332.22</c:v>
                </c:pt>
                <c:pt idx="5">
                  <c:v>373.08</c:v>
                </c:pt>
                <c:pt idx="6">
                  <c:v>404.4</c:v>
                </c:pt>
                <c:pt idx="7">
                  <c:v>433.02</c:v>
                </c:pt>
                <c:pt idx="8">
                  <c:v>457.02</c:v>
                </c:pt>
                <c:pt idx="9">
                  <c:v>479.42</c:v>
                </c:pt>
                <c:pt idx="10">
                  <c:v>501.18</c:v>
                </c:pt>
                <c:pt idx="11">
                  <c:v>519.43999999999994</c:v>
                </c:pt>
                <c:pt idx="12">
                  <c:v>534.42999999999984</c:v>
                </c:pt>
                <c:pt idx="13">
                  <c:v>551.16999999999996</c:v>
                </c:pt>
                <c:pt idx="14">
                  <c:v>563.21</c:v>
                </c:pt>
                <c:pt idx="15">
                  <c:v>576.80999999999983</c:v>
                </c:pt>
                <c:pt idx="16">
                  <c:v>588.8599999999999</c:v>
                </c:pt>
                <c:pt idx="17">
                  <c:v>600.05999999999983</c:v>
                </c:pt>
                <c:pt idx="18">
                  <c:v>608.79999999999995</c:v>
                </c:pt>
                <c:pt idx="19">
                  <c:v>617.049999999999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B-5FB9-474D-98FB-FB7E44384FD7}"/>
            </c:ext>
          </c:extLst>
        </c:ser>
        <c:ser>
          <c:idx val="29"/>
          <c:order val="28"/>
          <c:tx>
            <c:strRef>
              <c:f>Kid!$AD$4</c:f>
              <c:strCache>
                <c:ptCount val="1"/>
                <c:pt idx="0">
                  <c:v>15/02/2014</c:v>
                </c:pt>
              </c:strCache>
            </c:strRef>
          </c:tx>
          <c:spPr>
            <a:ln w="952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D$5:$AD$34</c:f>
              <c:numCache>
                <c:formatCode>General</c:formatCode>
                <c:ptCount val="30"/>
                <c:pt idx="0">
                  <c:v>1</c:v>
                </c:pt>
                <c:pt idx="1">
                  <c:v>180.22</c:v>
                </c:pt>
                <c:pt idx="2">
                  <c:v>260.39</c:v>
                </c:pt>
                <c:pt idx="3">
                  <c:v>320.48</c:v>
                </c:pt>
                <c:pt idx="4">
                  <c:v>370.5</c:v>
                </c:pt>
                <c:pt idx="5">
                  <c:v>410.34</c:v>
                </c:pt>
                <c:pt idx="6">
                  <c:v>446.02</c:v>
                </c:pt>
                <c:pt idx="7">
                  <c:v>476.48</c:v>
                </c:pt>
                <c:pt idx="8">
                  <c:v>506.8</c:v>
                </c:pt>
                <c:pt idx="9">
                  <c:v>530.4</c:v>
                </c:pt>
                <c:pt idx="10">
                  <c:v>554.1</c:v>
                </c:pt>
                <c:pt idx="11">
                  <c:v>574.33999999999992</c:v>
                </c:pt>
                <c:pt idx="12">
                  <c:v>594.42999999999984</c:v>
                </c:pt>
                <c:pt idx="13">
                  <c:v>613.41</c:v>
                </c:pt>
                <c:pt idx="14">
                  <c:v>628.25</c:v>
                </c:pt>
                <c:pt idx="15">
                  <c:v>645.31999999999994</c:v>
                </c:pt>
                <c:pt idx="16">
                  <c:v>657.88</c:v>
                </c:pt>
                <c:pt idx="17">
                  <c:v>674.03</c:v>
                </c:pt>
                <c:pt idx="18">
                  <c:v>683.11</c:v>
                </c:pt>
                <c:pt idx="19">
                  <c:v>697.65</c:v>
                </c:pt>
                <c:pt idx="20">
                  <c:v>705.04</c:v>
                </c:pt>
                <c:pt idx="21">
                  <c:v>715.48</c:v>
                </c:pt>
                <c:pt idx="22">
                  <c:v>725.74</c:v>
                </c:pt>
                <c:pt idx="23">
                  <c:v>732.78</c:v>
                </c:pt>
                <c:pt idx="24">
                  <c:v>742.31999999999994</c:v>
                </c:pt>
                <c:pt idx="25">
                  <c:v>751.78</c:v>
                </c:pt>
                <c:pt idx="26">
                  <c:v>757.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C-5FB9-474D-98FB-FB7E44384FD7}"/>
            </c:ext>
          </c:extLst>
        </c:ser>
        <c:ser>
          <c:idx val="30"/>
          <c:order val="29"/>
          <c:tx>
            <c:strRef>
              <c:f>Kid!$AE$4</c:f>
              <c:strCache>
                <c:ptCount val="1"/>
                <c:pt idx="0">
                  <c:v>22/02/2014</c:v>
                </c:pt>
              </c:strCache>
            </c:strRef>
          </c:tx>
          <c:spPr>
            <a:ln w="9525" cap="rnd">
              <a:solidFill>
                <a:schemeClr val="accent1">
                  <a:lumMod val="5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E$5:$AE$34</c:f>
              <c:numCache>
                <c:formatCode>General</c:formatCode>
                <c:ptCount val="30"/>
                <c:pt idx="0">
                  <c:v>1</c:v>
                </c:pt>
                <c:pt idx="1">
                  <c:v>157.41999999999999</c:v>
                </c:pt>
                <c:pt idx="2">
                  <c:v>228.91</c:v>
                </c:pt>
                <c:pt idx="3">
                  <c:v>283.25</c:v>
                </c:pt>
                <c:pt idx="4">
                  <c:v>325.57</c:v>
                </c:pt>
                <c:pt idx="5">
                  <c:v>358.04</c:v>
                </c:pt>
                <c:pt idx="6">
                  <c:v>389.09</c:v>
                </c:pt>
                <c:pt idx="7">
                  <c:v>417.59</c:v>
                </c:pt>
                <c:pt idx="8">
                  <c:v>439.03</c:v>
                </c:pt>
                <c:pt idx="9">
                  <c:v>458.35</c:v>
                </c:pt>
                <c:pt idx="10">
                  <c:v>476.42</c:v>
                </c:pt>
                <c:pt idx="11">
                  <c:v>489.9</c:v>
                </c:pt>
                <c:pt idx="12">
                  <c:v>505.48</c:v>
                </c:pt>
                <c:pt idx="13">
                  <c:v>516.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D-5FB9-474D-98FB-FB7E44384FD7}"/>
            </c:ext>
          </c:extLst>
        </c:ser>
        <c:ser>
          <c:idx val="31"/>
          <c:order val="30"/>
          <c:tx>
            <c:strRef>
              <c:f>Kid!$AF$4</c:f>
              <c:strCache>
                <c:ptCount val="1"/>
                <c:pt idx="0">
                  <c:v>22/02/2014</c:v>
                </c:pt>
              </c:strCache>
            </c:strRef>
          </c:tx>
          <c:spPr>
            <a:ln w="9525" cap="rnd">
              <a:solidFill>
                <a:schemeClr val="accent2">
                  <a:lumMod val="5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Kid!$A$5:$A$34</c:f>
              <c:numCache>
                <c:formatCode>General</c:formatCode>
                <c:ptCount val="30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  <c:pt idx="25">
                  <c:v>64103</c:v>
                </c:pt>
                <c:pt idx="26">
                  <c:v>66667</c:v>
                </c:pt>
                <c:pt idx="27">
                  <c:v>69231</c:v>
                </c:pt>
                <c:pt idx="28">
                  <c:v>71795</c:v>
                </c:pt>
                <c:pt idx="29">
                  <c:v>74359</c:v>
                </c:pt>
              </c:numCache>
            </c:numRef>
          </c:xVal>
          <c:yVal>
            <c:numRef>
              <c:f>Kid!$AF$5:$AF$34</c:f>
              <c:numCache>
                <c:formatCode>General</c:formatCode>
                <c:ptCount val="30"/>
                <c:pt idx="0">
                  <c:v>1</c:v>
                </c:pt>
                <c:pt idx="1">
                  <c:v>189.93</c:v>
                </c:pt>
                <c:pt idx="2">
                  <c:v>272.04000000000002</c:v>
                </c:pt>
                <c:pt idx="3">
                  <c:v>333.88</c:v>
                </c:pt>
                <c:pt idx="4">
                  <c:v>382.44</c:v>
                </c:pt>
                <c:pt idx="5">
                  <c:v>423.94</c:v>
                </c:pt>
                <c:pt idx="6">
                  <c:v>459.19</c:v>
                </c:pt>
                <c:pt idx="7">
                  <c:v>492.57</c:v>
                </c:pt>
                <c:pt idx="8">
                  <c:v>522.03</c:v>
                </c:pt>
                <c:pt idx="9">
                  <c:v>545.66999999999996</c:v>
                </c:pt>
                <c:pt idx="10">
                  <c:v>570.02</c:v>
                </c:pt>
                <c:pt idx="11">
                  <c:v>593.72</c:v>
                </c:pt>
                <c:pt idx="12">
                  <c:v>609.74</c:v>
                </c:pt>
                <c:pt idx="13">
                  <c:v>626.34999999999991</c:v>
                </c:pt>
                <c:pt idx="14">
                  <c:v>646.20000000000005</c:v>
                </c:pt>
                <c:pt idx="15">
                  <c:v>658.52</c:v>
                </c:pt>
                <c:pt idx="16">
                  <c:v>673.88</c:v>
                </c:pt>
                <c:pt idx="17">
                  <c:v>686.24</c:v>
                </c:pt>
                <c:pt idx="18">
                  <c:v>698.71</c:v>
                </c:pt>
                <c:pt idx="19">
                  <c:v>710.52</c:v>
                </c:pt>
                <c:pt idx="20">
                  <c:v>721.59</c:v>
                </c:pt>
                <c:pt idx="21">
                  <c:v>730.44999999999993</c:v>
                </c:pt>
                <c:pt idx="22">
                  <c:v>740.31</c:v>
                </c:pt>
                <c:pt idx="23">
                  <c:v>750.19</c:v>
                </c:pt>
                <c:pt idx="24">
                  <c:v>755.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E-5FB9-474D-98FB-FB7E44384F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2101032"/>
        <c:axId val="592107304"/>
      </c:scatterChart>
      <c:valAx>
        <c:axId val="592101032"/>
        <c:scaling>
          <c:orientation val="minMax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Number of read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592107304"/>
        <c:crosses val="autoZero"/>
        <c:crossBetween val="midCat"/>
      </c:valAx>
      <c:valAx>
        <c:axId val="592107304"/>
        <c:scaling>
          <c:orientation val="minMax"/>
          <c:max val="1500"/>
        </c:scaling>
        <c:delete val="0"/>
        <c:axPos val="l"/>
        <c:minorGridlines>
          <c:spPr>
            <a:ln>
              <a:solidFill>
                <a:sysClr val="window" lastClr="FFFFFF">
                  <a:lumMod val="65000"/>
                </a:sysClr>
              </a:solidFill>
              <a:prstDash val="sysDash"/>
            </a:ln>
          </c:spPr>
        </c:minorGridlines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b="0" dirty="0">
                    <a:effectLst/>
                  </a:rPr>
                  <a:t>Number of OTUs</a:t>
                </a:r>
                <a:endParaRPr lang="en-150" sz="1000" b="0" dirty="0">
                  <a:effectLst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592101032"/>
        <c:crosses val="autoZero"/>
        <c:crossBetween val="midCat"/>
        <c:majorUnit val="5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/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000"/>
            </a:pPr>
            <a:r>
              <a:rPr lang="en-US" sz="1000" dirty="0"/>
              <a:t>Bacteria</a:t>
            </a:r>
          </a:p>
        </c:rich>
      </c:tx>
      <c:layout>
        <c:manualLayout>
          <c:xMode val="edge"/>
          <c:yMode val="edge"/>
          <c:x val="0.39698198062865586"/>
          <c:y val="3.8789040224378171E-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164209619729716"/>
          <c:y val="8.6274677145927334E-2"/>
          <c:w val="0.77467477909965698"/>
          <c:h val="0.8077698213494758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18s Rarfaction'!$C$130</c:f>
              <c:strCache>
                <c:ptCount val="1"/>
                <c:pt idx="0">
                  <c:v>01/03/2013</c:v>
                </c:pt>
              </c:strCache>
            </c:strRef>
          </c:tx>
          <c:spPr>
            <a:ln w="9525" cap="rnd">
              <a:solidFill>
                <a:schemeClr val="accent1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0:$Q$130</c:f>
              <c:numCache>
                <c:formatCode>General</c:formatCode>
                <c:ptCount val="14"/>
                <c:pt idx="0">
                  <c:v>1</c:v>
                </c:pt>
                <c:pt idx="1">
                  <c:v>164.84</c:v>
                </c:pt>
                <c:pt idx="2">
                  <c:v>253.96</c:v>
                </c:pt>
                <c:pt idx="3">
                  <c:v>321.56</c:v>
                </c:pt>
                <c:pt idx="4">
                  <c:v>377.07</c:v>
                </c:pt>
                <c:pt idx="5">
                  <c:v>418.13</c:v>
                </c:pt>
                <c:pt idx="6">
                  <c:v>456.94</c:v>
                </c:pt>
                <c:pt idx="7">
                  <c:v>487.47</c:v>
                </c:pt>
                <c:pt idx="8">
                  <c:v>510.51</c:v>
                </c:pt>
                <c:pt idx="9">
                  <c:v>534.57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1B1-4CBD-AD51-9ECD14F03CEA}"/>
            </c:ext>
          </c:extLst>
        </c:ser>
        <c:ser>
          <c:idx val="1"/>
          <c:order val="1"/>
          <c:tx>
            <c:strRef>
              <c:f>'18s Rarfaction'!$C$131</c:f>
              <c:strCache>
                <c:ptCount val="1"/>
                <c:pt idx="0">
                  <c:v>01/03/2013</c:v>
                </c:pt>
              </c:strCache>
            </c:strRef>
          </c:tx>
          <c:spPr>
            <a:ln w="9525" cap="rnd">
              <a:solidFill>
                <a:schemeClr val="accent2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1:$Q$131</c:f>
              <c:numCache>
                <c:formatCode>General</c:formatCode>
                <c:ptCount val="14"/>
                <c:pt idx="0">
                  <c:v>1</c:v>
                </c:pt>
                <c:pt idx="1">
                  <c:v>175.14</c:v>
                </c:pt>
                <c:pt idx="2">
                  <c:v>272.38</c:v>
                </c:pt>
                <c:pt idx="3">
                  <c:v>350.09</c:v>
                </c:pt>
                <c:pt idx="4">
                  <c:v>408.15</c:v>
                </c:pt>
                <c:pt idx="5">
                  <c:v>455.66</c:v>
                </c:pt>
                <c:pt idx="6">
                  <c:v>500.25</c:v>
                </c:pt>
                <c:pt idx="7">
                  <c:v>535.26</c:v>
                </c:pt>
                <c:pt idx="8">
                  <c:v>563.08000000000004</c:v>
                </c:pt>
                <c:pt idx="9">
                  <c:v>589.17999999999995</c:v>
                </c:pt>
                <c:pt idx="10">
                  <c:v>611.59</c:v>
                </c:pt>
                <c:pt idx="11">
                  <c:v>631.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1B1-4CBD-AD51-9ECD14F03CEA}"/>
            </c:ext>
          </c:extLst>
        </c:ser>
        <c:ser>
          <c:idx val="2"/>
          <c:order val="2"/>
          <c:tx>
            <c:strRef>
              <c:f>'18s Rarfaction'!$C$132</c:f>
              <c:strCache>
                <c:ptCount val="1"/>
                <c:pt idx="0">
                  <c:v>01/05/2013</c:v>
                </c:pt>
              </c:strCache>
            </c:strRef>
          </c:tx>
          <c:spPr>
            <a:ln w="9525" cap="rnd">
              <a:solidFill>
                <a:schemeClr val="accent3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2:$Q$132</c:f>
              <c:numCache>
                <c:formatCode>General</c:formatCode>
                <c:ptCount val="14"/>
                <c:pt idx="0">
                  <c:v>1</c:v>
                </c:pt>
                <c:pt idx="1">
                  <c:v>231.34</c:v>
                </c:pt>
                <c:pt idx="2">
                  <c:v>342.95</c:v>
                </c:pt>
                <c:pt idx="3">
                  <c:v>428.66</c:v>
                </c:pt>
                <c:pt idx="4">
                  <c:v>488.73</c:v>
                </c:pt>
                <c:pt idx="5">
                  <c:v>542.04</c:v>
                </c:pt>
                <c:pt idx="6">
                  <c:v>580.16</c:v>
                </c:pt>
                <c:pt idx="7">
                  <c:v>620.11</c:v>
                </c:pt>
                <c:pt idx="8">
                  <c:v>646.85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1B1-4CBD-AD51-9ECD14F03CEA}"/>
            </c:ext>
          </c:extLst>
        </c:ser>
        <c:ser>
          <c:idx val="3"/>
          <c:order val="3"/>
          <c:tx>
            <c:strRef>
              <c:f>'18s Rarfaction'!$C$133</c:f>
              <c:strCache>
                <c:ptCount val="1"/>
                <c:pt idx="0">
                  <c:v>01/05/2013</c:v>
                </c:pt>
              </c:strCache>
            </c:strRef>
          </c:tx>
          <c:spPr>
            <a:ln w="9525" cap="rnd">
              <a:solidFill>
                <a:schemeClr val="accent4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3:$Q$133</c:f>
              <c:numCache>
                <c:formatCode>General</c:formatCode>
                <c:ptCount val="14"/>
                <c:pt idx="0">
                  <c:v>1</c:v>
                </c:pt>
                <c:pt idx="1">
                  <c:v>206.19</c:v>
                </c:pt>
                <c:pt idx="2">
                  <c:v>303.85000000000002</c:v>
                </c:pt>
                <c:pt idx="3">
                  <c:v>374.68</c:v>
                </c:pt>
                <c:pt idx="4">
                  <c:v>431.85</c:v>
                </c:pt>
                <c:pt idx="5">
                  <c:v>474.92</c:v>
                </c:pt>
                <c:pt idx="6">
                  <c:v>514.53</c:v>
                </c:pt>
                <c:pt idx="7">
                  <c:v>541.93999999999994</c:v>
                </c:pt>
                <c:pt idx="8">
                  <c:v>567.41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1B1-4CBD-AD51-9ECD14F03CEA}"/>
            </c:ext>
          </c:extLst>
        </c:ser>
        <c:ser>
          <c:idx val="4"/>
          <c:order val="4"/>
          <c:tx>
            <c:strRef>
              <c:f>'18s Rarfaction'!$C$134</c:f>
              <c:strCache>
                <c:ptCount val="1"/>
                <c:pt idx="0">
                  <c:v>01/06/2013</c:v>
                </c:pt>
              </c:strCache>
            </c:strRef>
          </c:tx>
          <c:spPr>
            <a:ln w="9525" cap="rnd">
              <a:solidFill>
                <a:schemeClr val="accent5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4:$Q$134</c:f>
              <c:numCache>
                <c:formatCode>General</c:formatCode>
                <c:ptCount val="14"/>
                <c:pt idx="0">
                  <c:v>1</c:v>
                </c:pt>
                <c:pt idx="1">
                  <c:v>171.79</c:v>
                </c:pt>
                <c:pt idx="2">
                  <c:v>265.14</c:v>
                </c:pt>
                <c:pt idx="3">
                  <c:v>332.23</c:v>
                </c:pt>
                <c:pt idx="4">
                  <c:v>391.8</c:v>
                </c:pt>
                <c:pt idx="5">
                  <c:v>435.02</c:v>
                </c:pt>
                <c:pt idx="6">
                  <c:v>473.35</c:v>
                </c:pt>
                <c:pt idx="7">
                  <c:v>502.74</c:v>
                </c:pt>
                <c:pt idx="8">
                  <c:v>531.38</c:v>
                </c:pt>
                <c:pt idx="9">
                  <c:v>555.2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1B1-4CBD-AD51-9ECD14F03CEA}"/>
            </c:ext>
          </c:extLst>
        </c:ser>
        <c:ser>
          <c:idx val="5"/>
          <c:order val="5"/>
          <c:tx>
            <c:strRef>
              <c:f>'18s Rarfaction'!$C$135</c:f>
              <c:strCache>
                <c:ptCount val="1"/>
                <c:pt idx="0">
                  <c:v>01/06/2013</c:v>
                </c:pt>
              </c:strCache>
            </c:strRef>
          </c:tx>
          <c:spPr>
            <a:ln w="9525" cap="rnd">
              <a:solidFill>
                <a:schemeClr val="accent6"/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5:$Q$135</c:f>
              <c:numCache>
                <c:formatCode>General</c:formatCode>
                <c:ptCount val="14"/>
                <c:pt idx="0">
                  <c:v>1</c:v>
                </c:pt>
                <c:pt idx="1">
                  <c:v>209.99</c:v>
                </c:pt>
                <c:pt idx="2">
                  <c:v>321.64</c:v>
                </c:pt>
                <c:pt idx="3">
                  <c:v>405.69</c:v>
                </c:pt>
                <c:pt idx="4">
                  <c:v>471.06</c:v>
                </c:pt>
                <c:pt idx="5">
                  <c:v>524.31999999999994</c:v>
                </c:pt>
                <c:pt idx="6">
                  <c:v>570.07000000000005</c:v>
                </c:pt>
                <c:pt idx="7">
                  <c:v>605.92999999999984</c:v>
                </c:pt>
                <c:pt idx="8">
                  <c:v>637.92999999999984</c:v>
                </c:pt>
                <c:pt idx="9">
                  <c:v>663.99</c:v>
                </c:pt>
                <c:pt idx="10">
                  <c:v>688.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91B1-4CBD-AD51-9ECD14F03CEA}"/>
            </c:ext>
          </c:extLst>
        </c:ser>
        <c:ser>
          <c:idx val="6"/>
          <c:order val="6"/>
          <c:tx>
            <c:strRef>
              <c:f>'18s Rarfaction'!$C$136</c:f>
              <c:strCache>
                <c:ptCount val="1"/>
                <c:pt idx="0">
                  <c:v>01/07/2013</c:v>
                </c:pt>
              </c:strCache>
            </c:strRef>
          </c:tx>
          <c:spPr>
            <a:ln w="9525" cap="rnd">
              <a:solidFill>
                <a:schemeClr val="accent1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6:$Q$136</c:f>
              <c:numCache>
                <c:formatCode>General</c:formatCode>
                <c:ptCount val="14"/>
                <c:pt idx="0">
                  <c:v>1</c:v>
                </c:pt>
                <c:pt idx="1">
                  <c:v>212.12</c:v>
                </c:pt>
                <c:pt idx="2">
                  <c:v>315.94</c:v>
                </c:pt>
                <c:pt idx="3">
                  <c:v>391.69</c:v>
                </c:pt>
                <c:pt idx="4">
                  <c:v>451.38</c:v>
                </c:pt>
                <c:pt idx="5">
                  <c:v>497.27</c:v>
                </c:pt>
                <c:pt idx="6">
                  <c:v>534.70000000000005</c:v>
                </c:pt>
                <c:pt idx="7">
                  <c:v>564.52</c:v>
                </c:pt>
                <c:pt idx="8">
                  <c:v>592.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91B1-4CBD-AD51-9ECD14F03CEA}"/>
            </c:ext>
          </c:extLst>
        </c:ser>
        <c:ser>
          <c:idx val="7"/>
          <c:order val="7"/>
          <c:tx>
            <c:strRef>
              <c:f>'18s Rarfaction'!$C$137</c:f>
              <c:strCache>
                <c:ptCount val="1"/>
                <c:pt idx="0">
                  <c:v>01/07/2013</c:v>
                </c:pt>
              </c:strCache>
            </c:strRef>
          </c:tx>
          <c:spPr>
            <a:ln w="9525" cap="rnd">
              <a:solidFill>
                <a:schemeClr val="accent2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7:$Q$137</c:f>
              <c:numCache>
                <c:formatCode>General</c:formatCode>
                <c:ptCount val="14"/>
                <c:pt idx="0">
                  <c:v>1</c:v>
                </c:pt>
                <c:pt idx="1">
                  <c:v>231.58</c:v>
                </c:pt>
                <c:pt idx="2">
                  <c:v>339.99</c:v>
                </c:pt>
                <c:pt idx="3">
                  <c:v>419.17</c:v>
                </c:pt>
                <c:pt idx="4">
                  <c:v>485.97</c:v>
                </c:pt>
                <c:pt idx="5">
                  <c:v>537.79</c:v>
                </c:pt>
                <c:pt idx="6">
                  <c:v>580.69000000000005</c:v>
                </c:pt>
                <c:pt idx="7">
                  <c:v>616.47</c:v>
                </c:pt>
                <c:pt idx="8">
                  <c:v>646.24</c:v>
                </c:pt>
                <c:pt idx="9">
                  <c:v>672.55</c:v>
                </c:pt>
                <c:pt idx="10">
                  <c:v>698.5</c:v>
                </c:pt>
                <c:pt idx="11">
                  <c:v>717.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91B1-4CBD-AD51-9ECD14F03CEA}"/>
            </c:ext>
          </c:extLst>
        </c:ser>
        <c:ser>
          <c:idx val="8"/>
          <c:order val="8"/>
          <c:tx>
            <c:strRef>
              <c:f>'18s Rarfaction'!$C$138</c:f>
              <c:strCache>
                <c:ptCount val="1"/>
                <c:pt idx="0">
                  <c:v>01/08/2013</c:v>
                </c:pt>
              </c:strCache>
            </c:strRef>
          </c:tx>
          <c:spPr>
            <a:ln w="9525" cap="rnd">
              <a:solidFill>
                <a:schemeClr val="accent3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8:$Q$138</c:f>
              <c:numCache>
                <c:formatCode>General</c:formatCode>
                <c:ptCount val="14"/>
                <c:pt idx="0">
                  <c:v>1</c:v>
                </c:pt>
                <c:pt idx="1">
                  <c:v>193.87</c:v>
                </c:pt>
                <c:pt idx="2">
                  <c:v>291.95</c:v>
                </c:pt>
                <c:pt idx="3">
                  <c:v>362.38</c:v>
                </c:pt>
                <c:pt idx="4">
                  <c:v>416.18</c:v>
                </c:pt>
                <c:pt idx="5">
                  <c:v>457.87</c:v>
                </c:pt>
                <c:pt idx="6">
                  <c:v>491.95</c:v>
                </c:pt>
                <c:pt idx="7">
                  <c:v>518.959999999999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91B1-4CBD-AD51-9ECD14F03CEA}"/>
            </c:ext>
          </c:extLst>
        </c:ser>
        <c:ser>
          <c:idx val="9"/>
          <c:order val="9"/>
          <c:tx>
            <c:strRef>
              <c:f>'18s Rarfaction'!$C$139</c:f>
              <c:strCache>
                <c:ptCount val="1"/>
                <c:pt idx="0">
                  <c:v>01/08/2013</c:v>
                </c:pt>
              </c:strCache>
            </c:strRef>
          </c:tx>
          <c:spPr>
            <a:ln w="9525" cap="rnd">
              <a:solidFill>
                <a:schemeClr val="accent4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39:$Q$139</c:f>
              <c:numCache>
                <c:formatCode>General</c:formatCode>
                <c:ptCount val="14"/>
                <c:pt idx="0">
                  <c:v>1</c:v>
                </c:pt>
                <c:pt idx="1">
                  <c:v>200</c:v>
                </c:pt>
                <c:pt idx="2">
                  <c:v>301.18</c:v>
                </c:pt>
                <c:pt idx="3">
                  <c:v>381.08</c:v>
                </c:pt>
                <c:pt idx="4">
                  <c:v>444.52</c:v>
                </c:pt>
                <c:pt idx="5">
                  <c:v>497.05</c:v>
                </c:pt>
                <c:pt idx="6">
                  <c:v>540.87</c:v>
                </c:pt>
                <c:pt idx="7">
                  <c:v>578.79</c:v>
                </c:pt>
                <c:pt idx="8">
                  <c:v>611.91</c:v>
                </c:pt>
                <c:pt idx="9">
                  <c:v>639.63</c:v>
                </c:pt>
                <c:pt idx="10">
                  <c:v>664.21</c:v>
                </c:pt>
                <c:pt idx="11">
                  <c:v>685.81</c:v>
                </c:pt>
                <c:pt idx="12">
                  <c:v>708.14</c:v>
                </c:pt>
                <c:pt idx="13">
                  <c:v>724.8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91B1-4CBD-AD51-9ECD14F03CEA}"/>
            </c:ext>
          </c:extLst>
        </c:ser>
        <c:ser>
          <c:idx val="10"/>
          <c:order val="10"/>
          <c:tx>
            <c:strRef>
              <c:f>'18s Rarfaction'!$C$140</c:f>
              <c:strCache>
                <c:ptCount val="1"/>
                <c:pt idx="0">
                  <c:v>08/08/2013</c:v>
                </c:pt>
              </c:strCache>
            </c:strRef>
          </c:tx>
          <c:spPr>
            <a:ln w="9525" cap="rnd">
              <a:solidFill>
                <a:schemeClr val="accent5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0:$Q$140</c:f>
              <c:numCache>
                <c:formatCode>General</c:formatCode>
                <c:ptCount val="14"/>
                <c:pt idx="0">
                  <c:v>1</c:v>
                </c:pt>
                <c:pt idx="1">
                  <c:v>193.39</c:v>
                </c:pt>
                <c:pt idx="2">
                  <c:v>287.5</c:v>
                </c:pt>
                <c:pt idx="3">
                  <c:v>358.47</c:v>
                </c:pt>
                <c:pt idx="4">
                  <c:v>410.64</c:v>
                </c:pt>
                <c:pt idx="5">
                  <c:v>451.67</c:v>
                </c:pt>
                <c:pt idx="6">
                  <c:v>485.05</c:v>
                </c:pt>
                <c:pt idx="7">
                  <c:v>512.43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91B1-4CBD-AD51-9ECD14F03CEA}"/>
            </c:ext>
          </c:extLst>
        </c:ser>
        <c:ser>
          <c:idx val="11"/>
          <c:order val="11"/>
          <c:tx>
            <c:strRef>
              <c:f>'18s Rarfaction'!$C$141</c:f>
              <c:strCache>
                <c:ptCount val="1"/>
                <c:pt idx="0">
                  <c:v>08/08/2013</c:v>
                </c:pt>
              </c:strCache>
            </c:strRef>
          </c:tx>
          <c:spPr>
            <a:ln w="9525" cap="rnd">
              <a:solidFill>
                <a:schemeClr val="accent6">
                  <a:lumMod val="6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1:$Q$141</c:f>
              <c:numCache>
                <c:formatCode>General</c:formatCode>
                <c:ptCount val="14"/>
                <c:pt idx="0">
                  <c:v>1</c:v>
                </c:pt>
                <c:pt idx="1">
                  <c:v>184.34</c:v>
                </c:pt>
                <c:pt idx="2">
                  <c:v>281.85000000000002</c:v>
                </c:pt>
                <c:pt idx="3">
                  <c:v>357.89</c:v>
                </c:pt>
                <c:pt idx="4">
                  <c:v>414.83</c:v>
                </c:pt>
                <c:pt idx="5">
                  <c:v>461.95</c:v>
                </c:pt>
                <c:pt idx="6">
                  <c:v>501.55</c:v>
                </c:pt>
                <c:pt idx="7">
                  <c:v>533.21</c:v>
                </c:pt>
                <c:pt idx="8">
                  <c:v>562.26</c:v>
                </c:pt>
                <c:pt idx="9">
                  <c:v>584.809999999999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91B1-4CBD-AD51-9ECD14F03CEA}"/>
            </c:ext>
          </c:extLst>
        </c:ser>
        <c:ser>
          <c:idx val="12"/>
          <c:order val="12"/>
          <c:tx>
            <c:strRef>
              <c:f>'18s Rarfaction'!$C$142</c:f>
              <c:strCache>
                <c:ptCount val="1"/>
                <c:pt idx="0">
                  <c:v>15/08/2013</c:v>
                </c:pt>
              </c:strCache>
            </c:strRef>
          </c:tx>
          <c:spPr>
            <a:ln w="952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2:$Q$142</c:f>
              <c:numCache>
                <c:formatCode>General</c:formatCode>
                <c:ptCount val="14"/>
                <c:pt idx="0">
                  <c:v>1</c:v>
                </c:pt>
                <c:pt idx="1">
                  <c:v>196.87</c:v>
                </c:pt>
                <c:pt idx="2">
                  <c:v>299.39999999999992</c:v>
                </c:pt>
                <c:pt idx="3">
                  <c:v>377.15</c:v>
                </c:pt>
                <c:pt idx="4">
                  <c:v>432.58</c:v>
                </c:pt>
                <c:pt idx="5">
                  <c:v>481.54</c:v>
                </c:pt>
                <c:pt idx="6">
                  <c:v>522.29</c:v>
                </c:pt>
                <c:pt idx="7">
                  <c:v>553.92999999999984</c:v>
                </c:pt>
                <c:pt idx="8">
                  <c:v>580.5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91B1-4CBD-AD51-9ECD14F03CEA}"/>
            </c:ext>
          </c:extLst>
        </c:ser>
        <c:ser>
          <c:idx val="13"/>
          <c:order val="13"/>
          <c:tx>
            <c:strRef>
              <c:f>'18s Rarfaction'!$C$143</c:f>
              <c:strCache>
                <c:ptCount val="1"/>
                <c:pt idx="0">
                  <c:v>15/08/2013</c:v>
                </c:pt>
              </c:strCache>
            </c:strRef>
          </c:tx>
          <c:spPr>
            <a:ln w="952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3:$Q$143</c:f>
              <c:numCache>
                <c:formatCode>General</c:formatCode>
                <c:ptCount val="14"/>
                <c:pt idx="0">
                  <c:v>1</c:v>
                </c:pt>
                <c:pt idx="1">
                  <c:v>208.28</c:v>
                </c:pt>
                <c:pt idx="2">
                  <c:v>321.39</c:v>
                </c:pt>
                <c:pt idx="3">
                  <c:v>405.73</c:v>
                </c:pt>
                <c:pt idx="4">
                  <c:v>473.58</c:v>
                </c:pt>
                <c:pt idx="5">
                  <c:v>528.29999999999995</c:v>
                </c:pt>
                <c:pt idx="6">
                  <c:v>578.45999999999992</c:v>
                </c:pt>
                <c:pt idx="7">
                  <c:v>617.83999999999992</c:v>
                </c:pt>
                <c:pt idx="8">
                  <c:v>651.71</c:v>
                </c:pt>
                <c:pt idx="9">
                  <c:v>680.74</c:v>
                </c:pt>
                <c:pt idx="10">
                  <c:v>708.06</c:v>
                </c:pt>
                <c:pt idx="11">
                  <c:v>732.66</c:v>
                </c:pt>
                <c:pt idx="12">
                  <c:v>751.6</c:v>
                </c:pt>
                <c:pt idx="13">
                  <c:v>768.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91B1-4CBD-AD51-9ECD14F03CEA}"/>
            </c:ext>
          </c:extLst>
        </c:ser>
        <c:ser>
          <c:idx val="14"/>
          <c:order val="14"/>
          <c:tx>
            <c:strRef>
              <c:f>'18s Rarfaction'!$C$144</c:f>
              <c:strCache>
                <c:ptCount val="1"/>
                <c:pt idx="0">
                  <c:v>01/09/2013</c:v>
                </c:pt>
              </c:strCache>
            </c:strRef>
          </c:tx>
          <c:spPr>
            <a:ln w="952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4:$Q$144</c:f>
              <c:numCache>
                <c:formatCode>General</c:formatCode>
                <c:ptCount val="14"/>
                <c:pt idx="0">
                  <c:v>1</c:v>
                </c:pt>
                <c:pt idx="1">
                  <c:v>191.09</c:v>
                </c:pt>
                <c:pt idx="2">
                  <c:v>283.63</c:v>
                </c:pt>
                <c:pt idx="3">
                  <c:v>355.92999999999989</c:v>
                </c:pt>
                <c:pt idx="4">
                  <c:v>405.79</c:v>
                </c:pt>
                <c:pt idx="5">
                  <c:v>451.83</c:v>
                </c:pt>
                <c:pt idx="6">
                  <c:v>488.78</c:v>
                </c:pt>
                <c:pt idx="7">
                  <c:v>519.29</c:v>
                </c:pt>
                <c:pt idx="8">
                  <c:v>543.26</c:v>
                </c:pt>
                <c:pt idx="9">
                  <c:v>567.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91B1-4CBD-AD51-9ECD14F03CEA}"/>
            </c:ext>
          </c:extLst>
        </c:ser>
        <c:ser>
          <c:idx val="15"/>
          <c:order val="15"/>
          <c:tx>
            <c:strRef>
              <c:f>'18s Rarfaction'!$C$145</c:f>
              <c:strCache>
                <c:ptCount val="1"/>
                <c:pt idx="0">
                  <c:v>01/09/2013</c:v>
                </c:pt>
              </c:strCache>
            </c:strRef>
          </c:tx>
          <c:spPr>
            <a:ln w="952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5:$Q$145</c:f>
              <c:numCache>
                <c:formatCode>General</c:formatCode>
                <c:ptCount val="14"/>
                <c:pt idx="0">
                  <c:v>1</c:v>
                </c:pt>
                <c:pt idx="1">
                  <c:v>191.59</c:v>
                </c:pt>
                <c:pt idx="2">
                  <c:v>285.64999999999998</c:v>
                </c:pt>
                <c:pt idx="3">
                  <c:v>355.36</c:v>
                </c:pt>
                <c:pt idx="4">
                  <c:v>412.72</c:v>
                </c:pt>
                <c:pt idx="5">
                  <c:v>458.49</c:v>
                </c:pt>
                <c:pt idx="6">
                  <c:v>498.26</c:v>
                </c:pt>
                <c:pt idx="7">
                  <c:v>531.58000000000004</c:v>
                </c:pt>
                <c:pt idx="8">
                  <c:v>558.88</c:v>
                </c:pt>
                <c:pt idx="9">
                  <c:v>581.94999999999993</c:v>
                </c:pt>
                <c:pt idx="10">
                  <c:v>604.22</c:v>
                </c:pt>
                <c:pt idx="11">
                  <c:v>622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91B1-4CBD-AD51-9ECD14F03CEA}"/>
            </c:ext>
          </c:extLst>
        </c:ser>
        <c:ser>
          <c:idx val="16"/>
          <c:order val="16"/>
          <c:tx>
            <c:strRef>
              <c:f>'18s Rarfaction'!$C$146</c:f>
              <c:strCache>
                <c:ptCount val="1"/>
                <c:pt idx="0">
                  <c:v>01/10/2013</c:v>
                </c:pt>
              </c:strCache>
            </c:strRef>
          </c:tx>
          <c:spPr>
            <a:ln w="952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6:$Q$146</c:f>
              <c:numCache>
                <c:formatCode>General</c:formatCode>
                <c:ptCount val="14"/>
                <c:pt idx="0">
                  <c:v>1</c:v>
                </c:pt>
                <c:pt idx="1">
                  <c:v>222.8</c:v>
                </c:pt>
                <c:pt idx="2">
                  <c:v>328.84</c:v>
                </c:pt>
                <c:pt idx="3">
                  <c:v>411.75</c:v>
                </c:pt>
                <c:pt idx="4">
                  <c:v>471.94</c:v>
                </c:pt>
                <c:pt idx="5">
                  <c:v>522.87</c:v>
                </c:pt>
                <c:pt idx="6">
                  <c:v>562.61</c:v>
                </c:pt>
                <c:pt idx="7">
                  <c:v>599.29</c:v>
                </c:pt>
                <c:pt idx="8">
                  <c:v>627.02</c:v>
                </c:pt>
                <c:pt idx="9">
                  <c:v>654.57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91B1-4CBD-AD51-9ECD14F03CEA}"/>
            </c:ext>
          </c:extLst>
        </c:ser>
        <c:ser>
          <c:idx val="17"/>
          <c:order val="17"/>
          <c:tx>
            <c:strRef>
              <c:f>'18s Rarfaction'!$C$147</c:f>
              <c:strCache>
                <c:ptCount val="1"/>
                <c:pt idx="0">
                  <c:v>01/10/2013</c:v>
                </c:pt>
              </c:strCache>
            </c:strRef>
          </c:tx>
          <c:spPr>
            <a:ln w="952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7:$Q$147</c:f>
              <c:numCache>
                <c:formatCode>General</c:formatCode>
                <c:ptCount val="14"/>
                <c:pt idx="0">
                  <c:v>1</c:v>
                </c:pt>
                <c:pt idx="1">
                  <c:v>256.88</c:v>
                </c:pt>
                <c:pt idx="2">
                  <c:v>376.71</c:v>
                </c:pt>
                <c:pt idx="3">
                  <c:v>464.01</c:v>
                </c:pt>
                <c:pt idx="4">
                  <c:v>534.22</c:v>
                </c:pt>
                <c:pt idx="5">
                  <c:v>588.54</c:v>
                </c:pt>
                <c:pt idx="6">
                  <c:v>634.23</c:v>
                </c:pt>
                <c:pt idx="7">
                  <c:v>675.29</c:v>
                </c:pt>
                <c:pt idx="8">
                  <c:v>709.67</c:v>
                </c:pt>
                <c:pt idx="9">
                  <c:v>738.8</c:v>
                </c:pt>
                <c:pt idx="10">
                  <c:v>763.92</c:v>
                </c:pt>
                <c:pt idx="11">
                  <c:v>783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91B1-4CBD-AD51-9ECD14F03CEA}"/>
            </c:ext>
          </c:extLst>
        </c:ser>
        <c:ser>
          <c:idx val="18"/>
          <c:order val="18"/>
          <c:tx>
            <c:strRef>
              <c:f>'18s Rarfaction'!$C$148</c:f>
              <c:strCache>
                <c:ptCount val="1"/>
                <c:pt idx="0">
                  <c:v>01/11/2013</c:v>
                </c:pt>
              </c:strCache>
            </c:strRef>
          </c:tx>
          <c:spPr>
            <a:ln w="9525" cap="rnd">
              <a:solidFill>
                <a:schemeClr val="accent1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8:$Q$148</c:f>
              <c:numCache>
                <c:formatCode>General</c:formatCode>
                <c:ptCount val="14"/>
                <c:pt idx="0">
                  <c:v>1</c:v>
                </c:pt>
                <c:pt idx="1">
                  <c:v>204.65</c:v>
                </c:pt>
                <c:pt idx="2">
                  <c:v>304.91000000000003</c:v>
                </c:pt>
                <c:pt idx="3">
                  <c:v>380.76</c:v>
                </c:pt>
                <c:pt idx="4">
                  <c:v>441.2</c:v>
                </c:pt>
                <c:pt idx="5">
                  <c:v>491.83</c:v>
                </c:pt>
                <c:pt idx="6">
                  <c:v>530.32999999999993</c:v>
                </c:pt>
                <c:pt idx="7">
                  <c:v>565.25</c:v>
                </c:pt>
                <c:pt idx="8">
                  <c:v>594.38</c:v>
                </c:pt>
                <c:pt idx="9">
                  <c:v>618.9</c:v>
                </c:pt>
                <c:pt idx="10">
                  <c:v>641.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2-91B1-4CBD-AD51-9ECD14F03CEA}"/>
            </c:ext>
          </c:extLst>
        </c:ser>
        <c:ser>
          <c:idx val="19"/>
          <c:order val="19"/>
          <c:tx>
            <c:strRef>
              <c:f>'18s Rarfaction'!$C$149</c:f>
              <c:strCache>
                <c:ptCount val="1"/>
                <c:pt idx="0">
                  <c:v>01/11/2013</c:v>
                </c:pt>
              </c:strCache>
            </c:strRef>
          </c:tx>
          <c:spPr>
            <a:ln w="9525" cap="rnd">
              <a:solidFill>
                <a:schemeClr val="accent2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49:$Q$149</c:f>
              <c:numCache>
                <c:formatCode>General</c:formatCode>
                <c:ptCount val="14"/>
                <c:pt idx="0">
                  <c:v>1</c:v>
                </c:pt>
                <c:pt idx="1">
                  <c:v>234.74</c:v>
                </c:pt>
                <c:pt idx="2">
                  <c:v>349.53</c:v>
                </c:pt>
                <c:pt idx="3">
                  <c:v>433.77</c:v>
                </c:pt>
                <c:pt idx="4">
                  <c:v>502.3</c:v>
                </c:pt>
                <c:pt idx="5">
                  <c:v>557.1</c:v>
                </c:pt>
                <c:pt idx="6">
                  <c:v>598.65</c:v>
                </c:pt>
                <c:pt idx="7">
                  <c:v>636.69000000000005</c:v>
                </c:pt>
                <c:pt idx="8">
                  <c:v>670.43</c:v>
                </c:pt>
                <c:pt idx="9">
                  <c:v>695.71</c:v>
                </c:pt>
                <c:pt idx="10">
                  <c:v>717.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3-91B1-4CBD-AD51-9ECD14F03CEA}"/>
            </c:ext>
          </c:extLst>
        </c:ser>
        <c:ser>
          <c:idx val="20"/>
          <c:order val="20"/>
          <c:tx>
            <c:strRef>
              <c:f>'18s Rarfaction'!$C$150</c:f>
              <c:strCache>
                <c:ptCount val="1"/>
                <c:pt idx="0">
                  <c:v>01/12/2013</c:v>
                </c:pt>
              </c:strCache>
            </c:strRef>
          </c:tx>
          <c:spPr>
            <a:ln w="9525" cap="rnd">
              <a:solidFill>
                <a:schemeClr val="accent3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0:$Q$150</c:f>
              <c:numCache>
                <c:formatCode>General</c:formatCode>
                <c:ptCount val="14"/>
                <c:pt idx="0">
                  <c:v>1</c:v>
                </c:pt>
                <c:pt idx="1">
                  <c:v>196.99</c:v>
                </c:pt>
                <c:pt idx="2">
                  <c:v>299.37</c:v>
                </c:pt>
                <c:pt idx="3">
                  <c:v>374.71</c:v>
                </c:pt>
                <c:pt idx="4">
                  <c:v>433.13</c:v>
                </c:pt>
                <c:pt idx="5">
                  <c:v>481.17</c:v>
                </c:pt>
                <c:pt idx="6">
                  <c:v>520.16</c:v>
                </c:pt>
                <c:pt idx="7">
                  <c:v>552.43999999999994</c:v>
                </c:pt>
                <c:pt idx="8">
                  <c:v>576.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4-91B1-4CBD-AD51-9ECD14F03CEA}"/>
            </c:ext>
          </c:extLst>
        </c:ser>
        <c:ser>
          <c:idx val="21"/>
          <c:order val="21"/>
          <c:tx>
            <c:strRef>
              <c:f>'18s Rarfaction'!$C$151</c:f>
              <c:strCache>
                <c:ptCount val="1"/>
                <c:pt idx="0">
                  <c:v>01/12/2013</c:v>
                </c:pt>
              </c:strCache>
            </c:strRef>
          </c:tx>
          <c:spPr>
            <a:ln w="9525" cap="rnd">
              <a:solidFill>
                <a:schemeClr val="accent4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1:$Q$151</c:f>
              <c:numCache>
                <c:formatCode>General</c:formatCode>
                <c:ptCount val="14"/>
                <c:pt idx="0">
                  <c:v>1</c:v>
                </c:pt>
                <c:pt idx="1">
                  <c:v>200.79</c:v>
                </c:pt>
                <c:pt idx="2">
                  <c:v>306.74</c:v>
                </c:pt>
                <c:pt idx="3">
                  <c:v>388.14</c:v>
                </c:pt>
                <c:pt idx="4">
                  <c:v>449.49</c:v>
                </c:pt>
                <c:pt idx="5">
                  <c:v>502.47</c:v>
                </c:pt>
                <c:pt idx="6">
                  <c:v>545.23</c:v>
                </c:pt>
                <c:pt idx="7">
                  <c:v>582.02</c:v>
                </c:pt>
                <c:pt idx="8">
                  <c:v>611.72</c:v>
                </c:pt>
                <c:pt idx="9">
                  <c:v>640.04</c:v>
                </c:pt>
                <c:pt idx="10">
                  <c:v>663.41</c:v>
                </c:pt>
                <c:pt idx="11">
                  <c:v>684.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5-91B1-4CBD-AD51-9ECD14F03CEA}"/>
            </c:ext>
          </c:extLst>
        </c:ser>
        <c:ser>
          <c:idx val="22"/>
          <c:order val="22"/>
          <c:tx>
            <c:strRef>
              <c:f>'18s Rarfaction'!$C$152</c:f>
              <c:strCache>
                <c:ptCount val="1"/>
                <c:pt idx="0">
                  <c:v>01/01/2014</c:v>
                </c:pt>
              </c:strCache>
            </c:strRef>
          </c:tx>
          <c:spPr>
            <a:ln w="9525" cap="rnd">
              <a:solidFill>
                <a:schemeClr val="accent5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2:$Q$152</c:f>
              <c:numCache>
                <c:formatCode>General</c:formatCode>
                <c:ptCount val="14"/>
                <c:pt idx="0">
                  <c:v>1</c:v>
                </c:pt>
                <c:pt idx="1">
                  <c:v>184.67</c:v>
                </c:pt>
                <c:pt idx="2">
                  <c:v>278.58</c:v>
                </c:pt>
                <c:pt idx="3">
                  <c:v>352.61</c:v>
                </c:pt>
                <c:pt idx="4">
                  <c:v>409.47</c:v>
                </c:pt>
                <c:pt idx="5">
                  <c:v>457.18</c:v>
                </c:pt>
                <c:pt idx="6">
                  <c:v>492.84</c:v>
                </c:pt>
                <c:pt idx="7">
                  <c:v>524.63</c:v>
                </c:pt>
                <c:pt idx="8">
                  <c:v>551.2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6-91B1-4CBD-AD51-9ECD14F03CEA}"/>
            </c:ext>
          </c:extLst>
        </c:ser>
        <c:ser>
          <c:idx val="23"/>
          <c:order val="23"/>
          <c:tx>
            <c:strRef>
              <c:f>'18s Rarfaction'!$C$153</c:f>
              <c:strCache>
                <c:ptCount val="1"/>
                <c:pt idx="0">
                  <c:v>01/01/2014</c:v>
                </c:pt>
              </c:strCache>
            </c:strRef>
          </c:tx>
          <c:spPr>
            <a:ln w="9525" cap="rnd">
              <a:solidFill>
                <a:schemeClr val="accent6">
                  <a:lumMod val="8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3:$Q$153</c:f>
              <c:numCache>
                <c:formatCode>General</c:formatCode>
                <c:ptCount val="14"/>
                <c:pt idx="0">
                  <c:v>1</c:v>
                </c:pt>
                <c:pt idx="1">
                  <c:v>180.93</c:v>
                </c:pt>
                <c:pt idx="2">
                  <c:v>278.51</c:v>
                </c:pt>
                <c:pt idx="3">
                  <c:v>353.69</c:v>
                </c:pt>
                <c:pt idx="4">
                  <c:v>410.35</c:v>
                </c:pt>
                <c:pt idx="5">
                  <c:v>460.42999999999989</c:v>
                </c:pt>
                <c:pt idx="6">
                  <c:v>500.44</c:v>
                </c:pt>
                <c:pt idx="7">
                  <c:v>536.15</c:v>
                </c:pt>
                <c:pt idx="8">
                  <c:v>566.23</c:v>
                </c:pt>
                <c:pt idx="9">
                  <c:v>589.70000000000005</c:v>
                </c:pt>
                <c:pt idx="10">
                  <c:v>613.05999999999983</c:v>
                </c:pt>
                <c:pt idx="11">
                  <c:v>630.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7-91B1-4CBD-AD51-9ECD14F03CEA}"/>
            </c:ext>
          </c:extLst>
        </c:ser>
        <c:ser>
          <c:idx val="24"/>
          <c:order val="24"/>
          <c:tx>
            <c:strRef>
              <c:f>'18s Rarfaction'!$C$154</c:f>
              <c:strCache>
                <c:ptCount val="1"/>
                <c:pt idx="0">
                  <c:v>01/02/2014</c:v>
                </c:pt>
              </c:strCache>
            </c:strRef>
          </c:tx>
          <c:spPr>
            <a:ln w="952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4:$Q$154</c:f>
              <c:numCache>
                <c:formatCode>General</c:formatCode>
                <c:ptCount val="14"/>
                <c:pt idx="0">
                  <c:v>1</c:v>
                </c:pt>
                <c:pt idx="1">
                  <c:v>203.31</c:v>
                </c:pt>
                <c:pt idx="2">
                  <c:v>309.89999999999992</c:v>
                </c:pt>
                <c:pt idx="3">
                  <c:v>386.73</c:v>
                </c:pt>
                <c:pt idx="4">
                  <c:v>449.61</c:v>
                </c:pt>
                <c:pt idx="5">
                  <c:v>500.06</c:v>
                </c:pt>
                <c:pt idx="6">
                  <c:v>540.42999999999984</c:v>
                </c:pt>
                <c:pt idx="7">
                  <c:v>571.03</c:v>
                </c:pt>
                <c:pt idx="8">
                  <c:v>600.31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8-91B1-4CBD-AD51-9ECD14F03CEA}"/>
            </c:ext>
          </c:extLst>
        </c:ser>
        <c:ser>
          <c:idx val="25"/>
          <c:order val="25"/>
          <c:tx>
            <c:strRef>
              <c:f>'18s Rarfaction'!$C$155</c:f>
              <c:strCache>
                <c:ptCount val="1"/>
                <c:pt idx="0">
                  <c:v>01/02/2014</c:v>
                </c:pt>
              </c:strCache>
            </c:strRef>
          </c:tx>
          <c:spPr>
            <a:ln w="952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5:$Q$155</c:f>
              <c:numCache>
                <c:formatCode>General</c:formatCode>
                <c:ptCount val="14"/>
                <c:pt idx="0">
                  <c:v>1</c:v>
                </c:pt>
                <c:pt idx="1">
                  <c:v>204.3</c:v>
                </c:pt>
                <c:pt idx="2">
                  <c:v>313.13</c:v>
                </c:pt>
                <c:pt idx="3">
                  <c:v>397.98</c:v>
                </c:pt>
                <c:pt idx="4">
                  <c:v>463.65</c:v>
                </c:pt>
                <c:pt idx="5">
                  <c:v>521.02</c:v>
                </c:pt>
                <c:pt idx="6">
                  <c:v>567.04999999999984</c:v>
                </c:pt>
                <c:pt idx="7">
                  <c:v>605.75</c:v>
                </c:pt>
                <c:pt idx="8">
                  <c:v>644.05999999999983</c:v>
                </c:pt>
                <c:pt idx="9">
                  <c:v>669.79</c:v>
                </c:pt>
                <c:pt idx="10">
                  <c:v>699.78</c:v>
                </c:pt>
                <c:pt idx="11">
                  <c:v>721.81</c:v>
                </c:pt>
                <c:pt idx="12">
                  <c:v>742.95999999999992</c:v>
                </c:pt>
                <c:pt idx="13">
                  <c:v>759.959999999999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9-91B1-4CBD-AD51-9ECD14F03CEA}"/>
            </c:ext>
          </c:extLst>
        </c:ser>
        <c:ser>
          <c:idx val="26"/>
          <c:order val="26"/>
          <c:tx>
            <c:strRef>
              <c:f>'18s Rarfaction'!$C$156</c:f>
              <c:strCache>
                <c:ptCount val="1"/>
                <c:pt idx="0">
                  <c:v>08/02/2014</c:v>
                </c:pt>
              </c:strCache>
            </c:strRef>
          </c:tx>
          <c:spPr>
            <a:ln w="952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6:$Q$156</c:f>
              <c:numCache>
                <c:formatCode>General</c:formatCode>
                <c:ptCount val="14"/>
                <c:pt idx="0">
                  <c:v>1</c:v>
                </c:pt>
                <c:pt idx="1">
                  <c:v>191.72</c:v>
                </c:pt>
                <c:pt idx="2">
                  <c:v>294.14999999999998</c:v>
                </c:pt>
                <c:pt idx="3">
                  <c:v>370.81</c:v>
                </c:pt>
                <c:pt idx="4">
                  <c:v>434.75</c:v>
                </c:pt>
                <c:pt idx="5">
                  <c:v>480.1</c:v>
                </c:pt>
                <c:pt idx="6">
                  <c:v>518.23</c:v>
                </c:pt>
                <c:pt idx="7">
                  <c:v>552.72</c:v>
                </c:pt>
                <c:pt idx="8">
                  <c:v>581.1</c:v>
                </c:pt>
                <c:pt idx="9">
                  <c:v>604.66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A-91B1-4CBD-AD51-9ECD14F03CEA}"/>
            </c:ext>
          </c:extLst>
        </c:ser>
        <c:ser>
          <c:idx val="27"/>
          <c:order val="27"/>
          <c:tx>
            <c:strRef>
              <c:f>'18s Rarfaction'!$C$157</c:f>
              <c:strCache>
                <c:ptCount val="1"/>
                <c:pt idx="0">
                  <c:v>15/02/2014</c:v>
                </c:pt>
              </c:strCache>
            </c:strRef>
          </c:tx>
          <c:spPr>
            <a:ln w="952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7:$Q$157</c:f>
              <c:numCache>
                <c:formatCode>General</c:formatCode>
                <c:ptCount val="14"/>
                <c:pt idx="0">
                  <c:v>1</c:v>
                </c:pt>
                <c:pt idx="1">
                  <c:v>202.85</c:v>
                </c:pt>
                <c:pt idx="2">
                  <c:v>303.14</c:v>
                </c:pt>
                <c:pt idx="3">
                  <c:v>380.79</c:v>
                </c:pt>
                <c:pt idx="4">
                  <c:v>438.83</c:v>
                </c:pt>
                <c:pt idx="5">
                  <c:v>488.56</c:v>
                </c:pt>
                <c:pt idx="6">
                  <c:v>530.20000000000005</c:v>
                </c:pt>
                <c:pt idx="7">
                  <c:v>563.93999999999994</c:v>
                </c:pt>
                <c:pt idx="8">
                  <c:v>592.77</c:v>
                </c:pt>
                <c:pt idx="9">
                  <c:v>615.41999999999996</c:v>
                </c:pt>
                <c:pt idx="10">
                  <c:v>637.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B-91B1-4CBD-AD51-9ECD14F03CEA}"/>
            </c:ext>
          </c:extLst>
        </c:ser>
        <c:ser>
          <c:idx val="28"/>
          <c:order val="28"/>
          <c:tx>
            <c:strRef>
              <c:f>'18s Rarfaction'!$C$158</c:f>
              <c:strCache>
                <c:ptCount val="1"/>
                <c:pt idx="0">
                  <c:v>15/02/2014</c:v>
                </c:pt>
              </c:strCache>
            </c:strRef>
          </c:tx>
          <c:spPr>
            <a:ln w="952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8:$Q$158</c:f>
              <c:numCache>
                <c:formatCode>General</c:formatCode>
                <c:ptCount val="14"/>
                <c:pt idx="0">
                  <c:v>1</c:v>
                </c:pt>
                <c:pt idx="1">
                  <c:v>199.53</c:v>
                </c:pt>
                <c:pt idx="2">
                  <c:v>306.72000000000003</c:v>
                </c:pt>
                <c:pt idx="3">
                  <c:v>387.97</c:v>
                </c:pt>
                <c:pt idx="4">
                  <c:v>453.85</c:v>
                </c:pt>
                <c:pt idx="5">
                  <c:v>509.19</c:v>
                </c:pt>
                <c:pt idx="6">
                  <c:v>554.37</c:v>
                </c:pt>
                <c:pt idx="7">
                  <c:v>593.74</c:v>
                </c:pt>
                <c:pt idx="8">
                  <c:v>626.63</c:v>
                </c:pt>
                <c:pt idx="9">
                  <c:v>655.62</c:v>
                </c:pt>
                <c:pt idx="10">
                  <c:v>681.15</c:v>
                </c:pt>
                <c:pt idx="11">
                  <c:v>704.17</c:v>
                </c:pt>
                <c:pt idx="12">
                  <c:v>722.72</c:v>
                </c:pt>
                <c:pt idx="13">
                  <c:v>740.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C-91B1-4CBD-AD51-9ECD14F03CEA}"/>
            </c:ext>
          </c:extLst>
        </c:ser>
        <c:ser>
          <c:idx val="29"/>
          <c:order val="29"/>
          <c:tx>
            <c:strRef>
              <c:f>'18s Rarfaction'!$C$159</c:f>
              <c:strCache>
                <c:ptCount val="1"/>
                <c:pt idx="0">
                  <c:v>22/02/2014</c:v>
                </c:pt>
              </c:strCache>
            </c:strRef>
          </c:tx>
          <c:spPr>
            <a:ln w="952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59:$Q$159</c:f>
              <c:numCache>
                <c:formatCode>General</c:formatCode>
                <c:ptCount val="14"/>
                <c:pt idx="0">
                  <c:v>1</c:v>
                </c:pt>
                <c:pt idx="1">
                  <c:v>194.53</c:v>
                </c:pt>
                <c:pt idx="2">
                  <c:v>296.08999999999992</c:v>
                </c:pt>
                <c:pt idx="3">
                  <c:v>368.75</c:v>
                </c:pt>
                <c:pt idx="4">
                  <c:v>432.75</c:v>
                </c:pt>
                <c:pt idx="5">
                  <c:v>479.22</c:v>
                </c:pt>
                <c:pt idx="6">
                  <c:v>519.83999999999992</c:v>
                </c:pt>
                <c:pt idx="7">
                  <c:v>553.70000000000005</c:v>
                </c:pt>
                <c:pt idx="8">
                  <c:v>584.5</c:v>
                </c:pt>
                <c:pt idx="9">
                  <c:v>610.01</c:v>
                </c:pt>
                <c:pt idx="10">
                  <c:v>632.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D-91B1-4CBD-AD51-9ECD14F03CEA}"/>
            </c:ext>
          </c:extLst>
        </c:ser>
        <c:ser>
          <c:idx val="30"/>
          <c:order val="30"/>
          <c:tx>
            <c:strRef>
              <c:f>'18s Rarfaction'!$C$160</c:f>
              <c:strCache>
                <c:ptCount val="1"/>
                <c:pt idx="0">
                  <c:v>22/02/2014</c:v>
                </c:pt>
              </c:strCache>
            </c:strRef>
          </c:tx>
          <c:spPr>
            <a:ln w="9525" cap="rnd">
              <a:solidFill>
                <a:schemeClr val="accent1">
                  <a:lumMod val="50000"/>
                </a:schemeClr>
              </a:solidFill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none"/>
          </c:marker>
          <c:xVal>
            <c:numRef>
              <c:f>'18s Rarfaction'!$D$129:$Q$129</c:f>
              <c:numCache>
                <c:formatCode>0</c:formatCode>
                <c:ptCount val="14"/>
                <c:pt idx="0">
                  <c:v>1</c:v>
                </c:pt>
                <c:pt idx="1">
                  <c:v>5264</c:v>
                </c:pt>
                <c:pt idx="2">
                  <c:v>10527</c:v>
                </c:pt>
                <c:pt idx="3">
                  <c:v>15790</c:v>
                </c:pt>
                <c:pt idx="4">
                  <c:v>21053</c:v>
                </c:pt>
                <c:pt idx="5">
                  <c:v>26317</c:v>
                </c:pt>
                <c:pt idx="6">
                  <c:v>31580</c:v>
                </c:pt>
                <c:pt idx="7">
                  <c:v>36843</c:v>
                </c:pt>
                <c:pt idx="8">
                  <c:v>42106</c:v>
                </c:pt>
                <c:pt idx="9">
                  <c:v>47369</c:v>
                </c:pt>
                <c:pt idx="10">
                  <c:v>52632</c:v>
                </c:pt>
                <c:pt idx="11">
                  <c:v>57895</c:v>
                </c:pt>
                <c:pt idx="12">
                  <c:v>63158</c:v>
                </c:pt>
                <c:pt idx="13">
                  <c:v>68421</c:v>
                </c:pt>
              </c:numCache>
            </c:numRef>
          </c:xVal>
          <c:yVal>
            <c:numRef>
              <c:f>'18s Rarfaction'!$D$160:$Q$160</c:f>
              <c:numCache>
                <c:formatCode>General</c:formatCode>
                <c:ptCount val="14"/>
                <c:pt idx="0">
                  <c:v>1</c:v>
                </c:pt>
                <c:pt idx="1">
                  <c:v>201.93</c:v>
                </c:pt>
                <c:pt idx="2">
                  <c:v>300.08</c:v>
                </c:pt>
                <c:pt idx="3">
                  <c:v>376.61</c:v>
                </c:pt>
                <c:pt idx="4">
                  <c:v>438.22</c:v>
                </c:pt>
                <c:pt idx="5">
                  <c:v>487.66</c:v>
                </c:pt>
                <c:pt idx="6">
                  <c:v>528.14</c:v>
                </c:pt>
                <c:pt idx="7">
                  <c:v>565.41999999999996</c:v>
                </c:pt>
                <c:pt idx="8">
                  <c:v>594.98</c:v>
                </c:pt>
                <c:pt idx="9">
                  <c:v>623.42999999999984</c:v>
                </c:pt>
                <c:pt idx="10">
                  <c:v>646.41999999999996</c:v>
                </c:pt>
                <c:pt idx="11">
                  <c:v>665.329999999999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E-91B1-4CBD-AD51-9ECD14F03C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2099464"/>
        <c:axId val="592103384"/>
      </c:scatterChart>
      <c:valAx>
        <c:axId val="592099464"/>
        <c:scaling>
          <c:orientation val="minMax"/>
          <c:max val="80000"/>
        </c:scaling>
        <c:delete val="1"/>
        <c:axPos val="b"/>
        <c:numFmt formatCode="0" sourceLinked="1"/>
        <c:majorTickMark val="out"/>
        <c:minorTickMark val="none"/>
        <c:tickLblPos val="nextTo"/>
        <c:crossAx val="592103384"/>
        <c:crosses val="autoZero"/>
        <c:crossBetween val="midCat"/>
        <c:majorUnit val="20000"/>
      </c:valAx>
      <c:valAx>
        <c:axId val="592103384"/>
        <c:scaling>
          <c:orientation val="minMax"/>
          <c:max val="1000"/>
        </c:scaling>
        <c:delete val="0"/>
        <c:axPos val="l"/>
        <c:majorGridlines/>
        <c:minorGridlines>
          <c:spPr>
            <a:ln>
              <a:solidFill>
                <a:schemeClr val="tx1"/>
              </a:solidFill>
              <a:prstDash val="dash"/>
            </a:ln>
          </c:spPr>
        </c:min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592099464"/>
        <c:crosses val="autoZero"/>
        <c:crossBetween val="midCat"/>
        <c:majorUnit val="5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000" b="1" i="1" baseline="0" dirty="0" err="1">
                <a:effectLst/>
              </a:rPr>
              <a:t>Bacteriovorax</a:t>
            </a:r>
            <a:r>
              <a:rPr lang="en-US" sz="1000" b="1" i="1" baseline="0" dirty="0">
                <a:effectLst/>
              </a:rPr>
              <a:t>-</a:t>
            </a:r>
            <a:r>
              <a:rPr lang="en-US" sz="1000" b="1" i="0" baseline="0" dirty="0">
                <a:effectLst/>
              </a:rPr>
              <a:t>Bx</a:t>
            </a:r>
            <a:endParaRPr lang="en-US" sz="1000" dirty="0">
              <a:effectLst/>
            </a:endParaRPr>
          </a:p>
        </c:rich>
      </c:tx>
      <c:layout>
        <c:manualLayout>
          <c:xMode val="edge"/>
          <c:yMode val="edge"/>
          <c:x val="0.18778314462298415"/>
          <c:y val="6.0133900617909228E-2"/>
        </c:manualLayout>
      </c:layout>
      <c:overlay val="0"/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Kid!$B$5</c:f>
              <c:strCache>
                <c:ptCount val="1"/>
                <c:pt idx="0">
                  <c:v>01/03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B$6:$B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43C-4C3C-B496-C29F99FB8CCF}"/>
            </c:ext>
          </c:extLst>
        </c:ser>
        <c:ser>
          <c:idx val="1"/>
          <c:order val="1"/>
          <c:tx>
            <c:strRef>
              <c:f>Kid!$C$5</c:f>
              <c:strCache>
                <c:ptCount val="1"/>
                <c:pt idx="0">
                  <c:v>01/03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C$6:$C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43C-4C3C-B496-C29F99FB8CCF}"/>
            </c:ext>
          </c:extLst>
        </c:ser>
        <c:ser>
          <c:idx val="2"/>
          <c:order val="2"/>
          <c:tx>
            <c:strRef>
              <c:f>Kid!$D$5</c:f>
              <c:strCache>
                <c:ptCount val="1"/>
                <c:pt idx="0">
                  <c:v>01/05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D$6:$D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43C-4C3C-B496-C29F99FB8CCF}"/>
            </c:ext>
          </c:extLst>
        </c:ser>
        <c:ser>
          <c:idx val="3"/>
          <c:order val="3"/>
          <c:tx>
            <c:strRef>
              <c:f>Kid!$E$5</c:f>
              <c:strCache>
                <c:ptCount val="1"/>
                <c:pt idx="0">
                  <c:v>01/05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E$6:$E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43C-4C3C-B496-C29F99FB8CCF}"/>
            </c:ext>
          </c:extLst>
        </c:ser>
        <c:ser>
          <c:idx val="4"/>
          <c:order val="4"/>
          <c:tx>
            <c:strRef>
              <c:f>Kid!$F$5</c:f>
              <c:strCache>
                <c:ptCount val="1"/>
                <c:pt idx="0">
                  <c:v>01/06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F$6:$F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43C-4C3C-B496-C29F99FB8CCF}"/>
            </c:ext>
          </c:extLst>
        </c:ser>
        <c:ser>
          <c:idx val="5"/>
          <c:order val="5"/>
          <c:tx>
            <c:strRef>
              <c:f>Kid!$G$5</c:f>
              <c:strCache>
                <c:ptCount val="1"/>
                <c:pt idx="0">
                  <c:v>01/06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G$6:$G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943C-4C3C-B496-C29F99FB8CCF}"/>
            </c:ext>
          </c:extLst>
        </c:ser>
        <c:ser>
          <c:idx val="6"/>
          <c:order val="6"/>
          <c:tx>
            <c:strRef>
              <c:f>Kid!$H$5</c:f>
              <c:strCache>
                <c:ptCount val="1"/>
                <c:pt idx="0">
                  <c:v>01/07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H$6:$H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943C-4C3C-B496-C29F99FB8CCF}"/>
            </c:ext>
          </c:extLst>
        </c:ser>
        <c:ser>
          <c:idx val="7"/>
          <c:order val="7"/>
          <c:tx>
            <c:strRef>
              <c:f>Kid!$I$5</c:f>
              <c:strCache>
                <c:ptCount val="1"/>
                <c:pt idx="0">
                  <c:v>01/07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I$6:$I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943C-4C3C-B496-C29F99FB8CCF}"/>
            </c:ext>
          </c:extLst>
        </c:ser>
        <c:ser>
          <c:idx val="8"/>
          <c:order val="8"/>
          <c:tx>
            <c:strRef>
              <c:f>Kid!$J$5</c:f>
              <c:strCache>
                <c:ptCount val="1"/>
                <c:pt idx="0">
                  <c:v>01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J$6:$J$29</c:f>
              <c:numCache>
                <c:formatCode>General</c:formatCode>
                <c:ptCount val="24"/>
                <c:pt idx="0">
                  <c:v>1</c:v>
                </c:pt>
                <c:pt idx="1">
                  <c:v>11.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943C-4C3C-B496-C29F99FB8CCF}"/>
            </c:ext>
          </c:extLst>
        </c:ser>
        <c:ser>
          <c:idx val="9"/>
          <c:order val="9"/>
          <c:tx>
            <c:strRef>
              <c:f>Kid!$K$5</c:f>
              <c:strCache>
                <c:ptCount val="1"/>
                <c:pt idx="0">
                  <c:v>01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K$6:$K$29</c:f>
              <c:numCache>
                <c:formatCode>General</c:formatCode>
                <c:ptCount val="24"/>
                <c:pt idx="0">
                  <c:v>1</c:v>
                </c:pt>
                <c:pt idx="1">
                  <c:v>7.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943C-4C3C-B496-C29F99FB8CCF}"/>
            </c:ext>
          </c:extLst>
        </c:ser>
        <c:ser>
          <c:idx val="10"/>
          <c:order val="10"/>
          <c:tx>
            <c:strRef>
              <c:f>Kid!$L$5</c:f>
              <c:strCache>
                <c:ptCount val="1"/>
                <c:pt idx="0">
                  <c:v>08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L$6:$L$29</c:f>
              <c:numCache>
                <c:formatCode>General</c:formatCode>
                <c:ptCount val="24"/>
                <c:pt idx="0">
                  <c:v>1</c:v>
                </c:pt>
                <c:pt idx="1">
                  <c:v>22.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943C-4C3C-B496-C29F99FB8CCF}"/>
            </c:ext>
          </c:extLst>
        </c:ser>
        <c:ser>
          <c:idx val="11"/>
          <c:order val="11"/>
          <c:tx>
            <c:strRef>
              <c:f>Kid!$M$5</c:f>
              <c:strCache>
                <c:ptCount val="1"/>
                <c:pt idx="0">
                  <c:v>08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M$6:$M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943C-4C3C-B496-C29F99FB8CCF}"/>
            </c:ext>
          </c:extLst>
        </c:ser>
        <c:ser>
          <c:idx val="12"/>
          <c:order val="12"/>
          <c:tx>
            <c:strRef>
              <c:f>Kid!$N$5</c:f>
              <c:strCache>
                <c:ptCount val="1"/>
                <c:pt idx="0">
                  <c:v>15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N$6:$N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943C-4C3C-B496-C29F99FB8CCF}"/>
            </c:ext>
          </c:extLst>
        </c:ser>
        <c:ser>
          <c:idx val="13"/>
          <c:order val="13"/>
          <c:tx>
            <c:strRef>
              <c:f>Kid!$O$5</c:f>
              <c:strCache>
                <c:ptCount val="1"/>
                <c:pt idx="0">
                  <c:v>15/08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O$6:$O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943C-4C3C-B496-C29F99FB8CCF}"/>
            </c:ext>
          </c:extLst>
        </c:ser>
        <c:ser>
          <c:idx val="14"/>
          <c:order val="14"/>
          <c:tx>
            <c:strRef>
              <c:f>Kid!$P$5</c:f>
              <c:strCache>
                <c:ptCount val="1"/>
                <c:pt idx="0">
                  <c:v>01/09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P$6:$P$29</c:f>
              <c:numCache>
                <c:formatCode>General</c:formatCode>
                <c:ptCount val="24"/>
                <c:pt idx="0">
                  <c:v>1</c:v>
                </c:pt>
                <c:pt idx="1">
                  <c:v>8.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943C-4C3C-B496-C29F99FB8CCF}"/>
            </c:ext>
          </c:extLst>
        </c:ser>
        <c:ser>
          <c:idx val="15"/>
          <c:order val="15"/>
          <c:tx>
            <c:strRef>
              <c:f>Kid!$Q$5</c:f>
              <c:strCache>
                <c:ptCount val="1"/>
                <c:pt idx="0">
                  <c:v>01/09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Q$6:$Q$29</c:f>
              <c:numCache>
                <c:formatCode>General</c:formatCode>
                <c:ptCount val="24"/>
                <c:pt idx="0">
                  <c:v>1</c:v>
                </c:pt>
                <c:pt idx="1">
                  <c:v>8.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943C-4C3C-B496-C29F99FB8CCF}"/>
            </c:ext>
          </c:extLst>
        </c:ser>
        <c:ser>
          <c:idx val="16"/>
          <c:order val="16"/>
          <c:tx>
            <c:strRef>
              <c:f>Kid!$R$5</c:f>
              <c:strCache>
                <c:ptCount val="1"/>
                <c:pt idx="0">
                  <c:v>01/10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R$6:$R$29</c:f>
              <c:numCache>
                <c:formatCode>General</c:formatCode>
                <c:ptCount val="24"/>
                <c:pt idx="0">
                  <c:v>1</c:v>
                </c:pt>
                <c:pt idx="1">
                  <c:v>9.8800000000000008</c:v>
                </c:pt>
                <c:pt idx="2">
                  <c:v>14.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943C-4C3C-B496-C29F99FB8CCF}"/>
            </c:ext>
          </c:extLst>
        </c:ser>
        <c:ser>
          <c:idx val="17"/>
          <c:order val="17"/>
          <c:tx>
            <c:strRef>
              <c:f>Kid!$S$5</c:f>
              <c:strCache>
                <c:ptCount val="1"/>
                <c:pt idx="0">
                  <c:v>01/10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S$6:$S$29</c:f>
              <c:numCache>
                <c:formatCode>General</c:formatCode>
                <c:ptCount val="24"/>
                <c:pt idx="0">
                  <c:v>1</c:v>
                </c:pt>
                <c:pt idx="1">
                  <c:v>8.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943C-4C3C-B496-C29F99FB8CCF}"/>
            </c:ext>
          </c:extLst>
        </c:ser>
        <c:ser>
          <c:idx val="18"/>
          <c:order val="18"/>
          <c:tx>
            <c:strRef>
              <c:f>Kid!$T$5</c:f>
              <c:strCache>
                <c:ptCount val="1"/>
                <c:pt idx="0">
                  <c:v>01/11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T$6:$T$29</c:f>
              <c:numCache>
                <c:formatCode>General</c:formatCode>
                <c:ptCount val="24"/>
                <c:pt idx="0">
                  <c:v>1</c:v>
                </c:pt>
                <c:pt idx="1">
                  <c:v>10.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2-943C-4C3C-B496-C29F99FB8CCF}"/>
            </c:ext>
          </c:extLst>
        </c:ser>
        <c:ser>
          <c:idx val="19"/>
          <c:order val="19"/>
          <c:tx>
            <c:strRef>
              <c:f>Kid!$U$5</c:f>
              <c:strCache>
                <c:ptCount val="1"/>
                <c:pt idx="0">
                  <c:v>01/11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U$6:$U$29</c:f>
              <c:numCache>
                <c:formatCode>General</c:formatCode>
                <c:ptCount val="24"/>
                <c:pt idx="0">
                  <c:v>1</c:v>
                </c:pt>
                <c:pt idx="1">
                  <c:v>11.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3-943C-4C3C-B496-C29F99FB8CCF}"/>
            </c:ext>
          </c:extLst>
        </c:ser>
        <c:ser>
          <c:idx val="20"/>
          <c:order val="20"/>
          <c:tx>
            <c:strRef>
              <c:f>Kid!$V$5</c:f>
              <c:strCache>
                <c:ptCount val="1"/>
                <c:pt idx="0">
                  <c:v>01/12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V$6:$V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4-943C-4C3C-B496-C29F99FB8CCF}"/>
            </c:ext>
          </c:extLst>
        </c:ser>
        <c:ser>
          <c:idx val="21"/>
          <c:order val="21"/>
          <c:tx>
            <c:strRef>
              <c:f>Kid!$W$5</c:f>
              <c:strCache>
                <c:ptCount val="1"/>
                <c:pt idx="0">
                  <c:v>01/12/2013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W$6:$W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5-943C-4C3C-B496-C29F99FB8CCF}"/>
            </c:ext>
          </c:extLst>
        </c:ser>
        <c:ser>
          <c:idx val="22"/>
          <c:order val="22"/>
          <c:tx>
            <c:strRef>
              <c:f>Kid!$X$5</c:f>
              <c:strCache>
                <c:ptCount val="1"/>
                <c:pt idx="0">
                  <c:v>01/01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X$6:$X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6-943C-4C3C-B496-C29F99FB8CCF}"/>
            </c:ext>
          </c:extLst>
        </c:ser>
        <c:ser>
          <c:idx val="23"/>
          <c:order val="23"/>
          <c:tx>
            <c:strRef>
              <c:f>Kid!$Y$5</c:f>
              <c:strCache>
                <c:ptCount val="1"/>
                <c:pt idx="0">
                  <c:v>01/01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Y$6:$Y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7-943C-4C3C-B496-C29F99FB8CCF}"/>
            </c:ext>
          </c:extLst>
        </c:ser>
        <c:ser>
          <c:idx val="24"/>
          <c:order val="24"/>
          <c:tx>
            <c:strRef>
              <c:f>Kid!$Z$5</c:f>
              <c:strCache>
                <c:ptCount val="1"/>
                <c:pt idx="0">
                  <c:v>01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Z$6:$Z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8-943C-4C3C-B496-C29F99FB8CCF}"/>
            </c:ext>
          </c:extLst>
        </c:ser>
        <c:ser>
          <c:idx val="25"/>
          <c:order val="25"/>
          <c:tx>
            <c:strRef>
              <c:f>Kid!$AA$5</c:f>
              <c:strCache>
                <c:ptCount val="1"/>
                <c:pt idx="0">
                  <c:v>01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A$6:$AA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9-943C-4C3C-B496-C29F99FB8CCF}"/>
            </c:ext>
          </c:extLst>
        </c:ser>
        <c:ser>
          <c:idx val="26"/>
          <c:order val="26"/>
          <c:tx>
            <c:strRef>
              <c:f>Kid!$AB$5</c:f>
              <c:strCache>
                <c:ptCount val="1"/>
                <c:pt idx="0">
                  <c:v>08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B$6:$AB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A-943C-4C3C-B496-C29F99FB8CCF}"/>
            </c:ext>
          </c:extLst>
        </c:ser>
        <c:ser>
          <c:idx val="27"/>
          <c:order val="27"/>
          <c:tx>
            <c:strRef>
              <c:f>Kid!$AC$5</c:f>
              <c:strCache>
                <c:ptCount val="1"/>
                <c:pt idx="0">
                  <c:v>15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C$6:$AC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B-943C-4C3C-B496-C29F99FB8CCF}"/>
            </c:ext>
          </c:extLst>
        </c:ser>
        <c:ser>
          <c:idx val="28"/>
          <c:order val="28"/>
          <c:tx>
            <c:strRef>
              <c:f>Kid!$AD$5</c:f>
              <c:strCache>
                <c:ptCount val="1"/>
                <c:pt idx="0">
                  <c:v>15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D$6:$AD$29</c:f>
              <c:numCache>
                <c:formatCode>General</c:formatCode>
                <c:ptCount val="24"/>
                <c:pt idx="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C-943C-4C3C-B496-C29F99FB8CCF}"/>
            </c:ext>
          </c:extLst>
        </c:ser>
        <c:ser>
          <c:idx val="29"/>
          <c:order val="29"/>
          <c:tx>
            <c:strRef>
              <c:f>Kid!$AE$5</c:f>
              <c:strCache>
                <c:ptCount val="1"/>
                <c:pt idx="0">
                  <c:v>22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E$6:$AE$29</c:f>
              <c:numCache>
                <c:formatCode>General</c:formatCode>
                <c:ptCount val="24"/>
                <c:pt idx="0">
                  <c:v>1</c:v>
                </c:pt>
                <c:pt idx="1">
                  <c:v>8.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D-943C-4C3C-B496-C29F99FB8CCF}"/>
            </c:ext>
          </c:extLst>
        </c:ser>
        <c:ser>
          <c:idx val="30"/>
          <c:order val="30"/>
          <c:tx>
            <c:strRef>
              <c:f>Kid!$AF$5</c:f>
              <c:strCache>
                <c:ptCount val="1"/>
                <c:pt idx="0">
                  <c:v>22/02/2014</c:v>
                </c:pt>
              </c:strCache>
            </c:strRef>
          </c:tx>
          <c:marker>
            <c:symbol val="none"/>
          </c:marker>
          <c:xVal>
            <c:numRef>
              <c:f>Kid!$A$6:$A$29</c:f>
              <c:numCache>
                <c:formatCode>General</c:formatCode>
                <c:ptCount val="24"/>
                <c:pt idx="0">
                  <c:v>1</c:v>
                </c:pt>
                <c:pt idx="1">
                  <c:v>2042</c:v>
                </c:pt>
                <c:pt idx="2">
                  <c:v>4083</c:v>
                </c:pt>
                <c:pt idx="3">
                  <c:v>6123</c:v>
                </c:pt>
                <c:pt idx="4">
                  <c:v>8164</c:v>
                </c:pt>
                <c:pt idx="5">
                  <c:v>10205</c:v>
                </c:pt>
                <c:pt idx="6">
                  <c:v>12246</c:v>
                </c:pt>
                <c:pt idx="7">
                  <c:v>14287</c:v>
                </c:pt>
                <c:pt idx="8">
                  <c:v>16327</c:v>
                </c:pt>
                <c:pt idx="9">
                  <c:v>18368</c:v>
                </c:pt>
                <c:pt idx="10">
                  <c:v>20409</c:v>
                </c:pt>
                <c:pt idx="11">
                  <c:v>22450</c:v>
                </c:pt>
                <c:pt idx="12">
                  <c:v>24491</c:v>
                </c:pt>
                <c:pt idx="13">
                  <c:v>26531</c:v>
                </c:pt>
                <c:pt idx="14">
                  <c:v>28572</c:v>
                </c:pt>
                <c:pt idx="15">
                  <c:v>30613</c:v>
                </c:pt>
                <c:pt idx="16">
                  <c:v>32654</c:v>
                </c:pt>
                <c:pt idx="17">
                  <c:v>34695</c:v>
                </c:pt>
                <c:pt idx="18">
                  <c:v>36735</c:v>
                </c:pt>
                <c:pt idx="19">
                  <c:v>38776</c:v>
                </c:pt>
                <c:pt idx="20">
                  <c:v>40817</c:v>
                </c:pt>
                <c:pt idx="21">
                  <c:v>42858</c:v>
                </c:pt>
                <c:pt idx="22">
                  <c:v>44899</c:v>
                </c:pt>
                <c:pt idx="23">
                  <c:v>46939</c:v>
                </c:pt>
              </c:numCache>
            </c:numRef>
          </c:xVal>
          <c:yVal>
            <c:numRef>
              <c:f>Kid!$AF$6:$AF$29</c:f>
              <c:numCache>
                <c:formatCode>General</c:formatCode>
                <c:ptCount val="24"/>
                <c:pt idx="0">
                  <c:v>1</c:v>
                </c:pt>
                <c:pt idx="1">
                  <c:v>7.7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E-943C-4C3C-B496-C29F99FB8C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5855360"/>
        <c:axId val="265930240"/>
      </c:scatterChart>
      <c:valAx>
        <c:axId val="265855360"/>
        <c:scaling>
          <c:orientation val="minMax"/>
          <c:max val="500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b="0" i="0" baseline="0" dirty="0">
                    <a:effectLst/>
                  </a:rPr>
                  <a:t>Number of reads</a:t>
                </a:r>
                <a:endParaRPr lang="en-150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3499606948549332"/>
              <c:y val="0.897661306044982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/>
        </c:spPr>
        <c:crossAx val="265930240"/>
        <c:crosses val="autoZero"/>
        <c:crossBetween val="midCat"/>
      </c:valAx>
      <c:valAx>
        <c:axId val="265930240"/>
        <c:scaling>
          <c:orientation val="minMax"/>
        </c:scaling>
        <c:delete val="0"/>
        <c:axPos val="l"/>
        <c:majorGridlines>
          <c:spPr>
            <a:ln>
              <a:prstDash val="dash"/>
            </a:ln>
          </c:spPr>
        </c:majorGridlines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b="0" i="0" baseline="0" dirty="0">
                    <a:effectLst/>
                  </a:rPr>
                  <a:t>Number of  OTUs</a:t>
                </a:r>
                <a:endParaRPr lang="en-150" sz="1000" dirty="0">
                  <a:effectLst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/>
        </c:spPr>
        <c:crossAx val="2658553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0714594114145217"/>
          <c:y val="9.2386490116021958E-2"/>
          <c:w val="0.40321644016719371"/>
          <c:h val="0.71868394396216539"/>
        </c:manualLayout>
      </c:layout>
      <c:overlay val="0"/>
      <c:spPr>
        <a:solidFill>
          <a:schemeClr val="bg1"/>
        </a:solidFill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/>
            </a:pPr>
            <a:r>
              <a:rPr lang="en-US" sz="1000" b="1" i="1" baseline="0" dirty="0" err="1">
                <a:effectLst/>
              </a:rPr>
              <a:t>Bdellovibrio</a:t>
            </a:r>
            <a:r>
              <a:rPr lang="en-US" sz="1000" b="1" i="1" baseline="0" dirty="0">
                <a:effectLst/>
              </a:rPr>
              <a:t>- </a:t>
            </a:r>
            <a:r>
              <a:rPr lang="en-US" sz="1000" b="1" i="0" baseline="0" dirty="0">
                <a:effectLst/>
              </a:rPr>
              <a:t>Bd</a:t>
            </a:r>
            <a:endParaRPr lang="en-US" sz="1000" dirty="0">
              <a:effectLst/>
            </a:endParaRPr>
          </a:p>
        </c:rich>
      </c:tx>
      <c:layout>
        <c:manualLayout>
          <c:xMode val="edge"/>
          <c:yMode val="edge"/>
          <c:x val="0.20216688119088924"/>
          <c:y val="4.709889199224481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4850813800417"/>
          <c:y val="0.14034676054449507"/>
          <c:w val="0.64052419892479506"/>
          <c:h val="0.6587102653106738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Kid!$B$5</c:f>
              <c:strCache>
                <c:ptCount val="1"/>
                <c:pt idx="0">
                  <c:v>01/03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B$6:$B$30</c:f>
              <c:numCache>
                <c:formatCode>General</c:formatCode>
                <c:ptCount val="25"/>
                <c:pt idx="0">
                  <c:v>1</c:v>
                </c:pt>
                <c:pt idx="1">
                  <c:v>19.8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467-4F49-864A-4729114F0D7A}"/>
            </c:ext>
          </c:extLst>
        </c:ser>
        <c:ser>
          <c:idx val="1"/>
          <c:order val="1"/>
          <c:tx>
            <c:strRef>
              <c:f>Kid!$C$5</c:f>
              <c:strCache>
                <c:ptCount val="1"/>
                <c:pt idx="0">
                  <c:v>01/03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C$6:$C$30</c:f>
              <c:numCache>
                <c:formatCode>General</c:formatCode>
                <c:ptCount val="25"/>
                <c:pt idx="0">
                  <c:v>1</c:v>
                </c:pt>
                <c:pt idx="1">
                  <c:v>36.94</c:v>
                </c:pt>
                <c:pt idx="2">
                  <c:v>39.909999999999997</c:v>
                </c:pt>
                <c:pt idx="3">
                  <c:v>41.74</c:v>
                </c:pt>
                <c:pt idx="4">
                  <c:v>42.62</c:v>
                </c:pt>
                <c:pt idx="5">
                  <c:v>43.47</c:v>
                </c:pt>
                <c:pt idx="6">
                  <c:v>43.72</c:v>
                </c:pt>
                <c:pt idx="7">
                  <c:v>44.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467-4F49-864A-4729114F0D7A}"/>
            </c:ext>
          </c:extLst>
        </c:ser>
        <c:ser>
          <c:idx val="2"/>
          <c:order val="2"/>
          <c:tx>
            <c:strRef>
              <c:f>Kid!$D$5</c:f>
              <c:strCache>
                <c:ptCount val="1"/>
                <c:pt idx="0">
                  <c:v>01/05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D$6:$D$30</c:f>
              <c:numCache>
                <c:formatCode>General</c:formatCode>
                <c:ptCount val="25"/>
                <c:pt idx="0">
                  <c:v>1</c:v>
                </c:pt>
                <c:pt idx="1">
                  <c:v>54.17</c:v>
                </c:pt>
                <c:pt idx="2">
                  <c:v>58.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467-4F49-864A-4729114F0D7A}"/>
            </c:ext>
          </c:extLst>
        </c:ser>
        <c:ser>
          <c:idx val="3"/>
          <c:order val="3"/>
          <c:tx>
            <c:strRef>
              <c:f>Kid!$E$5</c:f>
              <c:strCache>
                <c:ptCount val="1"/>
                <c:pt idx="0">
                  <c:v>01/05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E$6:$E$30</c:f>
              <c:numCache>
                <c:formatCode>General</c:formatCode>
                <c:ptCount val="25"/>
                <c:pt idx="0">
                  <c:v>1</c:v>
                </c:pt>
                <c:pt idx="1">
                  <c:v>28.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467-4F49-864A-4729114F0D7A}"/>
            </c:ext>
          </c:extLst>
        </c:ser>
        <c:ser>
          <c:idx val="4"/>
          <c:order val="4"/>
          <c:tx>
            <c:strRef>
              <c:f>Kid!$F$5</c:f>
              <c:strCache>
                <c:ptCount val="1"/>
                <c:pt idx="0">
                  <c:v>01/06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F$6:$F$30</c:f>
              <c:numCache>
                <c:formatCode>General</c:formatCode>
                <c:ptCount val="25"/>
                <c:pt idx="0">
                  <c:v>1</c:v>
                </c:pt>
                <c:pt idx="1">
                  <c:v>44.28</c:v>
                </c:pt>
                <c:pt idx="2">
                  <c:v>47.98</c:v>
                </c:pt>
                <c:pt idx="3">
                  <c:v>50</c:v>
                </c:pt>
                <c:pt idx="4">
                  <c:v>50.98</c:v>
                </c:pt>
                <c:pt idx="5">
                  <c:v>51.86</c:v>
                </c:pt>
                <c:pt idx="6">
                  <c:v>52.54</c:v>
                </c:pt>
                <c:pt idx="7">
                  <c:v>52.91</c:v>
                </c:pt>
                <c:pt idx="8">
                  <c:v>53.53</c:v>
                </c:pt>
                <c:pt idx="9">
                  <c:v>53.77</c:v>
                </c:pt>
                <c:pt idx="10">
                  <c:v>53.9</c:v>
                </c:pt>
                <c:pt idx="11">
                  <c:v>54.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467-4F49-864A-4729114F0D7A}"/>
            </c:ext>
          </c:extLst>
        </c:ser>
        <c:ser>
          <c:idx val="5"/>
          <c:order val="5"/>
          <c:tx>
            <c:strRef>
              <c:f>Kid!$G$5</c:f>
              <c:strCache>
                <c:ptCount val="1"/>
                <c:pt idx="0">
                  <c:v>01/06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G$6:$G$30</c:f>
              <c:numCache>
                <c:formatCode>General</c:formatCode>
                <c:ptCount val="25"/>
                <c:pt idx="0">
                  <c:v>1</c:v>
                </c:pt>
                <c:pt idx="1">
                  <c:v>33.24</c:v>
                </c:pt>
                <c:pt idx="2">
                  <c:v>35.56</c:v>
                </c:pt>
                <c:pt idx="3">
                  <c:v>36.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467-4F49-864A-4729114F0D7A}"/>
            </c:ext>
          </c:extLst>
        </c:ser>
        <c:ser>
          <c:idx val="6"/>
          <c:order val="6"/>
          <c:tx>
            <c:strRef>
              <c:f>Kid!$H$5</c:f>
              <c:strCache>
                <c:ptCount val="1"/>
                <c:pt idx="0">
                  <c:v>01/07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H$6:$H$30</c:f>
              <c:numCache>
                <c:formatCode>General</c:formatCode>
                <c:ptCount val="25"/>
                <c:pt idx="0">
                  <c:v>1</c:v>
                </c:pt>
                <c:pt idx="1">
                  <c:v>35.96</c:v>
                </c:pt>
                <c:pt idx="2">
                  <c:v>38.6</c:v>
                </c:pt>
                <c:pt idx="3">
                  <c:v>39.79</c:v>
                </c:pt>
                <c:pt idx="4">
                  <c:v>40.7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8467-4F49-864A-4729114F0D7A}"/>
            </c:ext>
          </c:extLst>
        </c:ser>
        <c:ser>
          <c:idx val="7"/>
          <c:order val="7"/>
          <c:tx>
            <c:strRef>
              <c:f>Kid!$I$5</c:f>
              <c:strCache>
                <c:ptCount val="1"/>
                <c:pt idx="0">
                  <c:v>01/07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I$6:$I$30</c:f>
              <c:numCache>
                <c:formatCode>General</c:formatCode>
                <c:ptCount val="25"/>
                <c:pt idx="0">
                  <c:v>1</c:v>
                </c:pt>
                <c:pt idx="1">
                  <c:v>24.14</c:v>
                </c:pt>
                <c:pt idx="2">
                  <c:v>25.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8467-4F49-864A-4729114F0D7A}"/>
            </c:ext>
          </c:extLst>
        </c:ser>
        <c:ser>
          <c:idx val="9"/>
          <c:order val="8"/>
          <c:tx>
            <c:strRef>
              <c:f>Kid!$K$5</c:f>
              <c:strCache>
                <c:ptCount val="1"/>
                <c:pt idx="0">
                  <c:v>08/08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K$6:$K$30</c:f>
              <c:numCache>
                <c:formatCode>General</c:formatCode>
                <c:ptCount val="25"/>
                <c:pt idx="0">
                  <c:v>1</c:v>
                </c:pt>
                <c:pt idx="1">
                  <c:v>27.2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8467-4F49-864A-4729114F0D7A}"/>
            </c:ext>
          </c:extLst>
        </c:ser>
        <c:ser>
          <c:idx val="10"/>
          <c:order val="9"/>
          <c:tx>
            <c:strRef>
              <c:f>Kid!$L$5</c:f>
              <c:strCache>
                <c:ptCount val="1"/>
                <c:pt idx="0">
                  <c:v>15/08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L$6:$L$30</c:f>
              <c:numCache>
                <c:formatCode>General</c:formatCode>
                <c:ptCount val="25"/>
                <c:pt idx="0">
                  <c:v>1</c:v>
                </c:pt>
                <c:pt idx="1">
                  <c:v>32.61</c:v>
                </c:pt>
                <c:pt idx="2">
                  <c:v>35.630000000000003</c:v>
                </c:pt>
                <c:pt idx="3">
                  <c:v>37.229999999999997</c:v>
                </c:pt>
                <c:pt idx="4">
                  <c:v>38.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8467-4F49-864A-4729114F0D7A}"/>
            </c:ext>
          </c:extLst>
        </c:ser>
        <c:ser>
          <c:idx val="11"/>
          <c:order val="10"/>
          <c:tx>
            <c:strRef>
              <c:f>Kid!$M$5</c:f>
              <c:strCache>
                <c:ptCount val="1"/>
                <c:pt idx="0">
                  <c:v>01/09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M$6:$M$30</c:f>
              <c:numCache>
                <c:formatCode>General</c:formatCode>
                <c:ptCount val="25"/>
                <c:pt idx="0">
                  <c:v>1</c:v>
                </c:pt>
                <c:pt idx="1">
                  <c:v>25.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8467-4F49-864A-4729114F0D7A}"/>
            </c:ext>
          </c:extLst>
        </c:ser>
        <c:ser>
          <c:idx val="12"/>
          <c:order val="11"/>
          <c:tx>
            <c:strRef>
              <c:f>Kid!$N$5</c:f>
              <c:strCache>
                <c:ptCount val="1"/>
                <c:pt idx="0">
                  <c:v>01/10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N$6:$N$30</c:f>
              <c:numCache>
                <c:formatCode>General</c:formatCode>
                <c:ptCount val="25"/>
                <c:pt idx="0">
                  <c:v>1</c:v>
                </c:pt>
                <c:pt idx="1">
                  <c:v>26.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8467-4F49-864A-4729114F0D7A}"/>
            </c:ext>
          </c:extLst>
        </c:ser>
        <c:ser>
          <c:idx val="13"/>
          <c:order val="12"/>
          <c:tx>
            <c:strRef>
              <c:f>Kid!$O$5</c:f>
              <c:strCache>
                <c:ptCount val="1"/>
                <c:pt idx="0">
                  <c:v>01/11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O$6:$O$30</c:f>
              <c:numCache>
                <c:formatCode>General</c:formatCode>
                <c:ptCount val="25"/>
                <c:pt idx="0">
                  <c:v>1</c:v>
                </c:pt>
                <c:pt idx="1">
                  <c:v>33.479999999999997</c:v>
                </c:pt>
                <c:pt idx="2">
                  <c:v>35.36</c:v>
                </c:pt>
                <c:pt idx="3">
                  <c:v>35.93</c:v>
                </c:pt>
                <c:pt idx="4">
                  <c:v>36.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8467-4F49-864A-4729114F0D7A}"/>
            </c:ext>
          </c:extLst>
        </c:ser>
        <c:ser>
          <c:idx val="14"/>
          <c:order val="13"/>
          <c:tx>
            <c:strRef>
              <c:f>Kid!$P$5</c:f>
              <c:strCache>
                <c:ptCount val="1"/>
                <c:pt idx="0">
                  <c:v>01/11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P$6:$P$30</c:f>
              <c:numCache>
                <c:formatCode>General</c:formatCode>
                <c:ptCount val="25"/>
                <c:pt idx="0">
                  <c:v>1</c:v>
                </c:pt>
                <c:pt idx="1">
                  <c:v>27.48</c:v>
                </c:pt>
                <c:pt idx="2">
                  <c:v>29.4</c:v>
                </c:pt>
                <c:pt idx="3">
                  <c:v>29.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8467-4F49-864A-4729114F0D7A}"/>
            </c:ext>
          </c:extLst>
        </c:ser>
        <c:ser>
          <c:idx val="15"/>
          <c:order val="14"/>
          <c:tx>
            <c:strRef>
              <c:f>Kid!$Q$5</c:f>
              <c:strCache>
                <c:ptCount val="1"/>
                <c:pt idx="0">
                  <c:v>01/12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Q$6:$Q$30</c:f>
              <c:numCache>
                <c:formatCode>General</c:formatCode>
                <c:ptCount val="25"/>
                <c:pt idx="0">
                  <c:v>1</c:v>
                </c:pt>
                <c:pt idx="1">
                  <c:v>19.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8467-4F49-864A-4729114F0D7A}"/>
            </c:ext>
          </c:extLst>
        </c:ser>
        <c:ser>
          <c:idx val="16"/>
          <c:order val="15"/>
          <c:tx>
            <c:strRef>
              <c:f>Kid!$R$5</c:f>
              <c:strCache>
                <c:ptCount val="1"/>
                <c:pt idx="0">
                  <c:v>01/12/2013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R$6:$R$30</c:f>
              <c:numCache>
                <c:formatCode>General</c:formatCode>
                <c:ptCount val="25"/>
                <c:pt idx="0">
                  <c:v>1</c:v>
                </c:pt>
                <c:pt idx="1">
                  <c:v>32.54</c:v>
                </c:pt>
                <c:pt idx="2">
                  <c:v>34.14</c:v>
                </c:pt>
                <c:pt idx="3">
                  <c:v>34.9</c:v>
                </c:pt>
                <c:pt idx="4">
                  <c:v>35.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8467-4F49-864A-4729114F0D7A}"/>
            </c:ext>
          </c:extLst>
        </c:ser>
        <c:ser>
          <c:idx val="17"/>
          <c:order val="16"/>
          <c:tx>
            <c:strRef>
              <c:f>Kid!$S$5</c:f>
              <c:strCache>
                <c:ptCount val="1"/>
                <c:pt idx="0">
                  <c:v>01/01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S$6:$S$30</c:f>
              <c:numCache>
                <c:formatCode>General</c:formatCode>
                <c:ptCount val="25"/>
                <c:pt idx="0">
                  <c:v>1</c:v>
                </c:pt>
                <c:pt idx="1">
                  <c:v>35.08</c:v>
                </c:pt>
                <c:pt idx="2">
                  <c:v>36.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8467-4F49-864A-4729114F0D7A}"/>
            </c:ext>
          </c:extLst>
        </c:ser>
        <c:ser>
          <c:idx val="18"/>
          <c:order val="17"/>
          <c:tx>
            <c:strRef>
              <c:f>Kid!$T$5</c:f>
              <c:strCache>
                <c:ptCount val="1"/>
                <c:pt idx="0">
                  <c:v>01/01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T$6:$T$30</c:f>
              <c:numCache>
                <c:formatCode>General</c:formatCode>
                <c:ptCount val="25"/>
                <c:pt idx="0">
                  <c:v>1</c:v>
                </c:pt>
                <c:pt idx="1">
                  <c:v>33.89</c:v>
                </c:pt>
                <c:pt idx="2">
                  <c:v>36.54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8467-4F49-864A-4729114F0D7A}"/>
            </c:ext>
          </c:extLst>
        </c:ser>
        <c:ser>
          <c:idx val="19"/>
          <c:order val="18"/>
          <c:tx>
            <c:strRef>
              <c:f>Kid!$U$5</c:f>
              <c:strCache>
                <c:ptCount val="1"/>
                <c:pt idx="0">
                  <c:v>01/02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U$6:$U$30</c:f>
              <c:numCache>
                <c:formatCode>General</c:formatCode>
                <c:ptCount val="25"/>
                <c:pt idx="0">
                  <c:v>1</c:v>
                </c:pt>
                <c:pt idx="1">
                  <c:v>31.7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2-8467-4F49-864A-4729114F0D7A}"/>
            </c:ext>
          </c:extLst>
        </c:ser>
        <c:ser>
          <c:idx val="20"/>
          <c:order val="19"/>
          <c:tx>
            <c:strRef>
              <c:f>Kid!$V$5</c:f>
              <c:strCache>
                <c:ptCount val="1"/>
                <c:pt idx="0">
                  <c:v>01/02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V$6:$V$30</c:f>
              <c:numCache>
                <c:formatCode>General</c:formatCode>
                <c:ptCount val="25"/>
                <c:pt idx="0">
                  <c:v>1</c:v>
                </c:pt>
                <c:pt idx="1">
                  <c:v>34.04</c:v>
                </c:pt>
                <c:pt idx="2">
                  <c:v>37.36</c:v>
                </c:pt>
                <c:pt idx="3">
                  <c:v>38.9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3-8467-4F49-864A-4729114F0D7A}"/>
            </c:ext>
          </c:extLst>
        </c:ser>
        <c:ser>
          <c:idx val="21"/>
          <c:order val="20"/>
          <c:tx>
            <c:strRef>
              <c:f>Kid!$W$5</c:f>
              <c:strCache>
                <c:ptCount val="1"/>
                <c:pt idx="0">
                  <c:v>08/02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W$6:$W$30</c:f>
              <c:numCache>
                <c:formatCode>General</c:formatCode>
                <c:ptCount val="25"/>
                <c:pt idx="0">
                  <c:v>1</c:v>
                </c:pt>
                <c:pt idx="1">
                  <c:v>24.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4-8467-4F49-864A-4729114F0D7A}"/>
            </c:ext>
          </c:extLst>
        </c:ser>
        <c:ser>
          <c:idx val="22"/>
          <c:order val="21"/>
          <c:tx>
            <c:strRef>
              <c:f>Kid!$X$5</c:f>
              <c:strCache>
                <c:ptCount val="1"/>
                <c:pt idx="0">
                  <c:v>15/02/2014</c:v>
                </c:pt>
              </c:strCache>
            </c:strRef>
          </c:tx>
          <c:marker>
            <c:symbol val="none"/>
          </c:marker>
          <c:xVal>
            <c:numRef>
              <c:f>Kid!$A$6:$A$30</c:f>
              <c:numCache>
                <c:formatCode>General</c:formatCode>
                <c:ptCount val="25"/>
                <c:pt idx="0">
                  <c:v>1</c:v>
                </c:pt>
                <c:pt idx="1">
                  <c:v>2565</c:v>
                </c:pt>
                <c:pt idx="2">
                  <c:v>5129</c:v>
                </c:pt>
                <c:pt idx="3">
                  <c:v>7693</c:v>
                </c:pt>
                <c:pt idx="4">
                  <c:v>10257</c:v>
                </c:pt>
                <c:pt idx="5">
                  <c:v>12821</c:v>
                </c:pt>
                <c:pt idx="6">
                  <c:v>15385</c:v>
                </c:pt>
                <c:pt idx="7">
                  <c:v>17950</c:v>
                </c:pt>
                <c:pt idx="8">
                  <c:v>20514</c:v>
                </c:pt>
                <c:pt idx="9">
                  <c:v>23078</c:v>
                </c:pt>
                <c:pt idx="10">
                  <c:v>25642</c:v>
                </c:pt>
                <c:pt idx="11">
                  <c:v>28206</c:v>
                </c:pt>
                <c:pt idx="12">
                  <c:v>30770</c:v>
                </c:pt>
                <c:pt idx="13">
                  <c:v>33334</c:v>
                </c:pt>
                <c:pt idx="14">
                  <c:v>35898</c:v>
                </c:pt>
                <c:pt idx="15">
                  <c:v>38462</c:v>
                </c:pt>
                <c:pt idx="16">
                  <c:v>41026</c:v>
                </c:pt>
                <c:pt idx="17">
                  <c:v>43590</c:v>
                </c:pt>
                <c:pt idx="18">
                  <c:v>46154</c:v>
                </c:pt>
                <c:pt idx="19">
                  <c:v>48718</c:v>
                </c:pt>
                <c:pt idx="20">
                  <c:v>51283</c:v>
                </c:pt>
                <c:pt idx="21">
                  <c:v>53847</c:v>
                </c:pt>
                <c:pt idx="22">
                  <c:v>56411</c:v>
                </c:pt>
                <c:pt idx="23">
                  <c:v>58975</c:v>
                </c:pt>
                <c:pt idx="24">
                  <c:v>61539</c:v>
                </c:pt>
              </c:numCache>
            </c:numRef>
          </c:xVal>
          <c:yVal>
            <c:numRef>
              <c:f>Kid!$X$6:$X$30</c:f>
              <c:numCache>
                <c:formatCode>General</c:formatCode>
                <c:ptCount val="25"/>
                <c:pt idx="0">
                  <c:v>1</c:v>
                </c:pt>
                <c:pt idx="1">
                  <c:v>25.61</c:v>
                </c:pt>
                <c:pt idx="2">
                  <c:v>27.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5-8467-4F49-864A-4729114F0D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2481920"/>
        <c:axId val="232484224"/>
      </c:scatterChart>
      <c:valAx>
        <c:axId val="232481920"/>
        <c:scaling>
          <c:orientation val="minMax"/>
          <c:max val="200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b="0" dirty="0"/>
                  <a:t>Number</a:t>
                </a:r>
                <a:r>
                  <a:rPr lang="en-US" b="0" baseline="0" dirty="0"/>
                  <a:t> of r</a:t>
                </a:r>
                <a:r>
                  <a:rPr lang="en-US" b="0" dirty="0"/>
                  <a:t>eads</a:t>
                </a:r>
              </a:p>
            </c:rich>
          </c:tx>
          <c:layout>
            <c:manualLayout>
              <c:xMode val="edge"/>
              <c:yMode val="edge"/>
              <c:x val="0.22987387295498787"/>
              <c:y val="0.8783666653440582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/>
        </c:spPr>
        <c:crossAx val="232484224"/>
        <c:crosses val="autoZero"/>
        <c:crossBetween val="midCat"/>
      </c:valAx>
      <c:valAx>
        <c:axId val="232484224"/>
        <c:scaling>
          <c:orientation val="minMax"/>
        </c:scaling>
        <c:delete val="0"/>
        <c:axPos val="l"/>
        <c:majorGridlines>
          <c:spPr>
            <a:ln>
              <a:prstDash val="dash"/>
            </a:ln>
          </c:spPr>
        </c:majorGridlines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Number of  OTU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3248192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7127623315819419"/>
          <c:y val="9.6867625530312626E-2"/>
          <c:w val="0.21652105696223758"/>
          <c:h val="0.70560451581281058"/>
        </c:manualLayout>
      </c:layout>
      <c:overlay val="0"/>
      <c:spPr>
        <a:solidFill>
          <a:schemeClr val="bg1"/>
        </a:solidFill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>
      <a:noFill/>
    </a:ln>
  </c:sp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6916849542198"/>
          <c:y val="0.11313728677531308"/>
          <c:w val="0.8001527704632353"/>
          <c:h val="0.7800373364162726"/>
        </c:manualLayout>
      </c:layout>
      <c:scatterChart>
        <c:scatterStyle val="lineMarker"/>
        <c:varyColors val="0"/>
        <c:ser>
          <c:idx val="1"/>
          <c:order val="0"/>
          <c:tx>
            <c:v>El-Bireh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PcOA UniBac'!$C$70:$C$124</c:f>
              <c:numCache>
                <c:formatCode>General</c:formatCode>
                <c:ptCount val="55"/>
                <c:pt idx="0">
                  <c:v>-0.82023999999999997</c:v>
                </c:pt>
                <c:pt idx="1">
                  <c:v>-0.84331999999999996</c:v>
                </c:pt>
                <c:pt idx="2">
                  <c:v>-0.71909999999999996</c:v>
                </c:pt>
                <c:pt idx="3">
                  <c:v>-0.72204999999999997</c:v>
                </c:pt>
                <c:pt idx="4">
                  <c:v>-0.47988999999999998</c:v>
                </c:pt>
                <c:pt idx="5">
                  <c:v>-0.44991999999999999</c:v>
                </c:pt>
                <c:pt idx="6">
                  <c:v>-0.35826000000000002</c:v>
                </c:pt>
                <c:pt idx="7">
                  <c:v>-0.47393000000000002</c:v>
                </c:pt>
                <c:pt idx="8">
                  <c:v>-0.60389000000000004</c:v>
                </c:pt>
                <c:pt idx="9">
                  <c:v>-0.52951999999999999</c:v>
                </c:pt>
                <c:pt idx="10">
                  <c:v>-0.69062999999999997</c:v>
                </c:pt>
                <c:pt idx="11">
                  <c:v>-0.54261000000000004</c:v>
                </c:pt>
                <c:pt idx="12">
                  <c:v>-0.43787999999999999</c:v>
                </c:pt>
                <c:pt idx="13">
                  <c:v>-0.53025</c:v>
                </c:pt>
                <c:pt idx="14">
                  <c:v>-0.54303999999999997</c:v>
                </c:pt>
                <c:pt idx="15">
                  <c:v>-0.45108999999999999</c:v>
                </c:pt>
                <c:pt idx="16">
                  <c:v>-0.57752999999999999</c:v>
                </c:pt>
                <c:pt idx="17">
                  <c:v>-0.50665000000000004</c:v>
                </c:pt>
                <c:pt idx="18">
                  <c:v>-0.40716999999999998</c:v>
                </c:pt>
                <c:pt idx="19">
                  <c:v>-0.29610999999999998</c:v>
                </c:pt>
                <c:pt idx="20">
                  <c:v>-0.27037</c:v>
                </c:pt>
                <c:pt idx="21">
                  <c:v>-0.53698999999999997</c:v>
                </c:pt>
                <c:pt idx="22">
                  <c:v>-0.52059999999999995</c:v>
                </c:pt>
                <c:pt idx="23">
                  <c:v>-0.58923000000000003</c:v>
                </c:pt>
                <c:pt idx="24">
                  <c:v>-0.54793000000000003</c:v>
                </c:pt>
                <c:pt idx="25">
                  <c:v>-0.49160999999999999</c:v>
                </c:pt>
                <c:pt idx="26">
                  <c:v>-0.41055000000000003</c:v>
                </c:pt>
                <c:pt idx="27">
                  <c:v>-0.40849000000000002</c:v>
                </c:pt>
                <c:pt idx="28">
                  <c:v>-0.55344000000000004</c:v>
                </c:pt>
                <c:pt idx="29">
                  <c:v>8.9569999999999997E-2</c:v>
                </c:pt>
                <c:pt idx="30">
                  <c:v>0.24718000000000001</c:v>
                </c:pt>
                <c:pt idx="31">
                  <c:v>-2.1749999999999999E-2</c:v>
                </c:pt>
                <c:pt idx="32">
                  <c:v>5.64E-3</c:v>
                </c:pt>
                <c:pt idx="33">
                  <c:v>0.18890000000000001</c:v>
                </c:pt>
                <c:pt idx="34">
                  <c:v>0.18436</c:v>
                </c:pt>
                <c:pt idx="35">
                  <c:v>0.30352000000000001</c:v>
                </c:pt>
                <c:pt idx="36">
                  <c:v>0.30951000000000001</c:v>
                </c:pt>
                <c:pt idx="37">
                  <c:v>0.66949000000000003</c:v>
                </c:pt>
                <c:pt idx="38">
                  <c:v>0.64668999999999999</c:v>
                </c:pt>
                <c:pt idx="39">
                  <c:v>1.6244799999999999</c:v>
                </c:pt>
                <c:pt idx="40">
                  <c:v>1.99851</c:v>
                </c:pt>
                <c:pt idx="41">
                  <c:v>2.9600000000000001E-2</c:v>
                </c:pt>
                <c:pt idx="42">
                  <c:v>0.4229</c:v>
                </c:pt>
                <c:pt idx="43">
                  <c:v>1.60632</c:v>
                </c:pt>
                <c:pt idx="44">
                  <c:v>2.5556800000000002</c:v>
                </c:pt>
                <c:pt idx="45">
                  <c:v>1.3793599999999999</c:v>
                </c:pt>
                <c:pt idx="46">
                  <c:v>1.25302</c:v>
                </c:pt>
                <c:pt idx="47">
                  <c:v>1.0815300000000001</c:v>
                </c:pt>
                <c:pt idx="48">
                  <c:v>0.58282</c:v>
                </c:pt>
                <c:pt idx="49">
                  <c:v>6.2100000000000002E-3</c:v>
                </c:pt>
                <c:pt idx="50">
                  <c:v>0.20510999999999999</c:v>
                </c:pt>
                <c:pt idx="51">
                  <c:v>-0.13059999999999999</c:v>
                </c:pt>
                <c:pt idx="52">
                  <c:v>0.35579</c:v>
                </c:pt>
                <c:pt idx="53">
                  <c:v>0.60928000000000004</c:v>
                </c:pt>
                <c:pt idx="54">
                  <c:v>0.53286999999999995</c:v>
                </c:pt>
              </c:numCache>
            </c:numRef>
          </c:xVal>
          <c:yVal>
            <c:numRef>
              <c:f>'PcOA UniBac'!$D$70:$D$124</c:f>
              <c:numCache>
                <c:formatCode>General</c:formatCode>
                <c:ptCount val="55"/>
                <c:pt idx="0">
                  <c:v>-0.58720000000000006</c:v>
                </c:pt>
                <c:pt idx="1">
                  <c:v>-0.60272000000000003</c:v>
                </c:pt>
                <c:pt idx="2">
                  <c:v>-0.64488000000000001</c:v>
                </c:pt>
                <c:pt idx="3">
                  <c:v>-0.68150999999999995</c:v>
                </c:pt>
                <c:pt idx="4">
                  <c:v>-0.50631999999999999</c:v>
                </c:pt>
                <c:pt idx="5">
                  <c:v>-0.46643000000000001</c:v>
                </c:pt>
                <c:pt idx="6">
                  <c:v>-0.40401999999999999</c:v>
                </c:pt>
                <c:pt idx="7">
                  <c:v>-0.47852</c:v>
                </c:pt>
                <c:pt idx="8">
                  <c:v>-0.62580000000000002</c:v>
                </c:pt>
                <c:pt idx="9">
                  <c:v>-0.55730999999999997</c:v>
                </c:pt>
                <c:pt idx="10">
                  <c:v>-0.76841999999999999</c:v>
                </c:pt>
                <c:pt idx="11">
                  <c:v>-0.63173000000000001</c:v>
                </c:pt>
                <c:pt idx="12">
                  <c:v>-0.80140999999999996</c:v>
                </c:pt>
                <c:pt idx="13">
                  <c:v>-0.78876000000000002</c:v>
                </c:pt>
                <c:pt idx="14">
                  <c:v>-0.80737000000000003</c:v>
                </c:pt>
                <c:pt idx="15">
                  <c:v>-0.74246000000000001</c:v>
                </c:pt>
                <c:pt idx="16">
                  <c:v>-0.90586</c:v>
                </c:pt>
                <c:pt idx="17">
                  <c:v>-0.42368</c:v>
                </c:pt>
                <c:pt idx="18">
                  <c:v>-0.34670000000000001</c:v>
                </c:pt>
                <c:pt idx="19">
                  <c:v>-0.30008000000000001</c:v>
                </c:pt>
                <c:pt idx="20">
                  <c:v>-0.28797</c:v>
                </c:pt>
                <c:pt idx="21">
                  <c:v>-0.47644999999999998</c:v>
                </c:pt>
                <c:pt idx="22">
                  <c:v>-0.45773000000000003</c:v>
                </c:pt>
                <c:pt idx="23">
                  <c:v>-0.41293000000000002</c:v>
                </c:pt>
                <c:pt idx="24">
                  <c:v>-0.38052999999999998</c:v>
                </c:pt>
                <c:pt idx="25">
                  <c:v>-0.37313000000000002</c:v>
                </c:pt>
                <c:pt idx="26">
                  <c:v>-0.30060999999999999</c:v>
                </c:pt>
                <c:pt idx="27">
                  <c:v>-0.31032999999999999</c:v>
                </c:pt>
                <c:pt idx="28">
                  <c:v>-0.39240000000000003</c:v>
                </c:pt>
                <c:pt idx="29">
                  <c:v>-0.82157999999999998</c:v>
                </c:pt>
                <c:pt idx="30">
                  <c:v>-0.22042</c:v>
                </c:pt>
                <c:pt idx="31">
                  <c:v>-0.31997999999999999</c:v>
                </c:pt>
                <c:pt idx="32">
                  <c:v>-0.30342999999999998</c:v>
                </c:pt>
                <c:pt idx="33">
                  <c:v>-0.31425999999999998</c:v>
                </c:pt>
                <c:pt idx="34">
                  <c:v>-0.30026000000000003</c:v>
                </c:pt>
                <c:pt idx="35">
                  <c:v>-0.46800000000000003</c:v>
                </c:pt>
                <c:pt idx="36">
                  <c:v>-0.48376999999999998</c:v>
                </c:pt>
                <c:pt idx="37">
                  <c:v>-0.41832000000000003</c:v>
                </c:pt>
                <c:pt idx="38">
                  <c:v>-0.37187999999999999</c:v>
                </c:pt>
                <c:pt idx="39">
                  <c:v>0.33462999999999998</c:v>
                </c:pt>
                <c:pt idx="40">
                  <c:v>0.90100999999999998</c:v>
                </c:pt>
                <c:pt idx="41">
                  <c:v>-0.45690999999999998</c:v>
                </c:pt>
                <c:pt idx="42">
                  <c:v>-0.33673999999999998</c:v>
                </c:pt>
                <c:pt idx="43">
                  <c:v>1.1458999999999999</c:v>
                </c:pt>
                <c:pt idx="44">
                  <c:v>1.5607899999999999</c:v>
                </c:pt>
                <c:pt idx="45">
                  <c:v>2.3479399999999999</c:v>
                </c:pt>
                <c:pt idx="46">
                  <c:v>2.1963300000000001</c:v>
                </c:pt>
                <c:pt idx="47">
                  <c:v>2.09396</c:v>
                </c:pt>
                <c:pt idx="48">
                  <c:v>0.72350999999999999</c:v>
                </c:pt>
                <c:pt idx="49">
                  <c:v>-1.34571</c:v>
                </c:pt>
                <c:pt idx="50">
                  <c:v>-0.98133999999999999</c:v>
                </c:pt>
                <c:pt idx="51">
                  <c:v>-0.18779000000000001</c:v>
                </c:pt>
                <c:pt idx="52">
                  <c:v>1.7409999999999998E-2</c:v>
                </c:pt>
                <c:pt idx="53">
                  <c:v>3.1550000000000002E-2</c:v>
                </c:pt>
                <c:pt idx="54">
                  <c:v>-7.210000000000000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8BE-4543-904F-A2BB56B8A0B2}"/>
            </c:ext>
          </c:extLst>
        </c:ser>
        <c:ser>
          <c:idx val="2"/>
          <c:order val="1"/>
          <c:tx>
            <c:v>Kidr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PcOA UniBac'!$C$125:$C$156</c:f>
              <c:numCache>
                <c:formatCode>General</c:formatCode>
                <c:ptCount val="32"/>
                <c:pt idx="0">
                  <c:v>1.4278500000000001</c:v>
                </c:pt>
                <c:pt idx="1">
                  <c:v>1.4215500000000001</c:v>
                </c:pt>
                <c:pt idx="2">
                  <c:v>1.31511</c:v>
                </c:pt>
                <c:pt idx="3">
                  <c:v>1.3785700000000001</c:v>
                </c:pt>
                <c:pt idx="4">
                  <c:v>1.5732299999999999</c:v>
                </c:pt>
                <c:pt idx="5">
                  <c:v>1.50512</c:v>
                </c:pt>
                <c:pt idx="6">
                  <c:v>1.4103699999999999</c:v>
                </c:pt>
                <c:pt idx="7">
                  <c:v>1.3418300000000001</c:v>
                </c:pt>
                <c:pt idx="8">
                  <c:v>1.4459599999999999</c:v>
                </c:pt>
                <c:pt idx="9">
                  <c:v>1.3594200000000001</c:v>
                </c:pt>
                <c:pt idx="10">
                  <c:v>1.5621400000000001</c:v>
                </c:pt>
                <c:pt idx="11">
                  <c:v>1.5351300000000001</c:v>
                </c:pt>
                <c:pt idx="12">
                  <c:v>1.5264599999999999</c:v>
                </c:pt>
                <c:pt idx="13">
                  <c:v>1.44364</c:v>
                </c:pt>
                <c:pt idx="14">
                  <c:v>1.6549499999999999</c:v>
                </c:pt>
                <c:pt idx="15">
                  <c:v>1.409</c:v>
                </c:pt>
                <c:pt idx="16">
                  <c:v>1.38147</c:v>
                </c:pt>
                <c:pt idx="17">
                  <c:v>1.31718</c:v>
                </c:pt>
                <c:pt idx="18">
                  <c:v>1.33083</c:v>
                </c:pt>
                <c:pt idx="19">
                  <c:v>1.2838499999999999</c:v>
                </c:pt>
                <c:pt idx="20">
                  <c:v>1.1303300000000001</c:v>
                </c:pt>
                <c:pt idx="21">
                  <c:v>1.0799099999999999</c:v>
                </c:pt>
                <c:pt idx="22">
                  <c:v>1.35568</c:v>
                </c:pt>
                <c:pt idx="23">
                  <c:v>1.2549300000000001</c:v>
                </c:pt>
                <c:pt idx="24">
                  <c:v>1.28159</c:v>
                </c:pt>
                <c:pt idx="25">
                  <c:v>1.2055499999999999</c:v>
                </c:pt>
                <c:pt idx="26">
                  <c:v>1.20736</c:v>
                </c:pt>
                <c:pt idx="27">
                  <c:v>1.2969200000000001</c:v>
                </c:pt>
                <c:pt idx="28">
                  <c:v>1.24804</c:v>
                </c:pt>
                <c:pt idx="29">
                  <c:v>1.3291599999999999</c:v>
                </c:pt>
                <c:pt idx="30">
                  <c:v>1.2422200000000001</c:v>
                </c:pt>
                <c:pt idx="31">
                  <c:v>1.20499</c:v>
                </c:pt>
              </c:numCache>
            </c:numRef>
          </c:xVal>
          <c:yVal>
            <c:numRef>
              <c:f>'PcOA UniBac'!$D$125:$D$156</c:f>
              <c:numCache>
                <c:formatCode>General</c:formatCode>
                <c:ptCount val="32"/>
                <c:pt idx="0">
                  <c:v>0.31574999999999998</c:v>
                </c:pt>
                <c:pt idx="1">
                  <c:v>0.30268</c:v>
                </c:pt>
                <c:pt idx="2">
                  <c:v>0.13056999999999999</c:v>
                </c:pt>
                <c:pt idx="3">
                  <c:v>0.14487</c:v>
                </c:pt>
                <c:pt idx="4">
                  <c:v>4.7649999999999998E-2</c:v>
                </c:pt>
                <c:pt idx="5">
                  <c:v>3.8539999999999998E-2</c:v>
                </c:pt>
                <c:pt idx="6">
                  <c:v>4.2970000000000001E-2</c:v>
                </c:pt>
                <c:pt idx="7">
                  <c:v>3.0790000000000001E-2</c:v>
                </c:pt>
                <c:pt idx="8">
                  <c:v>1.511E-2</c:v>
                </c:pt>
                <c:pt idx="9">
                  <c:v>2.4969999999999999E-2</c:v>
                </c:pt>
                <c:pt idx="10">
                  <c:v>7.1500000000000001E-3</c:v>
                </c:pt>
                <c:pt idx="11">
                  <c:v>-4.1399999999999996E-3</c:v>
                </c:pt>
                <c:pt idx="12">
                  <c:v>8.6300000000000005E-3</c:v>
                </c:pt>
                <c:pt idx="13">
                  <c:v>7.9900000000000006E-3</c:v>
                </c:pt>
                <c:pt idx="14">
                  <c:v>0.42285</c:v>
                </c:pt>
                <c:pt idx="15">
                  <c:v>7.8670000000000004E-2</c:v>
                </c:pt>
                <c:pt idx="16">
                  <c:v>9.9959999999999993E-2</c:v>
                </c:pt>
                <c:pt idx="17">
                  <c:v>7.4800000000000005E-2</c:v>
                </c:pt>
                <c:pt idx="18">
                  <c:v>0.20763000000000001</c:v>
                </c:pt>
                <c:pt idx="19">
                  <c:v>0.18051</c:v>
                </c:pt>
                <c:pt idx="20">
                  <c:v>0.62017</c:v>
                </c:pt>
                <c:pt idx="21">
                  <c:v>0.59299999999999997</c:v>
                </c:pt>
                <c:pt idx="22">
                  <c:v>0.35547000000000001</c:v>
                </c:pt>
                <c:pt idx="23">
                  <c:v>0.33912999999999999</c:v>
                </c:pt>
                <c:pt idx="24">
                  <c:v>0.34075</c:v>
                </c:pt>
                <c:pt idx="25">
                  <c:v>0.31498999999999999</c:v>
                </c:pt>
                <c:pt idx="26">
                  <c:v>0.44320999999999999</c:v>
                </c:pt>
                <c:pt idx="27">
                  <c:v>0.38159999999999999</c:v>
                </c:pt>
                <c:pt idx="28">
                  <c:v>0.38118999999999997</c:v>
                </c:pt>
                <c:pt idx="29">
                  <c:v>0.35927999999999999</c:v>
                </c:pt>
                <c:pt idx="30">
                  <c:v>0.32600000000000001</c:v>
                </c:pt>
                <c:pt idx="31">
                  <c:v>0.43906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8BE-4543-904F-A2BB56B8A0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275392"/>
        <c:axId val="85269120"/>
      </c:scatterChart>
      <c:valAx>
        <c:axId val="85275392"/>
        <c:scaling>
          <c:orientation val="maxMin"/>
          <c:min val="-1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XIS 1</a:t>
                </a:r>
              </a:p>
            </c:rich>
          </c:tx>
          <c:layout>
            <c:manualLayout>
              <c:xMode val="edge"/>
              <c:yMode val="edge"/>
              <c:x val="0.44551448636199747"/>
              <c:y val="0.905992341733905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269120"/>
        <c:crosses val="autoZero"/>
        <c:crossBetween val="midCat"/>
      </c:valAx>
      <c:valAx>
        <c:axId val="85269120"/>
        <c:scaling>
          <c:orientation val="minMax"/>
          <c:max val="2.5"/>
          <c:min val="-1.5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XIS 2</a:t>
                </a:r>
              </a:p>
            </c:rich>
          </c:tx>
          <c:layout>
            <c:manualLayout>
              <c:xMode val="edge"/>
              <c:yMode val="edge"/>
              <c:x val="1.8918416512069786E-2"/>
              <c:y val="0.427989264140201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27539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2784373668395436E-2"/>
          <c:y val="0.79356575473263447"/>
          <c:w val="0.42814881722469178"/>
          <c:h val="0.106086958423327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001029691628121E-2"/>
          <c:y val="0.1251423208827"/>
          <c:w val="0.85710733168859587"/>
          <c:h val="0.79979812477621604"/>
        </c:manualLayout>
      </c:layout>
      <c:scatterChart>
        <c:scatterStyle val="lineMarker"/>
        <c:varyColors val="0"/>
        <c:ser>
          <c:idx val="2"/>
          <c:order val="0"/>
          <c:tx>
            <c:v>Kidron Summer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lt1"/>
              </a:solidFill>
              <a:ln w="38100">
                <a:solidFill>
                  <a:schemeClr val="accent3">
                    <a:alpha val="60000"/>
                  </a:schemeClr>
                </a:solidFill>
              </a:ln>
              <a:effectLst/>
            </c:spPr>
          </c:marker>
          <c:xVal>
            <c:numRef>
              <c:f>'PcOA UniBac'!$C$133:$C$138</c:f>
              <c:numCache>
                <c:formatCode>General</c:formatCode>
                <c:ptCount val="6"/>
                <c:pt idx="0">
                  <c:v>1.4459599999999999</c:v>
                </c:pt>
                <c:pt idx="1">
                  <c:v>1.3594200000000001</c:v>
                </c:pt>
                <c:pt idx="2">
                  <c:v>1.5621400000000001</c:v>
                </c:pt>
                <c:pt idx="3">
                  <c:v>1.5351300000000001</c:v>
                </c:pt>
                <c:pt idx="4">
                  <c:v>1.5264599999999999</c:v>
                </c:pt>
                <c:pt idx="5">
                  <c:v>1.44364</c:v>
                </c:pt>
              </c:numCache>
            </c:numRef>
          </c:xVal>
          <c:yVal>
            <c:numRef>
              <c:f>'PcOA UniBac'!$D$133:$D$138</c:f>
              <c:numCache>
                <c:formatCode>General</c:formatCode>
                <c:ptCount val="6"/>
                <c:pt idx="0">
                  <c:v>1.511E-2</c:v>
                </c:pt>
                <c:pt idx="1">
                  <c:v>2.4969999999999999E-2</c:v>
                </c:pt>
                <c:pt idx="2">
                  <c:v>7.1500000000000001E-3</c:v>
                </c:pt>
                <c:pt idx="3">
                  <c:v>-4.1399999999999996E-3</c:v>
                </c:pt>
                <c:pt idx="4">
                  <c:v>8.6300000000000005E-3</c:v>
                </c:pt>
                <c:pt idx="5">
                  <c:v>7.9900000000000006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070-4B6E-93C9-B03FDF06B598}"/>
            </c:ext>
          </c:extLst>
        </c:ser>
        <c:ser>
          <c:idx val="6"/>
          <c:order val="1"/>
          <c:tx>
            <c:v>Kidron Winter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lt1"/>
              </a:solidFill>
              <a:ln w="38100">
                <a:solidFill>
                  <a:schemeClr val="accent1">
                    <a:lumMod val="60000"/>
                    <a:alpha val="60000"/>
                  </a:schemeClr>
                </a:solidFill>
              </a:ln>
              <a:effectLst/>
            </c:spPr>
          </c:marker>
          <c:xVal>
            <c:numRef>
              <c:f>'PcOA UniBac'!$C$148:$C$155</c:f>
              <c:numCache>
                <c:formatCode>General</c:formatCode>
                <c:ptCount val="8"/>
                <c:pt idx="0">
                  <c:v>1.2549300000000001</c:v>
                </c:pt>
                <c:pt idx="1">
                  <c:v>1.28159</c:v>
                </c:pt>
                <c:pt idx="2">
                  <c:v>1.2055499999999999</c:v>
                </c:pt>
                <c:pt idx="3">
                  <c:v>1.20736</c:v>
                </c:pt>
                <c:pt idx="4">
                  <c:v>1.2969200000000001</c:v>
                </c:pt>
                <c:pt idx="5">
                  <c:v>1.24804</c:v>
                </c:pt>
                <c:pt idx="6">
                  <c:v>1.3291599999999999</c:v>
                </c:pt>
                <c:pt idx="7">
                  <c:v>1.2422200000000001</c:v>
                </c:pt>
              </c:numCache>
            </c:numRef>
          </c:xVal>
          <c:yVal>
            <c:numRef>
              <c:f>'PcOA UniBac'!$D$148:$D$155</c:f>
              <c:numCache>
                <c:formatCode>General</c:formatCode>
                <c:ptCount val="8"/>
                <c:pt idx="0">
                  <c:v>0.33912999999999999</c:v>
                </c:pt>
                <c:pt idx="1">
                  <c:v>0.34075</c:v>
                </c:pt>
                <c:pt idx="2">
                  <c:v>0.31498999999999999</c:v>
                </c:pt>
                <c:pt idx="3">
                  <c:v>0.44320999999999999</c:v>
                </c:pt>
                <c:pt idx="4">
                  <c:v>0.38159999999999999</c:v>
                </c:pt>
                <c:pt idx="5">
                  <c:v>0.38118999999999997</c:v>
                </c:pt>
                <c:pt idx="6">
                  <c:v>0.35927999999999999</c:v>
                </c:pt>
                <c:pt idx="7">
                  <c:v>0.32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070-4B6E-93C9-B03FDF06B5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829632"/>
        <c:axId val="115713152"/>
      </c:scatterChart>
      <c:valAx>
        <c:axId val="161829632"/>
        <c:scaling>
          <c:orientation val="maxMin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xis 1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one"/>
        <c:spPr>
          <a:noFill/>
          <a:ln>
            <a:solidFill>
              <a:schemeClr val="tx1">
                <a:lumMod val="25000"/>
                <a:lumOff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spc="2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5713152"/>
        <c:crosses val="autoZero"/>
        <c:crossBetween val="midCat"/>
      </c:valAx>
      <c:valAx>
        <c:axId val="115713152"/>
        <c:scaling>
          <c:orientation val="minMax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xis 2</a:t>
                </a:r>
              </a:p>
            </c:rich>
          </c:tx>
          <c:layout>
            <c:manualLayout>
              <c:xMode val="edge"/>
              <c:yMode val="edge"/>
              <c:x val="6.0155428454178837E-3"/>
              <c:y val="0.37871015800895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one"/>
        <c:spPr>
          <a:noFill/>
          <a:ln>
            <a:solidFill>
              <a:schemeClr val="tx1">
                <a:lumMod val="25000"/>
                <a:lumOff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spc="2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182963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5242234408971232E-2"/>
          <c:y val="4.5952873290903504E-3"/>
          <c:w val="0.83121802025934677"/>
          <c:h val="0.1115837889518359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>
        <a:solidFill>
          <a:schemeClr val="tx1">
            <a:lumMod val="15000"/>
            <a:lumOff val="85000"/>
          </a:schemeClr>
        </a:solidFill>
      </a:ln>
    </cs:spPr>
    <cs:defRPr sz="1197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>
            <a:alpha val="60000"/>
          </a:schemeClr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38100">
        <a:solidFill>
          <a:schemeClr val="phClr">
            <a:alpha val="60000"/>
          </a:schemeClr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>
        <a:solidFill>
          <a:schemeClr val="tx1">
            <a:lumMod val="15000"/>
            <a:lumOff val="85000"/>
          </a:schemeClr>
        </a:solidFill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128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>
        <a:solidFill>
          <a:schemeClr val="tx1">
            <a:lumMod val="25000"/>
            <a:lumOff val="75000"/>
          </a:schemeClr>
        </a:solidFill>
      </a:ln>
    </cs:spPr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343</cdr:x>
      <cdr:y>0.21272</cdr:y>
    </cdr:from>
    <cdr:to>
      <cdr:x>0.67396</cdr:x>
      <cdr:y>0.3521</cdr:y>
    </cdr:to>
    <cdr:sp macro="" textlink="">
      <cdr:nvSpPr>
        <cdr:cNvPr id="2" name="TextBox 34">
          <a:extLst xmlns:a="http://schemas.openxmlformats.org/drawingml/2006/main">
            <a:ext uri="{FF2B5EF4-FFF2-40B4-BE49-F238E27FC236}">
              <a16:creationId xmlns:a16="http://schemas.microsoft.com/office/drawing/2014/main" id="{E96BE0E2-7222-4742-A9DC-510BBFA77652}"/>
            </a:ext>
          </a:extLst>
        </cdr:cNvPr>
        <cdr:cNvSpPr txBox="1"/>
      </cdr:nvSpPr>
      <cdr:spPr>
        <a:xfrm xmlns:a="http://schemas.openxmlformats.org/drawingml/2006/main">
          <a:off x="463233" y="606131"/>
          <a:ext cx="1447090" cy="39714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 dirty="0"/>
            <a:t>Coverage = 0.980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2823</cdr:x>
      <cdr:y>0.2391</cdr:y>
    </cdr:from>
    <cdr:to>
      <cdr:x>0.67961</cdr:x>
      <cdr:y>0.37267</cdr:y>
    </cdr:to>
    <cdr:sp macro="" textlink="">
      <cdr:nvSpPr>
        <cdr:cNvPr id="2" name="TextBox 27">
          <a:extLst xmlns:a="http://schemas.openxmlformats.org/drawingml/2006/main">
            <a:ext uri="{FF2B5EF4-FFF2-40B4-BE49-F238E27FC236}">
              <a16:creationId xmlns:a16="http://schemas.microsoft.com/office/drawing/2014/main" id="{876F3F65-FD6F-46AF-8628-454A9BF1D447}"/>
            </a:ext>
          </a:extLst>
        </cdr:cNvPr>
        <cdr:cNvSpPr txBox="1"/>
      </cdr:nvSpPr>
      <cdr:spPr>
        <a:xfrm xmlns:a="http://schemas.openxmlformats.org/drawingml/2006/main">
          <a:off x="332917" y="616339"/>
          <a:ext cx="1431497" cy="34431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 dirty="0"/>
            <a:t>Coverage = 0.992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505</cdr:x>
      <cdr:y>0.82708</cdr:y>
    </cdr:from>
    <cdr:to>
      <cdr:x>0.76378</cdr:x>
      <cdr:y>0.88504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7A27024B-31FC-4E64-A8D2-3F35544A6197}"/>
            </a:ext>
          </a:extLst>
        </cdr:cNvPr>
        <cdr:cNvSpPr/>
      </cdr:nvSpPr>
      <cdr:spPr>
        <a:xfrm xmlns:a="http://schemas.openxmlformats.org/drawingml/2006/main">
          <a:off x="2261887" y="2446261"/>
          <a:ext cx="876300" cy="17145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0653</cdr:x>
      <cdr:y>0.83371</cdr:y>
    </cdr:from>
    <cdr:to>
      <cdr:x>0.48564</cdr:x>
      <cdr:y>0.87377</cdr:y>
    </cdr:to>
    <cdr:sp macro="" textlink="">
      <cdr:nvSpPr>
        <cdr:cNvPr id="3" name="Rectangle 2">
          <a:extLst xmlns:a="http://schemas.openxmlformats.org/drawingml/2006/main">
            <a:ext uri="{FF2B5EF4-FFF2-40B4-BE49-F238E27FC236}">
              <a16:creationId xmlns:a16="http://schemas.microsoft.com/office/drawing/2014/main" id="{993B8518-56D9-4C7D-86F3-B8C5305A0104}"/>
            </a:ext>
          </a:extLst>
        </cdr:cNvPr>
        <cdr:cNvSpPr/>
      </cdr:nvSpPr>
      <cdr:spPr>
        <a:xfrm xmlns:a="http://schemas.openxmlformats.org/drawingml/2006/main">
          <a:off x="2088544" y="2568424"/>
          <a:ext cx="406400" cy="123419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858965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917025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14044124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1A9CD6-D5FA-49A8-99FB-90D529BE1E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DF3347-0EEA-467E-8612-F1AC076705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23CBA3-B4F9-4282-AF07-BDEF1552E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9A3AB2-88B3-460C-BE15-95766AF6F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2E97D7-3812-4477-82C0-1BE113E9E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24007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1DCF1-5247-4F47-AC14-8F45D98C9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AB7F71-8755-4F51-9FB7-B4A5163D70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505E88-BA3F-4B7D-A79D-E4540CA99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8852C3-BBEA-412B-A42E-E9F1175C7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C96DDE-3008-43BF-9B03-D7843539C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71929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60D97-B872-4B84-9587-34CE31A73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79A00B-D09D-46D5-9D13-D92802A998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557AC0-1F51-4669-BCF5-689ADD65C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B6BA7-C999-4EB4-8FCA-8C284D75F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75CDDD-B82B-44CD-9EA9-F34798CF9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07364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46FA7-5A69-4269-8422-2B10EE6D49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FA6C0-101A-4615-8E1B-9EA8B1E0FF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7F1AC9-ED8B-4C41-ACAF-35092326B9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2EF8E6-21AF-4B65-8E57-A19412257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24A758-47BE-4B4A-9E3B-269884195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8496BB-F14A-48C9-8CC5-1693C9E24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08768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FC408-FEA6-4AAF-A926-EE7FA23AE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0CC31B-C943-4DE6-B774-801937021A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3782E1-F5EB-40AF-B0A2-B716527B44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D6183E-649E-4F3B-85C2-75EA764732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564B92-FAEF-464D-BC79-2D5B060D17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983382-20B3-4F23-87CC-273DC68AD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C0CD10-4EBD-44A9-AD7A-B840CA65E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641855-D796-4CE8-8D90-3A136997E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68801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68F50-7C54-4ACB-9146-813DD531C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C122AD-B834-429C-A002-A7BDA15D2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D36ACD-2C42-44EB-AA23-86C3005BF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CAAFF4-9934-4C82-B616-0F1A60FC4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37231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10E2189-236E-40E0-8941-792786299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9B4A01-BE63-4249-90D7-17B1C4061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BFA94B-712A-4877-8062-F23B18E93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38239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3D15D-44B6-4475-B978-0F7EB4076C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8DFE59-422E-4A3F-9F95-B09076AFE3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10E3DD-D2CA-4C19-B7FB-95BA0AA79B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DDFB05-AA21-4022-91E6-0EA3E60C2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2638A3-E65A-4699-98DC-1DF115113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56594D-F39B-46E7-9AD6-665B6486B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306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89415498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CADAF-ED27-48E1-A5EC-A63AD2F9FC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A27742-DE1B-4D86-9C28-DA4B681229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FCD735-7B3C-4049-9738-A48F6DA5D6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4B06F2-945D-4E7B-9164-DF91F96F8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50520-AFC3-4FC9-AB31-6F08A0EA9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B5C4B3-4C38-4F7C-B310-937389631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85285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95275-9795-4F5D-8300-1A93EFCED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EA8E99-530A-479A-B3F6-90A1B3D0B3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5BEC4A-E1E6-4358-9390-A9086E989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B68A3A-DE5B-416C-B870-DD1BD6268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137C2D-632C-4312-A9C9-42ECF6CE8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96630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DE13D6-7B39-4621-8137-0A469220FD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D0E464-A1C7-4C0F-B7DE-CC91A53632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A188FB-0B97-4E43-9D64-7C005ABE9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CB1A04-FD68-4C01-A3FB-E655F5B1D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CFEBB1-804A-4BA9-B4A2-8F44CA66D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472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84257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4162780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146862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26588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993797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080673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43395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B771A-562C-465B-836B-DE532C5B78B4}" type="datetimeFigureOut">
              <a:rPr lang="en-150" smtClean="0"/>
              <a:t>04/24/2024</a:t>
            </a:fld>
            <a:endParaRPr lang="en-15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15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B57D3-0982-46CE-9C20-FC74D733A46A}" type="slidenum">
              <a:rPr lang="en-150" smtClean="0"/>
              <a:t>‹#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95783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428A0D5-C150-4408-9AC2-D2BB082F0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D1B29C-40D9-4904-8D40-F88D9B5EB5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08C6D-27E2-4FE2-BAF9-5C687072E7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2245C-F29A-4776-9DA8-E95D0745039D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EA721-318C-4565-8D6F-F6043FEFDD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7429B3-9E08-4BFE-9497-FE0DA70010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EC2DE-14E3-484A-B8C9-9C925AED9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88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hyperlink" Target="https://ngphylogeny.fr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A7A84D30-D593-4ED5-8483-8D83105296A0}"/>
              </a:ext>
            </a:extLst>
          </p:cNvPr>
          <p:cNvSpPr/>
          <p:nvPr/>
        </p:nvSpPr>
        <p:spPr>
          <a:xfrm>
            <a:off x="23187" y="6091774"/>
            <a:ext cx="9144000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/>
            <a:r>
              <a:rPr lang="en-US" sz="1600" b="1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sz="15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chment basin of the Al-Nar/Kidron (ANK) river. A. The river’s path, including indicative elevations. B. The sampling sites in the vicinity of </a:t>
            </a:r>
            <a:r>
              <a:rPr lang="en-US" sz="15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’Ubeideiya</a:t>
            </a:r>
            <a:r>
              <a:rPr lang="en-US" sz="15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their altitudes. Sites were reached upon accessibility at each time. Maps and elevations were collected from topographic-map.com, and coordinates from Google Earth.</a:t>
            </a:r>
            <a:endParaRPr lang="en-US" sz="1500" dirty="0">
              <a:solidFill>
                <a:prstClr val="black"/>
              </a:solidFill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1D5265B-C3FC-401C-936B-9B0D984CEE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391054" cy="30731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51B2280-A755-4CA6-89E2-1202898558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6343" y="3073125"/>
            <a:ext cx="6370844" cy="3036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0805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EC022BE-9A2E-48BE-AE9E-F88D9ED01997}"/>
              </a:ext>
            </a:extLst>
          </p:cNvPr>
          <p:cNvGrpSpPr/>
          <p:nvPr/>
        </p:nvGrpSpPr>
        <p:grpSpPr>
          <a:xfrm>
            <a:off x="115168" y="0"/>
            <a:ext cx="8913663" cy="6726226"/>
            <a:chOff x="115168" y="0"/>
            <a:chExt cx="8913663" cy="672622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6E0B6BE-35D2-4AA2-90B3-EB63CED80B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6521" y="5625359"/>
              <a:ext cx="4020525" cy="469499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C88CB469-AEE1-4BE4-9DB2-D0640A971DBE}"/>
                </a:ext>
              </a:extLst>
            </p:cNvPr>
            <p:cNvSpPr/>
            <p:nvPr/>
          </p:nvSpPr>
          <p:spPr>
            <a:xfrm>
              <a:off x="115168" y="6141451"/>
              <a:ext cx="8913663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igure S2. </a:t>
              </a:r>
              <a:r>
                <a:rPr lang="en-US" sz="1600" dirty="0">
                  <a:latin typeface="Calibri" panose="020F0502020204030204" pitchFamily="34" charset="0"/>
                  <a:ea typeface="Calibri" panose="020F0502020204030204" pitchFamily="34" charset="0"/>
                </a:rPr>
                <a:t>α</a:t>
              </a:r>
              <a:r>
                <a:rPr lang="en-US" sz="16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diversity rarefaction curves of the 16S rRNA gene OTUs  for Bacteria (A), </a:t>
              </a:r>
              <a:r>
                <a:rPr lang="en-US" sz="1600" i="1" dirty="0" err="1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dellovibrio</a:t>
              </a:r>
              <a:r>
                <a:rPr lang="en-US" sz="1600" i="1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16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B), </a:t>
              </a:r>
              <a:r>
                <a:rPr lang="en-US" sz="160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8S rRNA gene </a:t>
              </a:r>
              <a:r>
                <a:rPr lang="en-US" sz="16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C), and </a:t>
              </a:r>
              <a:r>
                <a:rPr lang="en-US" sz="1600" i="1" dirty="0" err="1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acteriovorax</a:t>
              </a:r>
              <a:r>
                <a:rPr lang="en-US" sz="16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D) of a year-long sampling effort at the Al Nar/Kidron stream.</a:t>
              </a:r>
              <a:endParaRPr lang="en-US" sz="1600" dirty="0"/>
            </a:p>
          </p:txBody>
        </p:sp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F639F603-762D-435E-B759-15C639F2FDD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706214395"/>
                </p:ext>
              </p:extLst>
            </p:nvPr>
          </p:nvGraphicFramePr>
          <p:xfrm>
            <a:off x="833535" y="2696851"/>
            <a:ext cx="2834485" cy="28493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A328CC6E-D2AF-4E6F-B40A-110394F6C9C3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60192055"/>
                </p:ext>
              </p:extLst>
            </p:nvPr>
          </p:nvGraphicFramePr>
          <p:xfrm>
            <a:off x="1049150" y="146803"/>
            <a:ext cx="2596206" cy="25777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57CD5CE-C0AF-4D40-AEB0-1E5F694DC050}"/>
                </a:ext>
              </a:extLst>
            </p:cNvPr>
            <p:cNvSpPr txBox="1"/>
            <p:nvPr/>
          </p:nvSpPr>
          <p:spPr>
            <a:xfrm rot="16200000">
              <a:off x="434371" y="1298717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Number of OTUs</a:t>
              </a:r>
              <a:endParaRPr lang="en-150" sz="1000" dirty="0"/>
            </a:p>
          </p:txBody>
        </p:sp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BE56A0C6-52A9-4048-9274-9EAA5328F35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71244121"/>
                </p:ext>
              </p:extLst>
            </p:nvPr>
          </p:nvGraphicFramePr>
          <p:xfrm>
            <a:off x="3713197" y="2934954"/>
            <a:ext cx="4108766" cy="2957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2D3B0C3-1C54-4D92-B5EC-7DE75355952E}"/>
                </a:ext>
              </a:extLst>
            </p:cNvPr>
            <p:cNvSpPr txBox="1"/>
            <p:nvPr/>
          </p:nvSpPr>
          <p:spPr>
            <a:xfrm>
              <a:off x="3408447" y="37284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  <a:endParaRPr lang="en-1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9160EC1-266B-4F3D-8074-2A57C8CE70EA}"/>
                </a:ext>
              </a:extLst>
            </p:cNvPr>
            <p:cNvSpPr txBox="1"/>
            <p:nvPr/>
          </p:nvSpPr>
          <p:spPr>
            <a:xfrm>
              <a:off x="4406953" y="335551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  <a:endParaRPr lang="en-15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6D2A6D2-19C4-49DC-A008-05240DF72F8E}"/>
                </a:ext>
              </a:extLst>
            </p:cNvPr>
            <p:cNvSpPr txBox="1"/>
            <p:nvPr/>
          </p:nvSpPr>
          <p:spPr>
            <a:xfrm>
              <a:off x="3405629" y="335551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  <a:endParaRPr lang="en-150" dirty="0"/>
            </a:p>
          </p:txBody>
        </p:sp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670C4576-D377-4F3E-8EC5-88E9328E015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7300201"/>
                </p:ext>
              </p:extLst>
            </p:nvPr>
          </p:nvGraphicFramePr>
          <p:xfrm>
            <a:off x="3784306" y="0"/>
            <a:ext cx="5137439" cy="31420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D99223C-274D-4A51-8CEE-6A305DBB9F61}"/>
                </a:ext>
              </a:extLst>
            </p:cNvPr>
            <p:cNvSpPr/>
            <p:nvPr/>
          </p:nvSpPr>
          <p:spPr>
            <a:xfrm>
              <a:off x="6641181" y="153979"/>
              <a:ext cx="2214832" cy="26378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C1B946FE-04AB-4F9D-9864-BED05067B389}"/>
                </a:ext>
              </a:extLst>
            </p:cNvPr>
            <p:cNvSpPr/>
            <p:nvPr/>
          </p:nvSpPr>
          <p:spPr>
            <a:xfrm>
              <a:off x="6641180" y="2519329"/>
              <a:ext cx="491964" cy="20336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72E567E-F1B6-4A8C-AEC7-201344DB6C2E}"/>
                </a:ext>
              </a:extLst>
            </p:cNvPr>
            <p:cNvSpPr txBox="1"/>
            <p:nvPr/>
          </p:nvSpPr>
          <p:spPr>
            <a:xfrm>
              <a:off x="4406953" y="352981"/>
              <a:ext cx="317716" cy="389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  <a:endParaRPr lang="en-150" dirty="0"/>
            </a:p>
          </p:txBody>
        </p:sp>
        <p:sp>
          <p:nvSpPr>
            <p:cNvPr id="19" name="TextBox 34">
              <a:extLst>
                <a:ext uri="{FF2B5EF4-FFF2-40B4-BE49-F238E27FC236}">
                  <a16:creationId xmlns:a16="http://schemas.microsoft.com/office/drawing/2014/main" id="{5D7E3826-2FB0-4E1F-B356-CFCD69E2055C}"/>
                </a:ext>
              </a:extLst>
            </p:cNvPr>
            <p:cNvSpPr txBox="1"/>
            <p:nvPr/>
          </p:nvSpPr>
          <p:spPr>
            <a:xfrm>
              <a:off x="4724669" y="424161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/>
                <a:t>Coverage </a:t>
              </a:r>
              <a:r>
                <a:rPr lang="en-US" sz="900"/>
                <a:t>= 0.99</a:t>
              </a:r>
              <a:endParaRPr lang="en-US" sz="900" dirty="0"/>
            </a:p>
          </p:txBody>
        </p:sp>
        <p:sp>
          <p:nvSpPr>
            <p:cNvPr id="20" name="TextBox 34">
              <a:extLst>
                <a:ext uri="{FF2B5EF4-FFF2-40B4-BE49-F238E27FC236}">
                  <a16:creationId xmlns:a16="http://schemas.microsoft.com/office/drawing/2014/main" id="{6E6BADD4-9001-4A3B-989A-AEDE4F7ACECF}"/>
                </a:ext>
              </a:extLst>
            </p:cNvPr>
            <p:cNvSpPr txBox="1"/>
            <p:nvPr/>
          </p:nvSpPr>
          <p:spPr>
            <a:xfrm>
              <a:off x="5129443" y="3811634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/>
                <a:t>Coverage = 0.9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54744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FB01526-038D-4DD1-BA98-44EC19110564}"/>
              </a:ext>
            </a:extLst>
          </p:cNvPr>
          <p:cNvSpPr txBox="1"/>
          <p:nvPr/>
        </p:nvSpPr>
        <p:spPr>
          <a:xfrm>
            <a:off x="490594" y="4986599"/>
            <a:ext cx="865340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3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/>
              <a:t>PCoA</a:t>
            </a:r>
            <a:r>
              <a:rPr lang="en-US" sz="1600" dirty="0"/>
              <a:t> of seasonal effects on the bacterial community in the Al-Nar/Kidron (ANK) river (A), and of the bacterial communities of the ANK river and of the Al-</a:t>
            </a:r>
            <a:r>
              <a:rPr lang="en-US" sz="1600" dirty="0" err="1"/>
              <a:t>Bireh</a:t>
            </a:r>
            <a:r>
              <a:rPr lang="en-US" sz="1600" dirty="0"/>
              <a:t> wastewater treatment plant (B), using Bray-Curtis distances. Each data point in the </a:t>
            </a:r>
            <a:r>
              <a:rPr lang="en-US" sz="1600" dirty="0" err="1"/>
              <a:t>PCoA</a:t>
            </a:r>
            <a:r>
              <a:rPr lang="en-US" sz="1600" dirty="0"/>
              <a:t> plot represents the bacterial community from a single time point. MRPP-A=0.223, p&lt;0.001.</a:t>
            </a:r>
            <a:endParaRPr lang="en-US" sz="1600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F58831A-537F-4B7E-AF7A-D5F70C2557FE}"/>
              </a:ext>
            </a:extLst>
          </p:cNvPr>
          <p:cNvGrpSpPr/>
          <p:nvPr/>
        </p:nvGrpSpPr>
        <p:grpSpPr>
          <a:xfrm>
            <a:off x="884583" y="591859"/>
            <a:ext cx="7513698" cy="2743702"/>
            <a:chOff x="884583" y="591859"/>
            <a:chExt cx="7513698" cy="2743702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109F2DB3-AA06-40AA-AC9F-F56936ADBDA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63573167"/>
                </p:ext>
              </p:extLst>
            </p:nvPr>
          </p:nvGraphicFramePr>
          <p:xfrm>
            <a:off x="4390546" y="591859"/>
            <a:ext cx="4007735" cy="27437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Chart 9">
              <a:extLst>
                <a:ext uri="{FF2B5EF4-FFF2-40B4-BE49-F238E27FC236}">
                  <a16:creationId xmlns:a16="http://schemas.microsoft.com/office/drawing/2014/main" id="{46565D0C-21AD-4469-9938-85EE3820EAE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4696364"/>
                </p:ext>
              </p:extLst>
            </p:nvPr>
          </p:nvGraphicFramePr>
          <p:xfrm>
            <a:off x="884583" y="591859"/>
            <a:ext cx="3659348" cy="26085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35CEED8-FC86-4411-912B-345D23C9F2AF}"/>
                </a:ext>
              </a:extLst>
            </p:cNvPr>
            <p:cNvSpPr txBox="1"/>
            <p:nvPr/>
          </p:nvSpPr>
          <p:spPr>
            <a:xfrm>
              <a:off x="3933256" y="864706"/>
              <a:ext cx="30811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FED37ED-2980-4D9D-A318-E29A6E9A738D}"/>
                </a:ext>
              </a:extLst>
            </p:cNvPr>
            <p:cNvSpPr txBox="1"/>
            <p:nvPr/>
          </p:nvSpPr>
          <p:spPr>
            <a:xfrm>
              <a:off x="4517805" y="864706"/>
              <a:ext cx="30811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/>
                <a:t>B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9C7AACE-4950-40FE-BB77-8D77337D75C9}"/>
                </a:ext>
              </a:extLst>
            </p:cNvPr>
            <p:cNvSpPr txBox="1"/>
            <p:nvPr/>
          </p:nvSpPr>
          <p:spPr>
            <a:xfrm>
              <a:off x="1562980" y="591859"/>
              <a:ext cx="122376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ANK Summe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C5CA2EA-12B1-4C2F-8BA6-33585F32D190}"/>
                </a:ext>
              </a:extLst>
            </p:cNvPr>
            <p:cNvSpPr txBox="1"/>
            <p:nvPr/>
          </p:nvSpPr>
          <p:spPr>
            <a:xfrm>
              <a:off x="3062190" y="591859"/>
              <a:ext cx="122376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ANK Winter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00A37FC-79DE-4A22-88B3-4B965392E914}"/>
                </a:ext>
              </a:extLst>
            </p:cNvPr>
            <p:cNvSpPr txBox="1"/>
            <p:nvPr/>
          </p:nvSpPr>
          <p:spPr>
            <a:xfrm>
              <a:off x="5782531" y="2774217"/>
              <a:ext cx="65310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ANK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19D8388-9C87-49A2-9E2B-CFEC943DE4B5}"/>
                </a:ext>
              </a:extLst>
            </p:cNvPr>
            <p:cNvSpPr txBox="1"/>
            <p:nvPr/>
          </p:nvSpPr>
          <p:spPr>
            <a:xfrm>
              <a:off x="4941826" y="2774217"/>
              <a:ext cx="65310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Al </a:t>
              </a:r>
              <a:r>
                <a:rPr lang="en-US" sz="1100" dirty="0" err="1"/>
                <a:t>Bireh</a:t>
              </a:r>
              <a:endParaRPr 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29122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3147AFA-7170-4FDC-AAD2-FF91AC4551B2}"/>
              </a:ext>
            </a:extLst>
          </p:cNvPr>
          <p:cNvSpPr/>
          <p:nvPr/>
        </p:nvSpPr>
        <p:spPr>
          <a:xfrm>
            <a:off x="115168" y="5980556"/>
            <a:ext cx="89136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rooted 16S rRNA gene based-phylogenetic tree of the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dellovibrionaceae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tected in the Al-Nar/Kidron river,  using the “One Click Flow” with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yML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ference, at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https://ngphylogeny.fr/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Red labels denote cultured strains with whole genome sequenced.  </a:t>
            </a:r>
            <a:endParaRPr lang="en-US" sz="16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8C66E7E-763C-4BAC-953C-31601AAED3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9867" y="195620"/>
            <a:ext cx="5096753" cy="56440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C87DF91-B6BA-40AF-B9EB-87F6C78608E2}"/>
              </a:ext>
            </a:extLst>
          </p:cNvPr>
          <p:cNvSpPr txBox="1"/>
          <p:nvPr/>
        </p:nvSpPr>
        <p:spPr>
          <a:xfrm>
            <a:off x="6582335" y="5015753"/>
            <a:ext cx="3272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⁦31°43'15"N⁩ ⁦35°15'50"E⁩</a:t>
            </a:r>
            <a:endParaRPr lang="en-150" dirty="0"/>
          </a:p>
        </p:txBody>
      </p:sp>
    </p:spTree>
    <p:extLst>
      <p:ext uri="{BB962C8B-B14F-4D97-AF65-F5344CB8AC3E}">
        <p14:creationId xmlns:p14="http://schemas.microsoft.com/office/powerpoint/2010/main" val="1848136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5</TotalTime>
  <Words>298</Words>
  <Application>Microsoft Office PowerPoint</Application>
  <PresentationFormat>On-screen Show (4:3)</PresentationFormat>
  <Paragraphs>3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rkevitch</dc:creator>
  <cp:lastModifiedBy>Marianne Natividad</cp:lastModifiedBy>
  <cp:revision>83</cp:revision>
  <dcterms:created xsi:type="dcterms:W3CDTF">2022-09-01T14:35:59Z</dcterms:created>
  <dcterms:modified xsi:type="dcterms:W3CDTF">2024-04-24T08:35:47Z</dcterms:modified>
</cp:coreProperties>
</file>